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1030" r:id="rId2"/>
    <p:sldId id="826" r:id="rId3"/>
    <p:sldId id="1041" r:id="rId4"/>
    <p:sldId id="1047" r:id="rId5"/>
    <p:sldId id="1044" r:id="rId6"/>
    <p:sldId id="261"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84" userDrawn="1">
          <p15:clr>
            <a:srgbClr val="A4A3A4"/>
          </p15:clr>
        </p15:guide>
        <p15:guide id="2" pos="381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86000" autoAdjust="0"/>
  </p:normalViewPr>
  <p:slideViewPr>
    <p:cSldViewPr snapToGrid="0" showGuides="1">
      <p:cViewPr varScale="1">
        <p:scale>
          <a:sx n="70" d="100"/>
          <a:sy n="70" d="100"/>
        </p:scale>
        <p:origin x="468" y="52"/>
      </p:cViewPr>
      <p:guideLst>
        <p:guide orient="horz" pos="2184"/>
        <p:guide pos="3816"/>
      </p:guideLst>
    </p:cSldViewPr>
  </p:slideViewPr>
  <p:notesTextViewPr>
    <p:cViewPr>
      <p:scale>
        <a:sx n="1" d="1"/>
        <a:sy n="1" d="1"/>
      </p:scale>
      <p:origin x="0" y="0"/>
    </p:cViewPr>
  </p:notesTextViewPr>
  <p:sorterViewPr>
    <p:cViewPr varScale="1">
      <p:scale>
        <a:sx n="100" d="100"/>
        <a:sy n="100" d="100"/>
      </p:scale>
      <p:origin x="0" y="-76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https://nih-my.sharepoint.com/personal/deanm_nih_gov/Documents/Documents/NanoPore%20Seq/SNU1000/UltraAdapt/SNU1000UltraAdaptHG38sumSamp.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nih-my.sharepoint.com/personal/deanm_nih_gov/Documents/Documents/NanoPore%20Seq/SNU1000/UltraAdapt/SNU1000UltraAdaptHG38sumSamp.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4.277597907413349E-2"/>
          <c:y val="0.19660523888047779"/>
          <c:w val="0.94273126454624834"/>
          <c:h val="0.67156899616518317"/>
        </c:manualLayout>
      </c:layout>
      <c:barChart>
        <c:barDir val="col"/>
        <c:grouping val="clustered"/>
        <c:varyColors val="0"/>
        <c:ser>
          <c:idx val="0"/>
          <c:order val="0"/>
          <c:tx>
            <c:strRef>
              <c:f>figures!$D$1</c:f>
              <c:strCache>
                <c:ptCount val="1"/>
                <c:pt idx="0">
                  <c:v>Z score</c:v>
                </c:pt>
              </c:strCache>
            </c:strRef>
          </c:tx>
          <c:spPr>
            <a:noFill/>
            <a:ln w="25400" cap="flat" cmpd="sng" algn="ctr">
              <a:solidFill>
                <a:schemeClr val="accent1"/>
              </a:solidFill>
              <a:miter lim="800000"/>
            </a:ln>
            <a:effectLst/>
          </c:spPr>
          <c:invertIfNegative val="0"/>
          <c:cat>
            <c:numRef>
              <c:f>figures!$C$2:$C$155</c:f>
              <c:numCache>
                <c:formatCode>0</c:formatCode>
                <c:ptCount val="154"/>
                <c:pt idx="0">
                  <c:v>9.9999999999999995E-7</c:v>
                </c:pt>
                <c:pt idx="1">
                  <c:v>10.000000999999999</c:v>
                </c:pt>
                <c:pt idx="2">
                  <c:v>20.000001000000001</c:v>
                </c:pt>
                <c:pt idx="3">
                  <c:v>30.000001000000001</c:v>
                </c:pt>
                <c:pt idx="4">
                  <c:v>40.000000999999997</c:v>
                </c:pt>
                <c:pt idx="5">
                  <c:v>50.000000999999997</c:v>
                </c:pt>
                <c:pt idx="6">
                  <c:v>60.000000999999997</c:v>
                </c:pt>
                <c:pt idx="7">
                  <c:v>70.000000999999997</c:v>
                </c:pt>
                <c:pt idx="8">
                  <c:v>80.000000999999997</c:v>
                </c:pt>
                <c:pt idx="9">
                  <c:v>90.000000999999997</c:v>
                </c:pt>
                <c:pt idx="10">
                  <c:v>100.000001</c:v>
                </c:pt>
                <c:pt idx="11">
                  <c:v>110.000001</c:v>
                </c:pt>
                <c:pt idx="12">
                  <c:v>120.000001</c:v>
                </c:pt>
                <c:pt idx="13">
                  <c:v>130.000001</c:v>
                </c:pt>
                <c:pt idx="14">
                  <c:v>140.000001</c:v>
                </c:pt>
                <c:pt idx="15">
                  <c:v>150.000001</c:v>
                </c:pt>
                <c:pt idx="16">
                  <c:v>160.000001</c:v>
                </c:pt>
                <c:pt idx="17">
                  <c:v>170.000001</c:v>
                </c:pt>
                <c:pt idx="18">
                  <c:v>180.000001</c:v>
                </c:pt>
                <c:pt idx="19">
                  <c:v>190.000001</c:v>
                </c:pt>
                <c:pt idx="20">
                  <c:v>200.000001</c:v>
                </c:pt>
                <c:pt idx="21">
                  <c:v>210.000001</c:v>
                </c:pt>
                <c:pt idx="22">
                  <c:v>220.000001</c:v>
                </c:pt>
                <c:pt idx="23">
                  <c:v>230.000001</c:v>
                </c:pt>
                <c:pt idx="24">
                  <c:v>240.000001</c:v>
                </c:pt>
                <c:pt idx="25">
                  <c:v>9.9999999999999995E-7</c:v>
                </c:pt>
                <c:pt idx="26">
                  <c:v>10.000000999999999</c:v>
                </c:pt>
                <c:pt idx="27">
                  <c:v>20.000001000000001</c:v>
                </c:pt>
                <c:pt idx="28">
                  <c:v>30.000001000000001</c:v>
                </c:pt>
                <c:pt idx="29">
                  <c:v>40.000000999999997</c:v>
                </c:pt>
                <c:pt idx="30">
                  <c:v>50.000000999999997</c:v>
                </c:pt>
                <c:pt idx="31">
                  <c:v>60.000000999999997</c:v>
                </c:pt>
                <c:pt idx="32">
                  <c:v>70.000000999999997</c:v>
                </c:pt>
                <c:pt idx="33">
                  <c:v>80.000000999999997</c:v>
                </c:pt>
                <c:pt idx="34">
                  <c:v>90.000000999999997</c:v>
                </c:pt>
                <c:pt idx="35">
                  <c:v>100.000001</c:v>
                </c:pt>
                <c:pt idx="36">
                  <c:v>110.000001</c:v>
                </c:pt>
                <c:pt idx="37">
                  <c:v>120.000001</c:v>
                </c:pt>
                <c:pt idx="38">
                  <c:v>130.000001</c:v>
                </c:pt>
                <c:pt idx="39">
                  <c:v>140.000001</c:v>
                </c:pt>
                <c:pt idx="40">
                  <c:v>150.000001</c:v>
                </c:pt>
                <c:pt idx="41">
                  <c:v>160.000001</c:v>
                </c:pt>
                <c:pt idx="42">
                  <c:v>170.000001</c:v>
                </c:pt>
                <c:pt idx="43">
                  <c:v>180.000001</c:v>
                </c:pt>
                <c:pt idx="44">
                  <c:v>190.000001</c:v>
                </c:pt>
                <c:pt idx="45">
                  <c:v>200.000001</c:v>
                </c:pt>
                <c:pt idx="46">
                  <c:v>210.000001</c:v>
                </c:pt>
                <c:pt idx="47">
                  <c:v>220.000001</c:v>
                </c:pt>
                <c:pt idx="48">
                  <c:v>230.000001</c:v>
                </c:pt>
                <c:pt idx="49">
                  <c:v>9.9999999999999995E-7</c:v>
                </c:pt>
                <c:pt idx="50">
                  <c:v>10.000000999999999</c:v>
                </c:pt>
                <c:pt idx="51">
                  <c:v>20.000001000000001</c:v>
                </c:pt>
                <c:pt idx="52">
                  <c:v>30.000001000000001</c:v>
                </c:pt>
                <c:pt idx="53">
                  <c:v>40.000000999999997</c:v>
                </c:pt>
                <c:pt idx="54">
                  <c:v>50.000000999999997</c:v>
                </c:pt>
                <c:pt idx="55">
                  <c:v>60.000000999999997</c:v>
                </c:pt>
                <c:pt idx="56">
                  <c:v>70.000000999999997</c:v>
                </c:pt>
                <c:pt idx="57">
                  <c:v>80.000000999999997</c:v>
                </c:pt>
                <c:pt idx="58">
                  <c:v>90.000000999999997</c:v>
                </c:pt>
                <c:pt idx="59">
                  <c:v>100.000001</c:v>
                </c:pt>
                <c:pt idx="60">
                  <c:v>110.000001</c:v>
                </c:pt>
                <c:pt idx="61">
                  <c:v>120.000001</c:v>
                </c:pt>
                <c:pt idx="62">
                  <c:v>130.000001</c:v>
                </c:pt>
                <c:pt idx="63">
                  <c:v>140.000001</c:v>
                </c:pt>
                <c:pt idx="64">
                  <c:v>150.000001</c:v>
                </c:pt>
                <c:pt idx="65">
                  <c:v>160.000001</c:v>
                </c:pt>
                <c:pt idx="66">
                  <c:v>170.000001</c:v>
                </c:pt>
                <c:pt idx="67">
                  <c:v>180.000001</c:v>
                </c:pt>
                <c:pt idx="68">
                  <c:v>190.000001</c:v>
                </c:pt>
                <c:pt idx="69">
                  <c:v>9.9999999999999995E-7</c:v>
                </c:pt>
                <c:pt idx="70">
                  <c:v>10.000000999999999</c:v>
                </c:pt>
                <c:pt idx="71">
                  <c:v>20.000001000000001</c:v>
                </c:pt>
                <c:pt idx="72">
                  <c:v>30.000001000000001</c:v>
                </c:pt>
                <c:pt idx="73">
                  <c:v>0</c:v>
                </c:pt>
                <c:pt idx="74">
                  <c:v>50.000000999999997</c:v>
                </c:pt>
                <c:pt idx="75">
                  <c:v>60.000000999999997</c:v>
                </c:pt>
                <c:pt idx="76">
                  <c:v>70.000000999999997</c:v>
                </c:pt>
                <c:pt idx="77">
                  <c:v>80.000000999999997</c:v>
                </c:pt>
                <c:pt idx="78">
                  <c:v>90.000000999999997</c:v>
                </c:pt>
                <c:pt idx="79">
                  <c:v>100.000001</c:v>
                </c:pt>
                <c:pt idx="80">
                  <c:v>110.000001</c:v>
                </c:pt>
                <c:pt idx="81">
                  <c:v>120.000001</c:v>
                </c:pt>
                <c:pt idx="82">
                  <c:v>130.000001</c:v>
                </c:pt>
                <c:pt idx="83">
                  <c:v>140.000001</c:v>
                </c:pt>
                <c:pt idx="84">
                  <c:v>150.000001</c:v>
                </c:pt>
                <c:pt idx="85">
                  <c:v>160.000001</c:v>
                </c:pt>
                <c:pt idx="86">
                  <c:v>170.000001</c:v>
                </c:pt>
                <c:pt idx="87">
                  <c:v>180.000001</c:v>
                </c:pt>
                <c:pt idx="88">
                  <c:v>9.9999999999999995E-7</c:v>
                </c:pt>
                <c:pt idx="89">
                  <c:v>10.000000999999999</c:v>
                </c:pt>
                <c:pt idx="90">
                  <c:v>20.000001000000001</c:v>
                </c:pt>
                <c:pt idx="91">
                  <c:v>30.000001000000001</c:v>
                </c:pt>
                <c:pt idx="92">
                  <c:v>40.000000999999997</c:v>
                </c:pt>
                <c:pt idx="93">
                  <c:v>50.000000999999997</c:v>
                </c:pt>
                <c:pt idx="94">
                  <c:v>60.000000999999997</c:v>
                </c:pt>
                <c:pt idx="95">
                  <c:v>70.000000999999997</c:v>
                </c:pt>
                <c:pt idx="96">
                  <c:v>80.000000999999997</c:v>
                </c:pt>
                <c:pt idx="97">
                  <c:v>90.000000999999997</c:v>
                </c:pt>
                <c:pt idx="98">
                  <c:v>100.000001</c:v>
                </c:pt>
                <c:pt idx="99">
                  <c:v>110.000001</c:v>
                </c:pt>
                <c:pt idx="100">
                  <c:v>120.000001</c:v>
                </c:pt>
                <c:pt idx="101">
                  <c:v>130.000001</c:v>
                </c:pt>
                <c:pt idx="102">
                  <c:v>140.000001</c:v>
                </c:pt>
                <c:pt idx="103">
                  <c:v>150.000001</c:v>
                </c:pt>
                <c:pt idx="104">
                  <c:v>160.000001</c:v>
                </c:pt>
                <c:pt idx="105">
                  <c:v>170.000001</c:v>
                </c:pt>
                <c:pt idx="106">
                  <c:v>9.9999999999999995E-7</c:v>
                </c:pt>
                <c:pt idx="107">
                  <c:v>10.000000999999999</c:v>
                </c:pt>
                <c:pt idx="108">
                  <c:v>20.000001000000001</c:v>
                </c:pt>
                <c:pt idx="109">
                  <c:v>30.000001000000001</c:v>
                </c:pt>
                <c:pt idx="110">
                  <c:v>40.000000999999997</c:v>
                </c:pt>
                <c:pt idx="111">
                  <c:v>50.000000999999997</c:v>
                </c:pt>
                <c:pt idx="112">
                  <c:v>60.000000999999997</c:v>
                </c:pt>
                <c:pt idx="113">
                  <c:v>70.000000999999997</c:v>
                </c:pt>
                <c:pt idx="114">
                  <c:v>80.000000999999997</c:v>
                </c:pt>
                <c:pt idx="115">
                  <c:v>90.000000999999997</c:v>
                </c:pt>
                <c:pt idx="116">
                  <c:v>100.000001</c:v>
                </c:pt>
                <c:pt idx="117">
                  <c:v>110.000001</c:v>
                </c:pt>
                <c:pt idx="118">
                  <c:v>120.000001</c:v>
                </c:pt>
                <c:pt idx="119">
                  <c:v>130.000001</c:v>
                </c:pt>
                <c:pt idx="120">
                  <c:v>140.000001</c:v>
                </c:pt>
                <c:pt idx="121">
                  <c:v>150.000001</c:v>
                </c:pt>
                <c:pt idx="122">
                  <c:v>160.000001</c:v>
                </c:pt>
                <c:pt idx="123">
                  <c:v>9.9999999999999995E-7</c:v>
                </c:pt>
                <c:pt idx="124">
                  <c:v>10.000000999999999</c:v>
                </c:pt>
                <c:pt idx="125">
                  <c:v>20.000001000000001</c:v>
                </c:pt>
                <c:pt idx="126">
                  <c:v>30.000001000000001</c:v>
                </c:pt>
                <c:pt idx="127">
                  <c:v>40.000000999999997</c:v>
                </c:pt>
                <c:pt idx="128">
                  <c:v>50.000000999999997</c:v>
                </c:pt>
                <c:pt idx="129">
                  <c:v>60.000000999999997</c:v>
                </c:pt>
                <c:pt idx="130">
                  <c:v>70.000000999999997</c:v>
                </c:pt>
                <c:pt idx="131">
                  <c:v>80.000000999999997</c:v>
                </c:pt>
                <c:pt idx="132">
                  <c:v>90.000000999999997</c:v>
                </c:pt>
                <c:pt idx="133">
                  <c:v>100.000001</c:v>
                </c:pt>
                <c:pt idx="134">
                  <c:v>110.000001</c:v>
                </c:pt>
                <c:pt idx="135">
                  <c:v>120.000001</c:v>
                </c:pt>
                <c:pt idx="136">
                  <c:v>130.000001</c:v>
                </c:pt>
                <c:pt idx="137">
                  <c:v>140.000001</c:v>
                </c:pt>
                <c:pt idx="138">
                  <c:v>150.000001</c:v>
                </c:pt>
                <c:pt idx="139">
                  <c:v>9.9999999999999995E-7</c:v>
                </c:pt>
                <c:pt idx="140">
                  <c:v>10.000000999999999</c:v>
                </c:pt>
                <c:pt idx="141">
                  <c:v>20.000001000000001</c:v>
                </c:pt>
                <c:pt idx="142">
                  <c:v>30.000001000000001</c:v>
                </c:pt>
                <c:pt idx="143">
                  <c:v>40.000000999999997</c:v>
                </c:pt>
                <c:pt idx="144">
                  <c:v>50.000000999999997</c:v>
                </c:pt>
                <c:pt idx="145">
                  <c:v>60.000000999999997</c:v>
                </c:pt>
                <c:pt idx="146">
                  <c:v>70.000000999999997</c:v>
                </c:pt>
                <c:pt idx="147">
                  <c:v>80.000000999999997</c:v>
                </c:pt>
                <c:pt idx="148">
                  <c:v>90.000000999999997</c:v>
                </c:pt>
                <c:pt idx="149">
                  <c:v>100.000001</c:v>
                </c:pt>
                <c:pt idx="150">
                  <c:v>110.000001</c:v>
                </c:pt>
                <c:pt idx="151">
                  <c:v>120.000001</c:v>
                </c:pt>
                <c:pt idx="152">
                  <c:v>130.000001</c:v>
                </c:pt>
                <c:pt idx="153">
                  <c:v>140.000001</c:v>
                </c:pt>
              </c:numCache>
            </c:numRef>
          </c:cat>
          <c:val>
            <c:numRef>
              <c:f>figures!$D$2:$D$155</c:f>
              <c:numCache>
                <c:formatCode>0.0</c:formatCode>
                <c:ptCount val="154"/>
                <c:pt idx="0">
                  <c:v>0.66006731564476095</c:v>
                </c:pt>
                <c:pt idx="1">
                  <c:v>0.574738835345594</c:v>
                </c:pt>
                <c:pt idx="2">
                  <c:v>0.574738835345594</c:v>
                </c:pt>
                <c:pt idx="3">
                  <c:v>0.43711225421790723</c:v>
                </c:pt>
                <c:pt idx="4">
                  <c:v>0.74814832756648064</c:v>
                </c:pt>
                <c:pt idx="5">
                  <c:v>0.32976352093831002</c:v>
                </c:pt>
                <c:pt idx="6">
                  <c:v>0.39857681150215379</c:v>
                </c:pt>
                <c:pt idx="7">
                  <c:v>0.65180972077709931</c:v>
                </c:pt>
                <c:pt idx="8">
                  <c:v>0.37930909014427783</c:v>
                </c:pt>
                <c:pt idx="9">
                  <c:v>0.51693567127196538</c:v>
                </c:pt>
                <c:pt idx="10">
                  <c:v>0.560976177232826</c:v>
                </c:pt>
                <c:pt idx="11">
                  <c:v>0.44812238070812238</c:v>
                </c:pt>
                <c:pt idx="15">
                  <c:v>0.8142090865077708</c:v>
                </c:pt>
                <c:pt idx="16">
                  <c:v>1.2601192093614781</c:v>
                </c:pt>
                <c:pt idx="17">
                  <c:v>0.95734073088056559</c:v>
                </c:pt>
                <c:pt idx="18">
                  <c:v>0.96559832574822713</c:v>
                </c:pt>
                <c:pt idx="19">
                  <c:v>1.1665331341946505</c:v>
                </c:pt>
                <c:pt idx="20">
                  <c:v>0.91330022491970575</c:v>
                </c:pt>
                <c:pt idx="21">
                  <c:v>1.0454217428022861</c:v>
                </c:pt>
                <c:pt idx="22">
                  <c:v>0.78117870703712611</c:v>
                </c:pt>
                <c:pt idx="23">
                  <c:v>1.0674419957827157</c:v>
                </c:pt>
                <c:pt idx="24">
                  <c:v>0.72826893251470415</c:v>
                </c:pt>
                <c:pt idx="25">
                  <c:v>0.2719603568646814</c:v>
                </c:pt>
                <c:pt idx="26">
                  <c:v>0.19488947143317681</c:v>
                </c:pt>
                <c:pt idx="27">
                  <c:v>3.5242637325058945E-2</c:v>
                </c:pt>
                <c:pt idx="28">
                  <c:v>0.42334959610513767</c:v>
                </c:pt>
                <c:pt idx="29">
                  <c:v>0.23617744577148231</c:v>
                </c:pt>
                <c:pt idx="30">
                  <c:v>0.19764200305573043</c:v>
                </c:pt>
                <c:pt idx="31">
                  <c:v>0.17837428169785369</c:v>
                </c:pt>
                <c:pt idx="32">
                  <c:v>0.33251605256086436</c:v>
                </c:pt>
                <c:pt idx="33">
                  <c:v>0.35178377391874111</c:v>
                </c:pt>
                <c:pt idx="34">
                  <c:v>0.27746542010978936</c:v>
                </c:pt>
                <c:pt idx="35">
                  <c:v>0.27746542010978936</c:v>
                </c:pt>
                <c:pt idx="36">
                  <c:v>0.34903124229618671</c:v>
                </c:pt>
                <c:pt idx="37">
                  <c:v>0.39031921663449298</c:v>
                </c:pt>
                <c:pt idx="38">
                  <c:v>0.21966225603616074</c:v>
                </c:pt>
                <c:pt idx="39">
                  <c:v>0.58574896183580916</c:v>
                </c:pt>
                <c:pt idx="40">
                  <c:v>0.62428440455156187</c:v>
                </c:pt>
                <c:pt idx="41">
                  <c:v>0.44812238070812238</c:v>
                </c:pt>
                <c:pt idx="42">
                  <c:v>0.39857681150215379</c:v>
                </c:pt>
                <c:pt idx="43">
                  <c:v>0.66832491051242171</c:v>
                </c:pt>
                <c:pt idx="44">
                  <c:v>0.7013552899830664</c:v>
                </c:pt>
                <c:pt idx="45">
                  <c:v>-1.7263776011093415</c:v>
                </c:pt>
                <c:pt idx="46">
                  <c:v>-1.5667307670012243</c:v>
                </c:pt>
                <c:pt idx="47">
                  <c:v>-1.437361780741198</c:v>
                </c:pt>
                <c:pt idx="48">
                  <c:v>-1.6520592473003903</c:v>
                </c:pt>
                <c:pt idx="49">
                  <c:v>5.1757827060381296E-2</c:v>
                </c:pt>
                <c:pt idx="50">
                  <c:v>-0.61985988884273335</c:v>
                </c:pt>
                <c:pt idx="51">
                  <c:v>-0.65564279993593244</c:v>
                </c:pt>
                <c:pt idx="52">
                  <c:v>-0.93915355705896908</c:v>
                </c:pt>
                <c:pt idx="53">
                  <c:v>-0.77675419132829726</c:v>
                </c:pt>
                <c:pt idx="54">
                  <c:v>-0.71344596400956106</c:v>
                </c:pt>
                <c:pt idx="55">
                  <c:v>-1.4951649448148265</c:v>
                </c:pt>
                <c:pt idx="56">
                  <c:v>-1.5639782353786702</c:v>
                </c:pt>
                <c:pt idx="57">
                  <c:v>-0.91438077245598481</c:v>
                </c:pt>
                <c:pt idx="58">
                  <c:v>0.60226415157113233</c:v>
                </c:pt>
                <c:pt idx="59">
                  <c:v>0.28297048335489655</c:v>
                </c:pt>
                <c:pt idx="60">
                  <c:v>0.29122807822255808</c:v>
                </c:pt>
                <c:pt idx="61">
                  <c:v>0.32976352093831002</c:v>
                </c:pt>
                <c:pt idx="62">
                  <c:v>0.29398060984511171</c:v>
                </c:pt>
                <c:pt idx="63">
                  <c:v>0.43711225421790723</c:v>
                </c:pt>
                <c:pt idx="64">
                  <c:v>0.23342491414892949</c:v>
                </c:pt>
                <c:pt idx="65">
                  <c:v>0.27746542010978936</c:v>
                </c:pt>
                <c:pt idx="66">
                  <c:v>0.57198630372304038</c:v>
                </c:pt>
                <c:pt idx="67">
                  <c:v>0.46188503882089038</c:v>
                </c:pt>
                <c:pt idx="68">
                  <c:v>0.65525038530529156</c:v>
                </c:pt>
                <c:pt idx="69">
                  <c:v>-0.42718267526397119</c:v>
                </c:pt>
                <c:pt idx="70">
                  <c:v>-0.64188014182316366</c:v>
                </c:pt>
                <c:pt idx="71">
                  <c:v>-0.55104659827889002</c:v>
                </c:pt>
                <c:pt idx="72">
                  <c:v>-0.57031431963676626</c:v>
                </c:pt>
                <c:pt idx="74">
                  <c:v>-0.59783963586230382</c:v>
                </c:pt>
                <c:pt idx="75">
                  <c:v>-0.50975862394058369</c:v>
                </c:pt>
                <c:pt idx="76">
                  <c:v>-0.53728394016612124</c:v>
                </c:pt>
                <c:pt idx="77">
                  <c:v>-0.57031431963676626</c:v>
                </c:pt>
                <c:pt idx="78">
                  <c:v>-0.65013773669082486</c:v>
                </c:pt>
                <c:pt idx="79">
                  <c:v>-0.5400364717886752</c:v>
                </c:pt>
                <c:pt idx="80">
                  <c:v>-0.66114786318104002</c:v>
                </c:pt>
                <c:pt idx="81">
                  <c:v>-0.79326938106361999</c:v>
                </c:pt>
                <c:pt idx="82">
                  <c:v>-0.46296558635716983</c:v>
                </c:pt>
                <c:pt idx="83">
                  <c:v>-0.48223330771504619</c:v>
                </c:pt>
                <c:pt idx="84">
                  <c:v>-0.46571811797972346</c:v>
                </c:pt>
                <c:pt idx="85">
                  <c:v>-0.7217035588772226</c:v>
                </c:pt>
                <c:pt idx="86">
                  <c:v>-0.56480925639165869</c:v>
                </c:pt>
                <c:pt idx="87">
                  <c:v>-0.80978457079894239</c:v>
                </c:pt>
                <c:pt idx="88">
                  <c:v>0.505925544781751</c:v>
                </c:pt>
                <c:pt idx="89">
                  <c:v>0.66557237888986809</c:v>
                </c:pt>
                <c:pt idx="90">
                  <c:v>0.80870402326266366</c:v>
                </c:pt>
                <c:pt idx="91">
                  <c:v>0.50042048153664309</c:v>
                </c:pt>
                <c:pt idx="92">
                  <c:v>0.49491541829153585</c:v>
                </c:pt>
                <c:pt idx="93">
                  <c:v>0.41784453286003048</c:v>
                </c:pt>
                <c:pt idx="94">
                  <c:v>0.26370276199702058</c:v>
                </c:pt>
                <c:pt idx="95">
                  <c:v>0.28297048335489655</c:v>
                </c:pt>
                <c:pt idx="96">
                  <c:v>0.57749136696814762</c:v>
                </c:pt>
                <c:pt idx="97">
                  <c:v>0.36279390040895548</c:v>
                </c:pt>
                <c:pt idx="98">
                  <c:v>0.48665782342387431</c:v>
                </c:pt>
                <c:pt idx="99">
                  <c:v>0.36829896365406267</c:v>
                </c:pt>
                <c:pt idx="100">
                  <c:v>4.9647894769678375E-3</c:v>
                </c:pt>
                <c:pt idx="101">
                  <c:v>-3.2928053906937289E-3</c:v>
                </c:pt>
                <c:pt idx="102">
                  <c:v>-0.47672824446993861</c:v>
                </c:pt>
                <c:pt idx="103">
                  <c:v>-0.31708141036182114</c:v>
                </c:pt>
                <c:pt idx="104">
                  <c:v>-9.4126348934967435E-2</c:v>
                </c:pt>
                <c:pt idx="105">
                  <c:v>0.54721351912005645</c:v>
                </c:pt>
                <c:pt idx="106">
                  <c:v>0.28847554660000452</c:v>
                </c:pt>
                <c:pt idx="107">
                  <c:v>0.32150592607064921</c:v>
                </c:pt>
                <c:pt idx="108">
                  <c:v>0.54721351912005645</c:v>
                </c:pt>
                <c:pt idx="109">
                  <c:v>0.50867807640430462</c:v>
                </c:pt>
                <c:pt idx="110">
                  <c:v>0.61877934130645462</c:v>
                </c:pt>
                <c:pt idx="111">
                  <c:v>0.71787047971838958</c:v>
                </c:pt>
                <c:pt idx="112">
                  <c:v>8.7540738153580377E-2</c:v>
                </c:pt>
                <c:pt idx="113">
                  <c:v>-1.4786497550795037</c:v>
                </c:pt>
                <c:pt idx="114">
                  <c:v>-1.3520333004420317</c:v>
                </c:pt>
                <c:pt idx="115">
                  <c:v>-1.2611997568977578</c:v>
                </c:pt>
                <c:pt idx="116">
                  <c:v>-1.4758972234569505</c:v>
                </c:pt>
                <c:pt idx="117">
                  <c:v>-1.3355181107067091</c:v>
                </c:pt>
                <c:pt idx="118">
                  <c:v>-1.577740893491439</c:v>
                </c:pt>
                <c:pt idx="119">
                  <c:v>-1.3850636799126765</c:v>
                </c:pt>
                <c:pt idx="120">
                  <c:v>-1.4841548183246114</c:v>
                </c:pt>
                <c:pt idx="121">
                  <c:v>-1.6190288678297453</c:v>
                </c:pt>
                <c:pt idx="122">
                  <c:v>-1.4043314012705528</c:v>
                </c:pt>
                <c:pt idx="123">
                  <c:v>-0.13816685489582692</c:v>
                </c:pt>
                <c:pt idx="124">
                  <c:v>-0.40791495390609483</c:v>
                </c:pt>
                <c:pt idx="125">
                  <c:v>-0.59508710423974986</c:v>
                </c:pt>
                <c:pt idx="126">
                  <c:v>-0.50700609231803007</c:v>
                </c:pt>
                <c:pt idx="127">
                  <c:v>-0.51801621880824489</c:v>
                </c:pt>
                <c:pt idx="128">
                  <c:v>-0.85933014000491015</c:v>
                </c:pt>
                <c:pt idx="129">
                  <c:v>-0.76023900159297486</c:v>
                </c:pt>
                <c:pt idx="130">
                  <c:v>-0.31708141036182114</c:v>
                </c:pt>
                <c:pt idx="131">
                  <c:v>-0.44369786499929353</c:v>
                </c:pt>
                <c:pt idx="132">
                  <c:v>-0.53177887692101367</c:v>
                </c:pt>
                <c:pt idx="133">
                  <c:v>-0.40240989066098765</c:v>
                </c:pt>
                <c:pt idx="134">
                  <c:v>-0.39690482741588007</c:v>
                </c:pt>
                <c:pt idx="135">
                  <c:v>-0.63912761020061004</c:v>
                </c:pt>
                <c:pt idx="136">
                  <c:v>-0.5290263452984596</c:v>
                </c:pt>
                <c:pt idx="137">
                  <c:v>-0.16844470274391801</c:v>
                </c:pt>
                <c:pt idx="138">
                  <c:v>-0.75473393834786773</c:v>
                </c:pt>
                <c:pt idx="139">
                  <c:v>0.21415719279105278</c:v>
                </c:pt>
                <c:pt idx="140">
                  <c:v>0.4784002285562135</c:v>
                </c:pt>
                <c:pt idx="141">
                  <c:v>0.36829896365406267</c:v>
                </c:pt>
                <c:pt idx="142">
                  <c:v>0.45637997557578319</c:v>
                </c:pt>
                <c:pt idx="143">
                  <c:v>0.21140466116849918</c:v>
                </c:pt>
                <c:pt idx="144">
                  <c:v>0.4921628866689815</c:v>
                </c:pt>
                <c:pt idx="145">
                  <c:v>0.52794579776218054</c:v>
                </c:pt>
                <c:pt idx="146">
                  <c:v>0.66557237888986809</c:v>
                </c:pt>
                <c:pt idx="147">
                  <c:v>0.91330022491970575</c:v>
                </c:pt>
                <c:pt idx="148">
                  <c:v>0.59675908832602431</c:v>
                </c:pt>
                <c:pt idx="149">
                  <c:v>0.64079959428688416</c:v>
                </c:pt>
                <c:pt idx="150">
                  <c:v>0.560976177232826</c:v>
                </c:pt>
                <c:pt idx="151">
                  <c:v>0.519688202894519</c:v>
                </c:pt>
                <c:pt idx="152">
                  <c:v>0.24718757226169824</c:v>
                </c:pt>
                <c:pt idx="153">
                  <c:v>1</c:v>
                </c:pt>
              </c:numCache>
            </c:numRef>
          </c:val>
          <c:extLst>
            <c:ext xmlns:c16="http://schemas.microsoft.com/office/drawing/2014/chart" uri="{C3380CC4-5D6E-409C-BE32-E72D297353CC}">
              <c16:uniqueId val="{00000000-1D12-459F-A9DC-66B44705B19F}"/>
            </c:ext>
          </c:extLst>
        </c:ser>
        <c:dLbls>
          <c:showLegendKey val="0"/>
          <c:showVal val="0"/>
          <c:showCatName val="0"/>
          <c:showSerName val="0"/>
          <c:showPercent val="0"/>
          <c:showBubbleSize val="0"/>
        </c:dLbls>
        <c:gapWidth val="164"/>
        <c:overlap val="-35"/>
        <c:axId val="972652440"/>
        <c:axId val="972657688"/>
      </c:barChart>
      <c:catAx>
        <c:axId val="972652440"/>
        <c:scaling>
          <c:orientation val="minMax"/>
        </c:scaling>
        <c:delete val="0"/>
        <c:axPos val="b"/>
        <c:numFmt formatCode="0" sourceLinked="1"/>
        <c:majorTickMark val="none"/>
        <c:minorTickMark val="none"/>
        <c:tickLblPos val="low"/>
        <c:spPr>
          <a:noFill/>
          <a:ln>
            <a:noFill/>
          </a:ln>
          <a:effectLst/>
        </c:spPr>
        <c:txPr>
          <a:bodyPr rot="-60000000" spcFirstLastPara="1" vertOverflow="ellipsis" vert="horz" wrap="square" anchor="ctr" anchorCtr="1"/>
          <a:lstStyle/>
          <a:p>
            <a:pPr>
              <a:defRPr sz="1197" b="0" i="0" u="none" strike="noStrike" kern="1200" baseline="0">
                <a:solidFill>
                  <a:schemeClr val="tx1">
                    <a:lumMod val="50000"/>
                    <a:lumOff val="50000"/>
                  </a:schemeClr>
                </a:solidFill>
                <a:latin typeface="+mn-lt"/>
                <a:ea typeface="+mn-ea"/>
                <a:cs typeface="+mn-cs"/>
              </a:defRPr>
            </a:pPr>
            <a:endParaRPr lang="en-US"/>
          </a:p>
        </c:txPr>
        <c:crossAx val="972657688"/>
        <c:crosses val="autoZero"/>
        <c:auto val="1"/>
        <c:lblAlgn val="ctr"/>
        <c:lblOffset val="100"/>
        <c:noMultiLvlLbl val="0"/>
      </c:catAx>
      <c:valAx>
        <c:axId val="972657688"/>
        <c:scaling>
          <c:orientation val="minMax"/>
          <c:max val="5"/>
          <c:min val="-3"/>
        </c:scaling>
        <c:delete val="0"/>
        <c:axPos val="l"/>
        <c:numFmt formatCode="0.0" sourceLinked="1"/>
        <c:majorTickMark val="none"/>
        <c:minorTickMark val="none"/>
        <c:tickLblPos val="nextTo"/>
        <c:spPr>
          <a:noFill/>
          <a:ln>
            <a:solidFill>
              <a:schemeClr val="accent2">
                <a:lumMod val="40000"/>
                <a:lumOff val="60000"/>
              </a:schemeClr>
            </a:solidFill>
          </a:ln>
          <a:effectLst/>
        </c:spPr>
        <c:txPr>
          <a:bodyPr rot="-60000000" spcFirstLastPara="1" vertOverflow="ellipsis" vert="horz" wrap="square" anchor="ctr" anchorCtr="1"/>
          <a:lstStyle/>
          <a:p>
            <a:pPr>
              <a:defRPr sz="1197" b="0" i="0" u="none" strike="noStrike" kern="1200" baseline="0">
                <a:solidFill>
                  <a:schemeClr val="tx1">
                    <a:lumMod val="50000"/>
                    <a:lumOff val="50000"/>
                  </a:schemeClr>
                </a:solidFill>
                <a:latin typeface="+mn-lt"/>
                <a:ea typeface="+mn-ea"/>
                <a:cs typeface="+mn-cs"/>
              </a:defRPr>
            </a:pPr>
            <a:endParaRPr lang="en-US"/>
          </a:p>
        </c:txPr>
        <c:crossAx val="972652440"/>
        <c:crossesAt val="1"/>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2.6267589419356151E-2"/>
          <c:y val="0.17171296296296298"/>
          <c:w val="0.95353514248421611"/>
          <c:h val="0.77736111111111106"/>
        </c:manualLayout>
      </c:layout>
      <c:barChart>
        <c:barDir val="col"/>
        <c:grouping val="clustered"/>
        <c:varyColors val="0"/>
        <c:ser>
          <c:idx val="0"/>
          <c:order val="0"/>
          <c:spPr>
            <a:noFill/>
            <a:ln w="25400" cap="flat" cmpd="sng" algn="ctr">
              <a:solidFill>
                <a:schemeClr val="accent1"/>
              </a:solidFill>
              <a:miter lim="800000"/>
            </a:ln>
            <a:effectLst/>
          </c:spPr>
          <c:invertIfNegative val="0"/>
          <c:dPt>
            <c:idx val="37"/>
            <c:invertIfNegative val="0"/>
            <c:bubble3D val="0"/>
            <c:spPr>
              <a:solidFill>
                <a:srgbClr val="FF0000"/>
              </a:solidFill>
              <a:ln w="25400" cap="flat" cmpd="sng" algn="ctr">
                <a:solidFill>
                  <a:schemeClr val="accent1"/>
                </a:solidFill>
                <a:miter lim="800000"/>
              </a:ln>
              <a:effectLst/>
            </c:spPr>
            <c:extLst>
              <c:ext xmlns:c16="http://schemas.microsoft.com/office/drawing/2014/chart" uri="{C3380CC4-5D6E-409C-BE32-E72D297353CC}">
                <c16:uniqueId val="{00000002-2B4A-4A53-99CF-CE6F7093F23E}"/>
              </c:ext>
            </c:extLst>
          </c:dPt>
          <c:cat>
            <c:numRef>
              <c:f>figures!$C$156:$C$310</c:f>
              <c:numCache>
                <c:formatCode>0</c:formatCode>
                <c:ptCount val="155"/>
                <c:pt idx="0">
                  <c:v>9.9999999999999995E-7</c:v>
                </c:pt>
                <c:pt idx="1">
                  <c:v>10.000000999999999</c:v>
                </c:pt>
                <c:pt idx="2">
                  <c:v>20.000001000000001</c:v>
                </c:pt>
                <c:pt idx="3">
                  <c:v>30.000001000000001</c:v>
                </c:pt>
                <c:pt idx="4">
                  <c:v>40.000000999999997</c:v>
                </c:pt>
                <c:pt idx="5">
                  <c:v>50.000000999999997</c:v>
                </c:pt>
                <c:pt idx="6">
                  <c:v>60.000000999999997</c:v>
                </c:pt>
                <c:pt idx="7">
                  <c:v>70.000000999999997</c:v>
                </c:pt>
                <c:pt idx="8">
                  <c:v>80.000000999999997</c:v>
                </c:pt>
                <c:pt idx="9">
                  <c:v>90.000000999999997</c:v>
                </c:pt>
                <c:pt idx="10">
                  <c:v>100.000001</c:v>
                </c:pt>
                <c:pt idx="11">
                  <c:v>110.000001</c:v>
                </c:pt>
                <c:pt idx="12">
                  <c:v>120.000001</c:v>
                </c:pt>
                <c:pt idx="13">
                  <c:v>130.000001</c:v>
                </c:pt>
                <c:pt idx="14">
                  <c:v>9.9999999999999995E-7</c:v>
                </c:pt>
                <c:pt idx="15">
                  <c:v>10.000000999999999</c:v>
                </c:pt>
                <c:pt idx="16">
                  <c:v>20.000001000000001</c:v>
                </c:pt>
                <c:pt idx="17">
                  <c:v>30.000001000000001</c:v>
                </c:pt>
                <c:pt idx="18">
                  <c:v>40.000000999999997</c:v>
                </c:pt>
                <c:pt idx="19">
                  <c:v>50.000000999999997</c:v>
                </c:pt>
                <c:pt idx="20">
                  <c:v>60.000000999999997</c:v>
                </c:pt>
                <c:pt idx="21">
                  <c:v>70.000000999999997</c:v>
                </c:pt>
                <c:pt idx="22">
                  <c:v>80.000000999999997</c:v>
                </c:pt>
                <c:pt idx="23">
                  <c:v>90.000000999999997</c:v>
                </c:pt>
                <c:pt idx="24">
                  <c:v>100.000001</c:v>
                </c:pt>
                <c:pt idx="25">
                  <c:v>110.000001</c:v>
                </c:pt>
                <c:pt idx="26">
                  <c:v>120.000001</c:v>
                </c:pt>
                <c:pt idx="27">
                  <c:v>9.9999999999999995E-7</c:v>
                </c:pt>
                <c:pt idx="28">
                  <c:v>10.000000999999999</c:v>
                </c:pt>
                <c:pt idx="29">
                  <c:v>20.000001000000001</c:v>
                </c:pt>
                <c:pt idx="30">
                  <c:v>30.000001000000001</c:v>
                </c:pt>
                <c:pt idx="31">
                  <c:v>40.000000999999997</c:v>
                </c:pt>
                <c:pt idx="32">
                  <c:v>50.000000999999997</c:v>
                </c:pt>
                <c:pt idx="33">
                  <c:v>60.000000999999997</c:v>
                </c:pt>
                <c:pt idx="34">
                  <c:v>70.000000999999997</c:v>
                </c:pt>
                <c:pt idx="35">
                  <c:v>80.000000999999997</c:v>
                </c:pt>
                <c:pt idx="36">
                  <c:v>90.000000999999997</c:v>
                </c:pt>
                <c:pt idx="37">
                  <c:v>100.000001</c:v>
                </c:pt>
                <c:pt idx="38">
                  <c:v>110.000001</c:v>
                </c:pt>
                <c:pt idx="39">
                  <c:v>120.000001</c:v>
                </c:pt>
                <c:pt idx="40">
                  <c:v>9.9999999999999995E-7</c:v>
                </c:pt>
                <c:pt idx="41">
                  <c:v>10.000000999999999</c:v>
                </c:pt>
                <c:pt idx="42">
                  <c:v>20.000001000000001</c:v>
                </c:pt>
                <c:pt idx="43">
                  <c:v>30.000001000000001</c:v>
                </c:pt>
                <c:pt idx="44">
                  <c:v>40.000000999999997</c:v>
                </c:pt>
                <c:pt idx="45">
                  <c:v>50.000000999999997</c:v>
                </c:pt>
                <c:pt idx="46">
                  <c:v>60.000000999999997</c:v>
                </c:pt>
                <c:pt idx="47">
                  <c:v>70.000000999999997</c:v>
                </c:pt>
                <c:pt idx="48">
                  <c:v>80.000000999999997</c:v>
                </c:pt>
                <c:pt idx="49">
                  <c:v>90.000000999999997</c:v>
                </c:pt>
                <c:pt idx="50">
                  <c:v>100.000001</c:v>
                </c:pt>
                <c:pt idx="51">
                  <c:v>110.000001</c:v>
                </c:pt>
                <c:pt idx="52">
                  <c:v>120.000001</c:v>
                </c:pt>
                <c:pt idx="53">
                  <c:v>9.9999999999999995E-7</c:v>
                </c:pt>
                <c:pt idx="54">
                  <c:v>10.000000999999999</c:v>
                </c:pt>
                <c:pt idx="55">
                  <c:v>20.000001000000001</c:v>
                </c:pt>
                <c:pt idx="56">
                  <c:v>30.000001000000001</c:v>
                </c:pt>
                <c:pt idx="57">
                  <c:v>40.000000999999997</c:v>
                </c:pt>
                <c:pt idx="58">
                  <c:v>50.000000999999997</c:v>
                </c:pt>
                <c:pt idx="59">
                  <c:v>60.000000999999997</c:v>
                </c:pt>
                <c:pt idx="60">
                  <c:v>70.000000999999997</c:v>
                </c:pt>
                <c:pt idx="61">
                  <c:v>80.000000999999997</c:v>
                </c:pt>
                <c:pt idx="62">
                  <c:v>90.000000999999997</c:v>
                </c:pt>
                <c:pt idx="63">
                  <c:v>100.000001</c:v>
                </c:pt>
                <c:pt idx="64">
                  <c:v>9.9999999999999995E-7</c:v>
                </c:pt>
                <c:pt idx="65">
                  <c:v>10.000000999999999</c:v>
                </c:pt>
                <c:pt idx="66">
                  <c:v>20.000001000000001</c:v>
                </c:pt>
                <c:pt idx="67">
                  <c:v>30.000001000000001</c:v>
                </c:pt>
                <c:pt idx="68">
                  <c:v>40.000000999999997</c:v>
                </c:pt>
                <c:pt idx="69">
                  <c:v>50.000000999999997</c:v>
                </c:pt>
                <c:pt idx="70">
                  <c:v>60.000000999999997</c:v>
                </c:pt>
                <c:pt idx="71">
                  <c:v>70.000000999999997</c:v>
                </c:pt>
                <c:pt idx="72">
                  <c:v>80.000000999999997</c:v>
                </c:pt>
                <c:pt idx="73">
                  <c:v>90.000000999999997</c:v>
                </c:pt>
                <c:pt idx="74">
                  <c:v>100.000001</c:v>
                </c:pt>
                <c:pt idx="75">
                  <c:v>9.9999999999999995E-7</c:v>
                </c:pt>
                <c:pt idx="76">
                  <c:v>10.000000999999999</c:v>
                </c:pt>
                <c:pt idx="77">
                  <c:v>20.000001000000001</c:v>
                </c:pt>
                <c:pt idx="78">
                  <c:v>30.000001000000001</c:v>
                </c:pt>
                <c:pt idx="79">
                  <c:v>40.000000999999997</c:v>
                </c:pt>
                <c:pt idx="80">
                  <c:v>50.000000999999997</c:v>
                </c:pt>
                <c:pt idx="81">
                  <c:v>60.000000999999997</c:v>
                </c:pt>
                <c:pt idx="82">
                  <c:v>70.000000999999997</c:v>
                </c:pt>
                <c:pt idx="83">
                  <c:v>80.000000999999997</c:v>
                </c:pt>
                <c:pt idx="84">
                  <c:v>90.000000999999997</c:v>
                </c:pt>
                <c:pt idx="85">
                  <c:v>9.9999999999999995E-7</c:v>
                </c:pt>
                <c:pt idx="86">
                  <c:v>10.000000999999999</c:v>
                </c:pt>
                <c:pt idx="87">
                  <c:v>20.000001000000001</c:v>
                </c:pt>
                <c:pt idx="88">
                  <c:v>30.000001000000001</c:v>
                </c:pt>
                <c:pt idx="89">
                  <c:v>40.000000999999997</c:v>
                </c:pt>
                <c:pt idx="90">
                  <c:v>50.000000999999997</c:v>
                </c:pt>
                <c:pt idx="91">
                  <c:v>60.000000999999997</c:v>
                </c:pt>
                <c:pt idx="92">
                  <c:v>70.000000999999997</c:v>
                </c:pt>
                <c:pt idx="93">
                  <c:v>80.000000999999997</c:v>
                </c:pt>
                <c:pt idx="94">
                  <c:v>9.9999999999999995E-7</c:v>
                </c:pt>
                <c:pt idx="95">
                  <c:v>10.000000999999999</c:v>
                </c:pt>
                <c:pt idx="96">
                  <c:v>20.000001000000001</c:v>
                </c:pt>
                <c:pt idx="97">
                  <c:v>30.000001000000001</c:v>
                </c:pt>
                <c:pt idx="98">
                  <c:v>40.000000999999997</c:v>
                </c:pt>
                <c:pt idx="99">
                  <c:v>50.000000999999997</c:v>
                </c:pt>
                <c:pt idx="100">
                  <c:v>60.000000999999997</c:v>
                </c:pt>
                <c:pt idx="101">
                  <c:v>70.000000999999997</c:v>
                </c:pt>
                <c:pt idx="102">
                  <c:v>80.000000999999997</c:v>
                </c:pt>
                <c:pt idx="103">
                  <c:v>9.9999999999999995E-7</c:v>
                </c:pt>
                <c:pt idx="104">
                  <c:v>10.000000999999999</c:v>
                </c:pt>
                <c:pt idx="105">
                  <c:v>20.000001000000001</c:v>
                </c:pt>
                <c:pt idx="106">
                  <c:v>30.000001000000001</c:v>
                </c:pt>
                <c:pt idx="107">
                  <c:v>40.000000999999997</c:v>
                </c:pt>
                <c:pt idx="108">
                  <c:v>50.000000999999997</c:v>
                </c:pt>
                <c:pt idx="109">
                  <c:v>60.000000999999997</c:v>
                </c:pt>
                <c:pt idx="110">
                  <c:v>70.000000999999997</c:v>
                </c:pt>
                <c:pt idx="111">
                  <c:v>9.9999999999999995E-7</c:v>
                </c:pt>
                <c:pt idx="112">
                  <c:v>10.000000999999999</c:v>
                </c:pt>
                <c:pt idx="113">
                  <c:v>20.000001000000001</c:v>
                </c:pt>
                <c:pt idx="114">
                  <c:v>30.000001000000001</c:v>
                </c:pt>
                <c:pt idx="115">
                  <c:v>40.000000999999997</c:v>
                </c:pt>
                <c:pt idx="116">
                  <c:v>50.000000999999997</c:v>
                </c:pt>
                <c:pt idx="117">
                  <c:v>9.9999999999999995E-7</c:v>
                </c:pt>
                <c:pt idx="118">
                  <c:v>10.000000999999999</c:v>
                </c:pt>
                <c:pt idx="119">
                  <c:v>20.000001000000001</c:v>
                </c:pt>
                <c:pt idx="120">
                  <c:v>30.000001000000001</c:v>
                </c:pt>
                <c:pt idx="121">
                  <c:v>40.000000999999997</c:v>
                </c:pt>
                <c:pt idx="122">
                  <c:v>50.000000999999997</c:v>
                </c:pt>
                <c:pt idx="123">
                  <c:v>60.000000999999997</c:v>
                </c:pt>
                <c:pt idx="124">
                  <c:v>9.9999999999999995E-7</c:v>
                </c:pt>
                <c:pt idx="125">
                  <c:v>10.000000999999999</c:v>
                </c:pt>
                <c:pt idx="126">
                  <c:v>20.000001000000001</c:v>
                </c:pt>
                <c:pt idx="127">
                  <c:v>30.000001000000001</c:v>
                </c:pt>
                <c:pt idx="128">
                  <c:v>40.000000999999997</c:v>
                </c:pt>
                <c:pt idx="129">
                  <c:v>9.9999999999999995E-7</c:v>
                </c:pt>
                <c:pt idx="130">
                  <c:v>10.000000999999999</c:v>
                </c:pt>
                <c:pt idx="131">
                  <c:v>20.000001000000001</c:v>
                </c:pt>
                <c:pt idx="132">
                  <c:v>30.000001000000001</c:v>
                </c:pt>
                <c:pt idx="133">
                  <c:v>40.000000999999997</c:v>
                </c:pt>
                <c:pt idx="134">
                  <c:v>9.9999999999999995E-7</c:v>
                </c:pt>
                <c:pt idx="135">
                  <c:v>10.000000999999999</c:v>
                </c:pt>
                <c:pt idx="136">
                  <c:v>20.000001000000001</c:v>
                </c:pt>
                <c:pt idx="137">
                  <c:v>30.000001000000001</c:v>
                </c:pt>
                <c:pt idx="138">
                  <c:v>40.000000999999997</c:v>
                </c:pt>
                <c:pt idx="139">
                  <c:v>9.9999999999999995E-7</c:v>
                </c:pt>
                <c:pt idx="140">
                  <c:v>10.000000999999999</c:v>
                </c:pt>
                <c:pt idx="141">
                  <c:v>20.000001000000001</c:v>
                </c:pt>
                <c:pt idx="142">
                  <c:v>30.000001000000001</c:v>
                </c:pt>
                <c:pt idx="143">
                  <c:v>40.000000999999997</c:v>
                </c:pt>
                <c:pt idx="144">
                  <c:v>50.000000999999997</c:v>
                </c:pt>
                <c:pt idx="145">
                  <c:v>60.000000999999997</c:v>
                </c:pt>
                <c:pt idx="146">
                  <c:v>70.000000999999997</c:v>
                </c:pt>
                <c:pt idx="147">
                  <c:v>80.000000999999997</c:v>
                </c:pt>
                <c:pt idx="148">
                  <c:v>90.000000999999997</c:v>
                </c:pt>
                <c:pt idx="149">
                  <c:v>100.000001</c:v>
                </c:pt>
                <c:pt idx="150">
                  <c:v>110.000001</c:v>
                </c:pt>
                <c:pt idx="151">
                  <c:v>120.000001</c:v>
                </c:pt>
                <c:pt idx="152">
                  <c:v>130.000001</c:v>
                </c:pt>
                <c:pt idx="153">
                  <c:v>140.000001</c:v>
                </c:pt>
                <c:pt idx="154">
                  <c:v>150.000001</c:v>
                </c:pt>
              </c:numCache>
            </c:numRef>
          </c:cat>
          <c:val>
            <c:numRef>
              <c:f>figures!$D$156:$D$310</c:f>
              <c:numCache>
                <c:formatCode>0.0</c:formatCode>
                <c:ptCount val="155"/>
                <c:pt idx="0">
                  <c:v>0.19488947143317681</c:v>
                </c:pt>
                <c:pt idx="1">
                  <c:v>0.41784453286003048</c:v>
                </c:pt>
                <c:pt idx="2">
                  <c:v>0.42885465935024569</c:v>
                </c:pt>
                <c:pt idx="3">
                  <c:v>0.49491541829153585</c:v>
                </c:pt>
                <c:pt idx="6">
                  <c:v>-0.24001052493031616</c:v>
                </c:pt>
                <c:pt idx="7">
                  <c:v>2.0831261645050501</c:v>
                </c:pt>
                <c:pt idx="8">
                  <c:v>2.1794647712944313</c:v>
                </c:pt>
                <c:pt idx="9">
                  <c:v>1.6399685732738962</c:v>
                </c:pt>
                <c:pt idx="10">
                  <c:v>2.2345154037455064</c:v>
                </c:pt>
                <c:pt idx="11">
                  <c:v>1.763832496288815</c:v>
                </c:pt>
                <c:pt idx="12">
                  <c:v>2.2647932515935976</c:v>
                </c:pt>
                <c:pt idx="13">
                  <c:v>1.7170394587054008</c:v>
                </c:pt>
                <c:pt idx="14">
                  <c:v>0.33251605256086436</c:v>
                </c:pt>
                <c:pt idx="15">
                  <c:v>0.56648124047793325</c:v>
                </c:pt>
                <c:pt idx="16">
                  <c:v>0.560976177232826</c:v>
                </c:pt>
                <c:pt idx="17">
                  <c:v>0.40408187474726176</c:v>
                </c:pt>
                <c:pt idx="19">
                  <c:v>0.26920782524212777</c:v>
                </c:pt>
                <c:pt idx="20">
                  <c:v>-8.0363690822198297E-2</c:v>
                </c:pt>
                <c:pt idx="21">
                  <c:v>5.7262890305489263E-2</c:v>
                </c:pt>
                <c:pt idx="22">
                  <c:v>0.18112681332040806</c:v>
                </c:pt>
                <c:pt idx="23">
                  <c:v>9.0293269776133972E-2</c:v>
                </c:pt>
                <c:pt idx="24">
                  <c:v>0.16185909196253212</c:v>
                </c:pt>
                <c:pt idx="25">
                  <c:v>-1.4302931880908108E-2</c:v>
                </c:pt>
                <c:pt idx="26">
                  <c:v>-3.9075716483892804E-2</c:v>
                </c:pt>
                <c:pt idx="27">
                  <c:v>-1.2832200098781876</c:v>
                </c:pt>
                <c:pt idx="28">
                  <c:v>-1.4098364645156605</c:v>
                </c:pt>
                <c:pt idx="29">
                  <c:v>-1.500670008059934</c:v>
                </c:pt>
                <c:pt idx="30">
                  <c:v>-1.6850896267710356</c:v>
                </c:pt>
                <c:pt idx="31">
                  <c:v>-1.4951649448148265</c:v>
                </c:pt>
                <c:pt idx="32">
                  <c:v>-0.80427950755383482</c:v>
                </c:pt>
                <c:pt idx="33">
                  <c:v>0.22791985090382152</c:v>
                </c:pt>
                <c:pt idx="34">
                  <c:v>0.26920782524212777</c:v>
                </c:pt>
                <c:pt idx="35">
                  <c:v>0.5031730131591966</c:v>
                </c:pt>
                <c:pt idx="36">
                  <c:v>0.36279390040895548</c:v>
                </c:pt>
                <c:pt idx="37">
                  <c:v>4.197070450626331</c:v>
                </c:pt>
                <c:pt idx="38">
                  <c:v>-2.5603946827431283</c:v>
                </c:pt>
                <c:pt idx="39">
                  <c:v>-2.3759750640320267</c:v>
                </c:pt>
                <c:pt idx="40">
                  <c:v>-1.6988522848838044</c:v>
                </c:pt>
                <c:pt idx="41">
                  <c:v>-1.4896598815697193</c:v>
                </c:pt>
                <c:pt idx="42">
                  <c:v>-1.4318567174960899</c:v>
                </c:pt>
                <c:pt idx="43">
                  <c:v>-0.84556748189214137</c:v>
                </c:pt>
                <c:pt idx="44">
                  <c:v>0.13708630735954822</c:v>
                </c:pt>
                <c:pt idx="45">
                  <c:v>0.51418313964941176</c:v>
                </c:pt>
                <c:pt idx="46">
                  <c:v>0.41784453286003048</c:v>
                </c:pt>
                <c:pt idx="47">
                  <c:v>0.8142090865077708</c:v>
                </c:pt>
                <c:pt idx="48">
                  <c:v>0.56648124047793325</c:v>
                </c:pt>
                <c:pt idx="49">
                  <c:v>0.54721351912005645</c:v>
                </c:pt>
                <c:pt idx="50">
                  <c:v>0.45362744395322879</c:v>
                </c:pt>
                <c:pt idx="51">
                  <c:v>0.24718757226169824</c:v>
                </c:pt>
                <c:pt idx="52">
                  <c:v>0.59951161994857871</c:v>
                </c:pt>
                <c:pt idx="54">
                  <c:v>-0.47122318122483103</c:v>
                </c:pt>
                <c:pt idx="55">
                  <c:v>-1.6878421583935892</c:v>
                </c:pt>
                <c:pt idx="56">
                  <c:v>-2.0924643069089908</c:v>
                </c:pt>
                <c:pt idx="57">
                  <c:v>-1.0932953279219786</c:v>
                </c:pt>
                <c:pt idx="58">
                  <c:v>0.91605275654225926</c:v>
                </c:pt>
                <c:pt idx="59">
                  <c:v>0.79769389677244773</c:v>
                </c:pt>
                <c:pt idx="60">
                  <c:v>0.69309769511540564</c:v>
                </c:pt>
                <c:pt idx="61">
                  <c:v>0.84173440273330835</c:v>
                </c:pt>
                <c:pt idx="62">
                  <c:v>1.0123913633316406</c:v>
                </c:pt>
                <c:pt idx="63">
                  <c:v>0.92155781978736651</c:v>
                </c:pt>
                <c:pt idx="66">
                  <c:v>-0.23725799330776218</c:v>
                </c:pt>
                <c:pt idx="67">
                  <c:v>0.68484010024774489</c:v>
                </c:pt>
                <c:pt idx="68">
                  <c:v>1.8574185714556426</c:v>
                </c:pt>
                <c:pt idx="69">
                  <c:v>2.0528483166569589</c:v>
                </c:pt>
                <c:pt idx="70">
                  <c:v>1.9152217355292713</c:v>
                </c:pt>
                <c:pt idx="71">
                  <c:v>2.0308280636765286</c:v>
                </c:pt>
                <c:pt idx="72">
                  <c:v>1.8051204706271204</c:v>
                </c:pt>
                <c:pt idx="73">
                  <c:v>1.813378065494782</c:v>
                </c:pt>
                <c:pt idx="74">
                  <c:v>1.5601451562198372</c:v>
                </c:pt>
                <c:pt idx="77">
                  <c:v>0.45362744395322879</c:v>
                </c:pt>
                <c:pt idx="78">
                  <c:v>0.4205970644825841</c:v>
                </c:pt>
                <c:pt idx="79">
                  <c:v>0.35728883716384752</c:v>
                </c:pt>
                <c:pt idx="80">
                  <c:v>0.2003945346782848</c:v>
                </c:pt>
                <c:pt idx="81">
                  <c:v>0.53345086100728856</c:v>
                </c:pt>
                <c:pt idx="82">
                  <c:v>0.39031921663449298</c:v>
                </c:pt>
                <c:pt idx="83">
                  <c:v>0.40132934312470814</c:v>
                </c:pt>
                <c:pt idx="84">
                  <c:v>1.719791990327955</c:v>
                </c:pt>
                <c:pt idx="85">
                  <c:v>-0.38038963768055734</c:v>
                </c:pt>
                <c:pt idx="86">
                  <c:v>-0.44369786499929353</c:v>
                </c:pt>
                <c:pt idx="87">
                  <c:v>-0.60884976235251864</c:v>
                </c:pt>
                <c:pt idx="88">
                  <c:v>-0.60334469910741095</c:v>
                </c:pt>
                <c:pt idx="89">
                  <c:v>-0.3198339419843747</c:v>
                </c:pt>
                <c:pt idx="90">
                  <c:v>0.17562175007530009</c:v>
                </c:pt>
                <c:pt idx="91">
                  <c:v>-0.35836938470012702</c:v>
                </c:pt>
                <c:pt idx="92">
                  <c:v>-0.2565257146656385</c:v>
                </c:pt>
                <c:pt idx="93">
                  <c:v>-0.38864723254821848</c:v>
                </c:pt>
                <c:pt idx="94">
                  <c:v>-4.1828248106446399E-2</c:v>
                </c:pt>
                <c:pt idx="95">
                  <c:v>0.17562175007530009</c:v>
                </c:pt>
                <c:pt idx="96">
                  <c:v>-0.27028837277840728</c:v>
                </c:pt>
                <c:pt idx="97">
                  <c:v>-0.17670229761157957</c:v>
                </c:pt>
                <c:pt idx="98">
                  <c:v>-0.20698014545967108</c:v>
                </c:pt>
                <c:pt idx="99">
                  <c:v>3.799516894761254E-2</c:v>
                </c:pt>
                <c:pt idx="100">
                  <c:v>-6.6601032709429922E-2</c:v>
                </c:pt>
                <c:pt idx="101">
                  <c:v>-0.15743457625370363</c:v>
                </c:pt>
                <c:pt idx="102">
                  <c:v>0.86283714517288745</c:v>
                </c:pt>
                <c:pt idx="103">
                  <c:v>0.47014263368855191</c:v>
                </c:pt>
                <c:pt idx="104">
                  <c:v>-0.34460672658735864</c:v>
                </c:pt>
                <c:pt idx="105">
                  <c:v>-1.1703662133534836</c:v>
                </c:pt>
                <c:pt idx="106">
                  <c:v>-1.8364788660114919</c:v>
                </c:pt>
                <c:pt idx="107">
                  <c:v>-1.6080187413395302</c:v>
                </c:pt>
                <c:pt idx="108">
                  <c:v>-1.7896858284280779</c:v>
                </c:pt>
                <c:pt idx="109">
                  <c:v>-1.5254427926629177</c:v>
                </c:pt>
                <c:pt idx="110">
                  <c:v>-1.7456453224672177</c:v>
                </c:pt>
                <c:pt idx="111">
                  <c:v>0.21690972441360637</c:v>
                </c:pt>
                <c:pt idx="112">
                  <c:v>1.0674419957827157</c:v>
                </c:pt>
                <c:pt idx="113">
                  <c:v>-0.83730988702447984</c:v>
                </c:pt>
                <c:pt idx="114">
                  <c:v>-0.27854596764606881</c:v>
                </c:pt>
                <c:pt idx="115">
                  <c:v>5.7262890305489263E-2</c:v>
                </c:pt>
                <c:pt idx="116">
                  <c:v>-0.48498583933759981</c:v>
                </c:pt>
                <c:pt idx="117">
                  <c:v>0.69585022673795927</c:v>
                </c:pt>
                <c:pt idx="118">
                  <c:v>0.4921628866689815</c:v>
                </c:pt>
                <c:pt idx="119">
                  <c:v>1.0784521222729309</c:v>
                </c:pt>
                <c:pt idx="120">
                  <c:v>1.0371641479346245</c:v>
                </c:pt>
                <c:pt idx="121">
                  <c:v>0.65731478402220733</c:v>
                </c:pt>
                <c:pt idx="122">
                  <c:v>0.5031730131591966</c:v>
                </c:pt>
                <c:pt idx="123">
                  <c:v>2.1</c:v>
                </c:pt>
                <c:pt idx="125">
                  <c:v>-0.26753584115585327</c:v>
                </c:pt>
                <c:pt idx="126">
                  <c:v>0.43986478584046085</c:v>
                </c:pt>
                <c:pt idx="127">
                  <c:v>0.25544516712935905</c:v>
                </c:pt>
                <c:pt idx="128">
                  <c:v>-0.80152697593128153</c:v>
                </c:pt>
                <c:pt idx="130">
                  <c:v>-1.1070579860347478</c:v>
                </c:pt>
                <c:pt idx="131">
                  <c:v>-0.50150102907292249</c:v>
                </c:pt>
                <c:pt idx="132">
                  <c:v>-0.58958204099464229</c:v>
                </c:pt>
                <c:pt idx="133">
                  <c:v>-0.14917698138604207</c:v>
                </c:pt>
                <c:pt idx="135">
                  <c:v>-1.1070579860347478</c:v>
                </c:pt>
                <c:pt idx="136">
                  <c:v>-0.50150102907292249</c:v>
                </c:pt>
                <c:pt idx="137">
                  <c:v>-0.58958204099464229</c:v>
                </c:pt>
                <c:pt idx="138">
                  <c:v>-0.14917698138604207</c:v>
                </c:pt>
                <c:pt idx="139">
                  <c:v>-1.3107453261037252</c:v>
                </c:pt>
                <c:pt idx="140">
                  <c:v>-1.5337003875305792</c:v>
                </c:pt>
                <c:pt idx="141">
                  <c:v>-1.3850636799126765</c:v>
                </c:pt>
                <c:pt idx="142">
                  <c:v>-1.544710514020794</c:v>
                </c:pt>
                <c:pt idx="143">
                  <c:v>-1.3437757055743702</c:v>
                </c:pt>
                <c:pt idx="144">
                  <c:v>-1.7786757019378627</c:v>
                </c:pt>
                <c:pt idx="145">
                  <c:v>-1.8887769668400132</c:v>
                </c:pt>
                <c:pt idx="146">
                  <c:v>-1.6410491208101752</c:v>
                </c:pt>
                <c:pt idx="147">
                  <c:v>-1.5749883618688851</c:v>
                </c:pt>
                <c:pt idx="148">
                  <c:v>-1.544710514020794</c:v>
                </c:pt>
                <c:pt idx="149">
                  <c:v>-1.6355440575650677</c:v>
                </c:pt>
                <c:pt idx="150">
                  <c:v>-1.580493425113993</c:v>
                </c:pt>
                <c:pt idx="151">
                  <c:v>-1.4758972234569505</c:v>
                </c:pt>
                <c:pt idx="152">
                  <c:v>-1.6080187413395302</c:v>
                </c:pt>
                <c:pt idx="153">
                  <c:v>-1.5997611464718691</c:v>
                </c:pt>
                <c:pt idx="154">
                  <c:v>-1.6924297110978455</c:v>
                </c:pt>
              </c:numCache>
            </c:numRef>
          </c:val>
          <c:extLst>
            <c:ext xmlns:c16="http://schemas.microsoft.com/office/drawing/2014/chart" uri="{C3380CC4-5D6E-409C-BE32-E72D297353CC}">
              <c16:uniqueId val="{00000000-2B4A-4A53-99CF-CE6F7093F23E}"/>
            </c:ext>
          </c:extLst>
        </c:ser>
        <c:dLbls>
          <c:showLegendKey val="0"/>
          <c:showVal val="0"/>
          <c:showCatName val="0"/>
          <c:showSerName val="0"/>
          <c:showPercent val="0"/>
          <c:showBubbleSize val="0"/>
        </c:dLbls>
        <c:gapWidth val="164"/>
        <c:overlap val="-35"/>
        <c:axId val="488116880"/>
        <c:axId val="488117536"/>
      </c:barChart>
      <c:catAx>
        <c:axId val="488116880"/>
        <c:scaling>
          <c:orientation val="minMax"/>
        </c:scaling>
        <c:delete val="0"/>
        <c:axPos val="b"/>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lumMod val="50000"/>
                    <a:lumOff val="50000"/>
                  </a:schemeClr>
                </a:solidFill>
                <a:latin typeface="+mn-lt"/>
                <a:ea typeface="+mn-ea"/>
                <a:cs typeface="+mn-cs"/>
              </a:defRPr>
            </a:pPr>
            <a:endParaRPr lang="en-US"/>
          </a:p>
        </c:txPr>
        <c:crossAx val="488117536"/>
        <c:crosses val="autoZero"/>
        <c:auto val="1"/>
        <c:lblAlgn val="ctr"/>
        <c:lblOffset val="100"/>
        <c:noMultiLvlLbl val="0"/>
      </c:catAx>
      <c:valAx>
        <c:axId val="488117536"/>
        <c:scaling>
          <c:orientation val="minMax"/>
        </c:scaling>
        <c:delete val="0"/>
        <c:axPos val="l"/>
        <c:numFmt formatCode="0.0"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lumMod val="50000"/>
                    <a:lumOff val="50000"/>
                  </a:schemeClr>
                </a:solidFill>
                <a:latin typeface="+mn-lt"/>
                <a:ea typeface="+mn-ea"/>
                <a:cs typeface="+mn-cs"/>
              </a:defRPr>
            </a:pPr>
            <a:endParaRPr lang="en-US"/>
          </a:p>
        </c:txPr>
        <c:crossAx val="48811688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1">
  <cs:axisTitle>
    <cs:lnRef idx="0"/>
    <cs:fillRef idx="0"/>
    <cs:effectRef idx="0"/>
    <cs:fontRef idx="minor">
      <a:schemeClr val="tx1">
        <a:lumMod val="50000"/>
        <a:lumOff val="50000"/>
      </a:schemeClr>
    </cs:fontRef>
    <cs:defRPr sz="1197" kern="1200"/>
  </cs:axisTitle>
  <cs:categoryAxis>
    <cs:lnRef idx="0"/>
    <cs:fillRef idx="0"/>
    <cs:effectRef idx="0"/>
    <cs:fontRef idx="minor">
      <a:schemeClr val="tx1">
        <a:lumMod val="50000"/>
        <a:lumOff val="50000"/>
      </a:schemeClr>
    </cs:fontRef>
    <cs:defRPr sz="1197"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65000"/>
        <a:lumOff val="35000"/>
      </a:schemeClr>
    </cs:fontRef>
    <cs:defRPr sz="1197" kern="1200"/>
  </cs:dataLabel>
  <cs:dataLabelCallout>
    <cs:lnRef idx="0"/>
    <cs:fillRef idx="0"/>
    <cs:effectRef idx="0"/>
    <cs:fontRef idx="minor">
      <a:schemeClr val="bg1"/>
    </cs:fontRef>
    <cs:spPr>
      <a:solidFill>
        <a:schemeClr val="tx1">
          <a:lumMod val="35000"/>
          <a:lumOff val="65000"/>
        </a:schemeClr>
      </a:solidFill>
    </cs:spPr>
    <cs:defRPr sz="1197"/>
    <cs:bodyPr rot="0" spcFirstLastPara="1" vertOverflow="clip" horzOverflow="clip" vert="horz" wrap="square" lIns="36576" tIns="18288" rIns="36576" bIns="18288" anchor="ctr" anchorCtr="1">
      <a:spAutoFit/>
    </cs:bodyPr>
  </cs:dataLabelCallout>
  <cs:dataPoint>
    <cs:lnRef idx="0">
      <cs:styleClr val="auto"/>
    </cs:lnRef>
    <cs:fillRef idx="0"/>
    <cs:effectRef idx="0"/>
    <cs:fontRef idx="minor">
      <a:schemeClr val="dk1"/>
    </cs:fontRef>
    <cs:spPr>
      <a:noFill/>
      <a:ln w="25400" cap="flat" cmpd="sng" algn="ctr">
        <a:solidFill>
          <a:schemeClr val="phClr"/>
        </a:solidFill>
        <a:miter lim="800000"/>
      </a:ln>
    </cs:spPr>
  </cs:dataPoint>
  <cs:dataPoint3D>
    <cs:lnRef idx="0">
      <cs:styleClr val="auto"/>
    </cs:lnRef>
    <cs:fillRef idx="0">
      <cs:styleClr val="auto"/>
    </cs:fillRef>
    <cs:effectRef idx="0"/>
    <cs:fontRef idx="minor">
      <a:schemeClr val="dk1"/>
    </cs:fontRef>
    <cs:spPr>
      <a:ln w="19050" cap="flat" cmpd="sng" algn="ctr">
        <a:solidFill>
          <a:schemeClr val="phClr"/>
        </a:solidFill>
        <a:miter lim="800000"/>
      </a:ln>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styleClr val="auto"/>
    </cs:lnRef>
    <cs:fillRef idx="0">
      <cs:styleClr val="auto"/>
    </cs:fillRef>
    <cs:effectRef idx="0"/>
    <cs:fontRef idx="minor">
      <a:schemeClr val="dk1"/>
    </cs:fontRef>
    <cs:spPr>
      <a:ln w="19050" cap="rnd">
        <a:solidFill>
          <a:schemeClr val="phClr"/>
        </a:solidFill>
        <a:round/>
      </a:ln>
    </cs:spPr>
  </cs:dataPointMarker>
  <cs:dataPointMarkerLayout symbol="circle" size="6"/>
  <cs:dataPointWireframe>
    <cs:lnRef idx="0">
      <cs:styleClr val="auto"/>
    </cs:lnRef>
    <cs:fillRef idx="1"/>
    <cs:effectRef idx="0"/>
    <cs:fontRef idx="minor">
      <a:schemeClr val="tx1"/>
    </cs:fontRef>
    <cs:spPr>
      <a:ln w="9525">
        <a:solidFill>
          <a:schemeClr val="phClr"/>
        </a:solidFill>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1197" kern="1200"/>
  </cs:dataTable>
  <cs:downBar>
    <cs:lnRef idx="0"/>
    <cs:fillRef idx="0"/>
    <cs:effectRef idx="0"/>
    <cs:fontRef idx="minor">
      <a:schemeClr val="dk1"/>
    </cs:fontRef>
    <cs:spPr>
      <a:solidFill>
        <a:schemeClr val="dk1">
          <a:lumMod val="75000"/>
          <a:lumOff val="25000"/>
        </a:schemeClr>
      </a:solidFill>
      <a:ln w="9525" cap="flat" cmpd="sng" algn="ctr">
        <a:solidFill>
          <a:schemeClr val="tx1">
            <a:lumMod val="50000"/>
            <a:lumOff val="50000"/>
          </a:schemeClr>
        </a:solidFill>
        <a:round/>
      </a:ln>
    </cs:spPr>
  </cs:downBar>
  <cs:dropLine>
    <cs:lnRef idx="0"/>
    <cs:fillRef idx="0"/>
    <cs:effectRef idx="0"/>
    <cs:fontRef idx="minor">
      <a:schemeClr val="dk1"/>
    </cs:fontRef>
    <cs:spPr>
      <a:ln w="9525" cap="flat" cmpd="sng" algn="ctr">
        <a:solidFill>
          <a:schemeClr val="tx1">
            <a:lumMod val="35000"/>
            <a:lumOff val="65000"/>
          </a:schemeClr>
        </a:solidFill>
        <a:round/>
      </a:ln>
    </cs:spPr>
  </cs:dropLine>
  <cs:errorBar>
    <cs:lnRef idx="0"/>
    <cs:fillRef idx="0"/>
    <cs:effectRef idx="0"/>
    <cs:fontRef idx="minor">
      <a:schemeClr val="dk1"/>
    </cs:fontRef>
    <cs:spPr>
      <a:ln w="9525" cap="flat" cmpd="sng" algn="ctr">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a:solidFill>
          <a:schemeClr val="tx1">
            <a:lumMod val="15000"/>
            <a:lumOff val="85000"/>
          </a:schemeClr>
        </a:solidFill>
      </a:ln>
    </cs:spPr>
  </cs:gridlineMajor>
  <cs:gridlineMinor>
    <cs:lnRef idx="0"/>
    <cs:fillRef idx="0"/>
    <cs:effectRef idx="0"/>
    <cs:fontRef idx="minor">
      <a:schemeClr val="dk1"/>
    </cs:fontRef>
    <cs:spPr>
      <a:ln w="9525">
        <a:solidFill>
          <a:schemeClr val="tx1">
            <a:lumMod val="5000"/>
            <a:lumOff val="95000"/>
          </a:schemeClr>
        </a:solidFill>
      </a:ln>
    </cs:spPr>
  </cs:gridlineMinor>
  <cs:hiLoLine>
    <cs:lnRef idx="0"/>
    <cs:fillRef idx="0"/>
    <cs:effectRef idx="0"/>
    <cs:fontRef idx="minor">
      <a:schemeClr val="dk1"/>
    </cs:fontRef>
    <cs:spPr>
      <a:ln w="9525" cap="flat" cmpd="sng" algn="ctr">
        <a:solidFill>
          <a:schemeClr val="tx1">
            <a:lumMod val="35000"/>
            <a:lumOff val="65000"/>
          </a:schemeClr>
        </a:solidFill>
        <a:round/>
      </a:ln>
    </cs:spPr>
  </cs:hiLoLine>
  <cs:leaderLine>
    <cs:lnRef idx="0"/>
    <cs:fillRef idx="0"/>
    <cs:effectRef idx="0"/>
    <cs:fontRef idx="minor">
      <a:schemeClr val="dk1"/>
    </cs:fontRef>
    <cs:spPr>
      <a:ln w="9525" cap="flat" cmpd="sng" algn="ctr">
        <a:solidFill>
          <a:schemeClr val="tx1">
            <a:lumMod val="35000"/>
            <a:lumOff val="65000"/>
          </a:schemeClr>
        </a:solidFill>
        <a:round/>
      </a:ln>
    </cs:spPr>
  </cs:leaderLine>
  <cs:legend>
    <cs:lnRef idx="0"/>
    <cs:fillRef idx="0"/>
    <cs:effectRef idx="0"/>
    <cs:fontRef idx="minor">
      <a:schemeClr val="tx1">
        <a:lumMod val="50000"/>
        <a:lumOff val="50000"/>
      </a:schemeClr>
    </cs:fontRef>
    <cs:defRPr sz="1197"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defRPr sz="1197" kern="1200"/>
  </cs:seriesAxis>
  <cs:seriesLine>
    <cs:lnRef idx="0"/>
    <cs:fillRef idx="0"/>
    <cs:effectRef idx="0"/>
    <cs:fontRef idx="minor">
      <a:schemeClr val="dk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2200" b="0" kern="1200" cap="none" spc="5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tx1">
        <a:lumMod val="50000"/>
        <a:lumOff val="50000"/>
      </a:schemeClr>
    </cs:fontRef>
    <cs:defRPr sz="1197" kern="1200"/>
  </cs:trendlineLabel>
  <cs:upBar>
    <cs:lnRef idx="0"/>
    <cs:fillRef idx="0"/>
    <cs:effectRef idx="0"/>
    <cs:fontRef idx="minor">
      <a:schemeClr val="dk1"/>
    </cs:fontRef>
    <cs:spPr>
      <a:solidFill>
        <a:schemeClr val="lt1"/>
      </a:solidFill>
      <a:ln w="9525" cap="flat" cmpd="sng" algn="ctr">
        <a:solidFill>
          <a:schemeClr val="tx1">
            <a:lumMod val="50000"/>
            <a:lumOff val="50000"/>
          </a:schemeClr>
        </a:solidFill>
        <a:round/>
      </a:ln>
    </cs:spPr>
  </cs:upBar>
  <cs:valueAxis>
    <cs:lnRef idx="0"/>
    <cs:fillRef idx="0"/>
    <cs:effectRef idx="0"/>
    <cs:fontRef idx="minor">
      <a:schemeClr val="tx1">
        <a:lumMod val="50000"/>
        <a:lumOff val="50000"/>
      </a:schemeClr>
    </cs:fontRef>
    <cs:defRPr sz="1197" kern="1200"/>
  </cs:valueAxis>
  <cs:wall>
    <cs:lnRef idx="0"/>
    <cs:fillRef idx="0"/>
    <cs:effectRef idx="0"/>
    <cs:fontRef idx="minor">
      <a:schemeClr val="dk1"/>
    </cs:fontRef>
  </cs:wall>
</cs:chartStyle>
</file>

<file path=ppt/charts/style2.xml><?xml version="1.0" encoding="utf-8"?>
<cs:chartStyle xmlns:cs="http://schemas.microsoft.com/office/drawing/2012/chartStyle" xmlns:a="http://schemas.openxmlformats.org/drawingml/2006/main" id="211">
  <cs:axisTitle>
    <cs:lnRef idx="0"/>
    <cs:fillRef idx="0"/>
    <cs:effectRef idx="0"/>
    <cs:fontRef idx="minor">
      <a:schemeClr val="tx1">
        <a:lumMod val="50000"/>
        <a:lumOff val="50000"/>
      </a:schemeClr>
    </cs:fontRef>
    <cs:defRPr sz="1197" kern="1200"/>
  </cs:axisTitle>
  <cs:categoryAxis>
    <cs:lnRef idx="0"/>
    <cs:fillRef idx="0"/>
    <cs:effectRef idx="0"/>
    <cs:fontRef idx="minor">
      <a:schemeClr val="tx1">
        <a:lumMod val="50000"/>
        <a:lumOff val="50000"/>
      </a:schemeClr>
    </cs:fontRef>
    <cs:defRPr sz="1197"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65000"/>
        <a:lumOff val="35000"/>
      </a:schemeClr>
    </cs:fontRef>
    <cs:defRPr sz="1197" kern="1200"/>
  </cs:dataLabel>
  <cs:dataLabelCallout>
    <cs:lnRef idx="0"/>
    <cs:fillRef idx="0"/>
    <cs:effectRef idx="0"/>
    <cs:fontRef idx="minor">
      <a:schemeClr val="bg1"/>
    </cs:fontRef>
    <cs:spPr>
      <a:solidFill>
        <a:schemeClr val="tx1">
          <a:lumMod val="35000"/>
          <a:lumOff val="65000"/>
        </a:schemeClr>
      </a:solidFill>
    </cs:spPr>
    <cs:defRPr sz="1197"/>
    <cs:bodyPr rot="0" spcFirstLastPara="1" vertOverflow="clip" horzOverflow="clip" vert="horz" wrap="square" lIns="36576" tIns="18288" rIns="36576" bIns="18288" anchor="ctr" anchorCtr="1">
      <a:spAutoFit/>
    </cs:bodyPr>
  </cs:dataLabelCallout>
  <cs:dataPoint>
    <cs:lnRef idx="0">
      <cs:styleClr val="auto"/>
    </cs:lnRef>
    <cs:fillRef idx="0"/>
    <cs:effectRef idx="0"/>
    <cs:fontRef idx="minor">
      <a:schemeClr val="dk1"/>
    </cs:fontRef>
    <cs:spPr>
      <a:noFill/>
      <a:ln w="25400" cap="flat" cmpd="sng" algn="ctr">
        <a:solidFill>
          <a:schemeClr val="phClr"/>
        </a:solidFill>
        <a:miter lim="800000"/>
      </a:ln>
    </cs:spPr>
  </cs:dataPoint>
  <cs:dataPoint3D>
    <cs:lnRef idx="0">
      <cs:styleClr val="auto"/>
    </cs:lnRef>
    <cs:fillRef idx="0">
      <cs:styleClr val="auto"/>
    </cs:fillRef>
    <cs:effectRef idx="0"/>
    <cs:fontRef idx="minor">
      <a:schemeClr val="dk1"/>
    </cs:fontRef>
    <cs:spPr>
      <a:ln w="19050" cap="flat" cmpd="sng" algn="ctr">
        <a:solidFill>
          <a:schemeClr val="phClr"/>
        </a:solidFill>
        <a:miter lim="800000"/>
      </a:ln>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styleClr val="auto"/>
    </cs:lnRef>
    <cs:fillRef idx="0">
      <cs:styleClr val="auto"/>
    </cs:fillRef>
    <cs:effectRef idx="0"/>
    <cs:fontRef idx="minor">
      <a:schemeClr val="dk1"/>
    </cs:fontRef>
    <cs:spPr>
      <a:ln w="19050" cap="rnd">
        <a:solidFill>
          <a:schemeClr val="phClr"/>
        </a:solidFill>
        <a:round/>
      </a:ln>
    </cs:spPr>
  </cs:dataPointMarker>
  <cs:dataPointMarkerLayout symbol="circle" size="6"/>
  <cs:dataPointWireframe>
    <cs:lnRef idx="0">
      <cs:styleClr val="auto"/>
    </cs:lnRef>
    <cs:fillRef idx="1"/>
    <cs:effectRef idx="0"/>
    <cs:fontRef idx="minor">
      <a:schemeClr val="tx1"/>
    </cs:fontRef>
    <cs:spPr>
      <a:ln w="9525">
        <a:solidFill>
          <a:schemeClr val="phClr"/>
        </a:solidFill>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1197" kern="1200"/>
  </cs:dataTable>
  <cs:downBar>
    <cs:lnRef idx="0"/>
    <cs:fillRef idx="0"/>
    <cs:effectRef idx="0"/>
    <cs:fontRef idx="minor">
      <a:schemeClr val="dk1"/>
    </cs:fontRef>
    <cs:spPr>
      <a:solidFill>
        <a:schemeClr val="dk1">
          <a:lumMod val="75000"/>
          <a:lumOff val="25000"/>
        </a:schemeClr>
      </a:solidFill>
      <a:ln w="9525" cap="flat" cmpd="sng" algn="ctr">
        <a:solidFill>
          <a:schemeClr val="tx1">
            <a:lumMod val="50000"/>
            <a:lumOff val="50000"/>
          </a:schemeClr>
        </a:solidFill>
        <a:round/>
      </a:ln>
    </cs:spPr>
  </cs:downBar>
  <cs:dropLine>
    <cs:lnRef idx="0"/>
    <cs:fillRef idx="0"/>
    <cs:effectRef idx="0"/>
    <cs:fontRef idx="minor">
      <a:schemeClr val="dk1"/>
    </cs:fontRef>
    <cs:spPr>
      <a:ln w="9525" cap="flat" cmpd="sng" algn="ctr">
        <a:solidFill>
          <a:schemeClr val="tx1">
            <a:lumMod val="35000"/>
            <a:lumOff val="65000"/>
          </a:schemeClr>
        </a:solidFill>
        <a:round/>
      </a:ln>
    </cs:spPr>
  </cs:dropLine>
  <cs:errorBar>
    <cs:lnRef idx="0"/>
    <cs:fillRef idx="0"/>
    <cs:effectRef idx="0"/>
    <cs:fontRef idx="minor">
      <a:schemeClr val="dk1"/>
    </cs:fontRef>
    <cs:spPr>
      <a:ln w="9525" cap="flat" cmpd="sng" algn="ctr">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a:solidFill>
          <a:schemeClr val="tx1">
            <a:lumMod val="15000"/>
            <a:lumOff val="85000"/>
          </a:schemeClr>
        </a:solidFill>
      </a:ln>
    </cs:spPr>
  </cs:gridlineMajor>
  <cs:gridlineMinor>
    <cs:lnRef idx="0"/>
    <cs:fillRef idx="0"/>
    <cs:effectRef idx="0"/>
    <cs:fontRef idx="minor">
      <a:schemeClr val="dk1"/>
    </cs:fontRef>
    <cs:spPr>
      <a:ln w="9525">
        <a:solidFill>
          <a:schemeClr val="tx1">
            <a:lumMod val="5000"/>
            <a:lumOff val="95000"/>
          </a:schemeClr>
        </a:solidFill>
      </a:ln>
    </cs:spPr>
  </cs:gridlineMinor>
  <cs:hiLoLine>
    <cs:lnRef idx="0"/>
    <cs:fillRef idx="0"/>
    <cs:effectRef idx="0"/>
    <cs:fontRef idx="minor">
      <a:schemeClr val="dk1"/>
    </cs:fontRef>
    <cs:spPr>
      <a:ln w="9525" cap="flat" cmpd="sng" algn="ctr">
        <a:solidFill>
          <a:schemeClr val="tx1">
            <a:lumMod val="35000"/>
            <a:lumOff val="65000"/>
          </a:schemeClr>
        </a:solidFill>
        <a:round/>
      </a:ln>
    </cs:spPr>
  </cs:hiLoLine>
  <cs:leaderLine>
    <cs:lnRef idx="0"/>
    <cs:fillRef idx="0"/>
    <cs:effectRef idx="0"/>
    <cs:fontRef idx="minor">
      <a:schemeClr val="dk1"/>
    </cs:fontRef>
    <cs:spPr>
      <a:ln w="9525" cap="flat" cmpd="sng" algn="ctr">
        <a:solidFill>
          <a:schemeClr val="tx1">
            <a:lumMod val="35000"/>
            <a:lumOff val="65000"/>
          </a:schemeClr>
        </a:solidFill>
        <a:round/>
      </a:ln>
    </cs:spPr>
  </cs:leaderLine>
  <cs:legend>
    <cs:lnRef idx="0"/>
    <cs:fillRef idx="0"/>
    <cs:effectRef idx="0"/>
    <cs:fontRef idx="minor">
      <a:schemeClr val="tx1">
        <a:lumMod val="50000"/>
        <a:lumOff val="50000"/>
      </a:schemeClr>
    </cs:fontRef>
    <cs:defRPr sz="1197"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defRPr sz="1197" kern="1200"/>
  </cs:seriesAxis>
  <cs:seriesLine>
    <cs:lnRef idx="0"/>
    <cs:fillRef idx="0"/>
    <cs:effectRef idx="0"/>
    <cs:fontRef idx="minor">
      <a:schemeClr val="dk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2200" b="0" kern="1200" cap="none" spc="5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tx1">
        <a:lumMod val="50000"/>
        <a:lumOff val="50000"/>
      </a:schemeClr>
    </cs:fontRef>
    <cs:defRPr sz="1197" kern="1200"/>
  </cs:trendlineLabel>
  <cs:upBar>
    <cs:lnRef idx="0"/>
    <cs:fillRef idx="0"/>
    <cs:effectRef idx="0"/>
    <cs:fontRef idx="minor">
      <a:schemeClr val="dk1"/>
    </cs:fontRef>
    <cs:spPr>
      <a:solidFill>
        <a:schemeClr val="lt1"/>
      </a:solidFill>
      <a:ln w="9525" cap="flat" cmpd="sng" algn="ctr">
        <a:solidFill>
          <a:schemeClr val="tx1">
            <a:lumMod val="50000"/>
            <a:lumOff val="50000"/>
          </a:schemeClr>
        </a:solidFill>
        <a:round/>
      </a:ln>
    </cs:spPr>
  </cs:upBar>
  <cs:valueAxis>
    <cs:lnRef idx="0"/>
    <cs:fillRef idx="0"/>
    <cs:effectRef idx="0"/>
    <cs:fontRef idx="minor">
      <a:schemeClr val="tx1">
        <a:lumMod val="50000"/>
        <a:lumOff val="50000"/>
      </a:schemeClr>
    </cs:fontRef>
    <cs:defRPr sz="1197" kern="1200"/>
  </cs:valueAxis>
  <cs:wall>
    <cs:lnRef idx="0"/>
    <cs:fillRef idx="0"/>
    <cs:effectRef idx="0"/>
    <cs:fontRef idx="minor">
      <a:schemeClr val="dk1"/>
    </cs:fontRef>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8A120B9-7F01-4396-9657-EB0D252B7D1B}" type="datetimeFigureOut">
              <a:rPr lang="en-US" smtClean="0"/>
              <a:t>10/17/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2C1D7A2-AAAD-4FEE-8214-3C87A7AB3D26}" type="slidenum">
              <a:rPr lang="en-US" smtClean="0"/>
              <a:t>‹#›</a:t>
            </a:fld>
            <a:endParaRPr lang="en-US"/>
          </a:p>
        </p:txBody>
      </p:sp>
    </p:spTree>
    <p:extLst>
      <p:ext uri="{BB962C8B-B14F-4D97-AF65-F5344CB8AC3E}">
        <p14:creationId xmlns:p14="http://schemas.microsoft.com/office/powerpoint/2010/main" val="18010310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ng read DNA contig in </a:t>
            </a:r>
            <a:r>
              <a:rPr lang="en-US" dirty="0" err="1"/>
              <a:t>SiHa</a:t>
            </a:r>
            <a:r>
              <a:rPr lang="en-US" dirty="0"/>
              <a:t> cervical cancer cells. A 54 kb contig is shown containing the integrated HPV16 sequence and flanking human DNA. The Human DNA are rearranged with the sequences at the HPV junctions being 300kb apart on the human genome as described (Akagi et al. 2014). Human DNA is shown in Blue and light blue, and HPV sequences in red. </a:t>
            </a:r>
          </a:p>
        </p:txBody>
      </p:sp>
      <p:sp>
        <p:nvSpPr>
          <p:cNvPr id="4" name="Slide Number Placeholder 3"/>
          <p:cNvSpPr>
            <a:spLocks noGrp="1"/>
          </p:cNvSpPr>
          <p:nvPr>
            <p:ph type="sldNum" sz="quarter" idx="5"/>
          </p:nvPr>
        </p:nvSpPr>
        <p:spPr/>
        <p:txBody>
          <a:bodyPr/>
          <a:lstStyle/>
          <a:p>
            <a:fld id="{775EF51D-CAB0-45EF-9997-E9A5569A6465}" type="slidenum">
              <a:rPr lang="en-GB" smtClean="0"/>
              <a:pPr/>
              <a:t>2</a:t>
            </a:fld>
            <a:endParaRPr lang="en-GB"/>
          </a:p>
        </p:txBody>
      </p:sp>
    </p:spTree>
    <p:extLst>
      <p:ext uri="{BB962C8B-B14F-4D97-AF65-F5344CB8AC3E}">
        <p14:creationId xmlns:p14="http://schemas.microsoft.com/office/powerpoint/2010/main" val="40370326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2C1D7A2-AAAD-4FEE-8214-3C87A7AB3D26}" type="slidenum">
              <a:rPr lang="en-US" smtClean="0"/>
              <a:t>4</a:t>
            </a:fld>
            <a:endParaRPr lang="en-US"/>
          </a:p>
        </p:txBody>
      </p:sp>
    </p:spTree>
    <p:extLst>
      <p:ext uri="{BB962C8B-B14F-4D97-AF65-F5344CB8AC3E}">
        <p14:creationId xmlns:p14="http://schemas.microsoft.com/office/powerpoint/2010/main" val="165570221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presentative HPV RNA in EP only tumors</a:t>
            </a:r>
          </a:p>
        </p:txBody>
      </p:sp>
      <p:sp>
        <p:nvSpPr>
          <p:cNvPr id="4" name="Slide Number Placeholder 3"/>
          <p:cNvSpPr>
            <a:spLocks noGrp="1"/>
          </p:cNvSpPr>
          <p:nvPr>
            <p:ph type="sldNum" sz="quarter" idx="5"/>
          </p:nvPr>
        </p:nvSpPr>
        <p:spPr/>
        <p:txBody>
          <a:bodyPr/>
          <a:lstStyle/>
          <a:p>
            <a:fld id="{92C1D7A2-AAAD-4FEE-8214-3C87A7AB3D26}" type="slidenum">
              <a:rPr lang="en-US" smtClean="0"/>
              <a:t>6</a:t>
            </a:fld>
            <a:endParaRPr lang="en-US"/>
          </a:p>
        </p:txBody>
      </p:sp>
    </p:spTree>
    <p:extLst>
      <p:ext uri="{BB962C8B-B14F-4D97-AF65-F5344CB8AC3E}">
        <p14:creationId xmlns:p14="http://schemas.microsoft.com/office/powerpoint/2010/main" val="26072775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6CF7DB-7907-400A-923E-EE5CF218422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1E78A59-6DBD-437E-AA5E-6B674807F69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DAA588D-3E2E-4B20-B5E4-68816F374B65}"/>
              </a:ext>
            </a:extLst>
          </p:cNvPr>
          <p:cNvSpPr>
            <a:spLocks noGrp="1"/>
          </p:cNvSpPr>
          <p:nvPr>
            <p:ph type="dt" sz="half" idx="10"/>
          </p:nvPr>
        </p:nvSpPr>
        <p:spPr/>
        <p:txBody>
          <a:bodyPr/>
          <a:lstStyle/>
          <a:p>
            <a:fld id="{6D8E67F6-22BE-4FA0-8403-CDA14006433B}" type="datetimeFigureOut">
              <a:rPr lang="en-US" smtClean="0"/>
              <a:t>10/17/2021</a:t>
            </a:fld>
            <a:endParaRPr lang="en-US"/>
          </a:p>
        </p:txBody>
      </p:sp>
      <p:sp>
        <p:nvSpPr>
          <p:cNvPr id="5" name="Footer Placeholder 4">
            <a:extLst>
              <a:ext uri="{FF2B5EF4-FFF2-40B4-BE49-F238E27FC236}">
                <a16:creationId xmlns:a16="http://schemas.microsoft.com/office/drawing/2014/main" id="{52CF1350-6AB7-4F50-97BE-EE53D85C63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A82CD65-381E-4482-BAAB-A6DFABCD7DBB}"/>
              </a:ext>
            </a:extLst>
          </p:cNvPr>
          <p:cNvSpPr>
            <a:spLocks noGrp="1"/>
          </p:cNvSpPr>
          <p:nvPr>
            <p:ph type="sldNum" sz="quarter" idx="12"/>
          </p:nvPr>
        </p:nvSpPr>
        <p:spPr/>
        <p:txBody>
          <a:bodyPr/>
          <a:lstStyle/>
          <a:p>
            <a:fld id="{252F9753-9956-4FBA-843C-B77A85B76D67}" type="slidenum">
              <a:rPr lang="en-US" smtClean="0"/>
              <a:t>‹#›</a:t>
            </a:fld>
            <a:endParaRPr lang="en-US"/>
          </a:p>
        </p:txBody>
      </p:sp>
    </p:spTree>
    <p:extLst>
      <p:ext uri="{BB962C8B-B14F-4D97-AF65-F5344CB8AC3E}">
        <p14:creationId xmlns:p14="http://schemas.microsoft.com/office/powerpoint/2010/main" val="18838849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519A6F-5671-43DD-B8B2-D50204CA22A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4A91306-E611-4E68-9C05-69A5D94EC34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C1D1C6E-76AB-49B2-BFF6-433F9E58AA35}"/>
              </a:ext>
            </a:extLst>
          </p:cNvPr>
          <p:cNvSpPr>
            <a:spLocks noGrp="1"/>
          </p:cNvSpPr>
          <p:nvPr>
            <p:ph type="dt" sz="half" idx="10"/>
          </p:nvPr>
        </p:nvSpPr>
        <p:spPr/>
        <p:txBody>
          <a:bodyPr/>
          <a:lstStyle/>
          <a:p>
            <a:fld id="{6D8E67F6-22BE-4FA0-8403-CDA14006433B}" type="datetimeFigureOut">
              <a:rPr lang="en-US" smtClean="0"/>
              <a:t>10/17/2021</a:t>
            </a:fld>
            <a:endParaRPr lang="en-US"/>
          </a:p>
        </p:txBody>
      </p:sp>
      <p:sp>
        <p:nvSpPr>
          <p:cNvPr id="5" name="Footer Placeholder 4">
            <a:extLst>
              <a:ext uri="{FF2B5EF4-FFF2-40B4-BE49-F238E27FC236}">
                <a16:creationId xmlns:a16="http://schemas.microsoft.com/office/drawing/2014/main" id="{A9AB4413-E770-4E21-9D62-494C36A6C13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AF78EF7-B63F-437A-9534-240035C3A939}"/>
              </a:ext>
            </a:extLst>
          </p:cNvPr>
          <p:cNvSpPr>
            <a:spLocks noGrp="1"/>
          </p:cNvSpPr>
          <p:nvPr>
            <p:ph type="sldNum" sz="quarter" idx="12"/>
          </p:nvPr>
        </p:nvSpPr>
        <p:spPr/>
        <p:txBody>
          <a:bodyPr/>
          <a:lstStyle/>
          <a:p>
            <a:fld id="{252F9753-9956-4FBA-843C-B77A85B76D67}" type="slidenum">
              <a:rPr lang="en-US" smtClean="0"/>
              <a:t>‹#›</a:t>
            </a:fld>
            <a:endParaRPr lang="en-US"/>
          </a:p>
        </p:txBody>
      </p:sp>
    </p:spTree>
    <p:extLst>
      <p:ext uri="{BB962C8B-B14F-4D97-AF65-F5344CB8AC3E}">
        <p14:creationId xmlns:p14="http://schemas.microsoft.com/office/powerpoint/2010/main" val="13423900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CD40DAB-74C1-4A67-B072-0D188D247A6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27162A5-6DAA-4463-A8BB-636D0701781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0945FC5-4656-4CCB-BB41-054CD254BCC1}"/>
              </a:ext>
            </a:extLst>
          </p:cNvPr>
          <p:cNvSpPr>
            <a:spLocks noGrp="1"/>
          </p:cNvSpPr>
          <p:nvPr>
            <p:ph type="dt" sz="half" idx="10"/>
          </p:nvPr>
        </p:nvSpPr>
        <p:spPr/>
        <p:txBody>
          <a:bodyPr/>
          <a:lstStyle/>
          <a:p>
            <a:fld id="{6D8E67F6-22BE-4FA0-8403-CDA14006433B}" type="datetimeFigureOut">
              <a:rPr lang="en-US" smtClean="0"/>
              <a:t>10/17/2021</a:t>
            </a:fld>
            <a:endParaRPr lang="en-US"/>
          </a:p>
        </p:txBody>
      </p:sp>
      <p:sp>
        <p:nvSpPr>
          <p:cNvPr id="5" name="Footer Placeholder 4">
            <a:extLst>
              <a:ext uri="{FF2B5EF4-FFF2-40B4-BE49-F238E27FC236}">
                <a16:creationId xmlns:a16="http://schemas.microsoft.com/office/drawing/2014/main" id="{389622D3-06C5-447B-979D-594111F972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544861-D2E9-4790-8D78-4869FC21BCB0}"/>
              </a:ext>
            </a:extLst>
          </p:cNvPr>
          <p:cNvSpPr>
            <a:spLocks noGrp="1"/>
          </p:cNvSpPr>
          <p:nvPr>
            <p:ph type="sldNum" sz="quarter" idx="12"/>
          </p:nvPr>
        </p:nvSpPr>
        <p:spPr/>
        <p:txBody>
          <a:bodyPr/>
          <a:lstStyle/>
          <a:p>
            <a:fld id="{252F9753-9956-4FBA-843C-B77A85B76D67}" type="slidenum">
              <a:rPr lang="en-US" smtClean="0"/>
              <a:t>‹#›</a:t>
            </a:fld>
            <a:endParaRPr lang="en-US"/>
          </a:p>
        </p:txBody>
      </p:sp>
    </p:spTree>
    <p:extLst>
      <p:ext uri="{BB962C8B-B14F-4D97-AF65-F5344CB8AC3E}">
        <p14:creationId xmlns:p14="http://schemas.microsoft.com/office/powerpoint/2010/main" val="71291651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One column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lstStyle>
            <a:lvl1pPr>
              <a:defRPr cap="none"/>
            </a:lvl1pPr>
          </a:lstStyle>
          <a:p>
            <a:r>
              <a:rPr lang="en-NZ" dirty="0"/>
              <a:t>Example slide title</a:t>
            </a:r>
            <a:endParaRPr lang="en-US" dirty="0"/>
          </a:p>
        </p:txBody>
      </p:sp>
      <p:sp>
        <p:nvSpPr>
          <p:cNvPr id="5" name="Text Placeholder 5"/>
          <p:cNvSpPr>
            <a:spLocks noGrp="1"/>
          </p:cNvSpPr>
          <p:nvPr>
            <p:ph type="body" sz="quarter" idx="13" hasCustomPrompt="1"/>
          </p:nvPr>
        </p:nvSpPr>
        <p:spPr>
          <a:xfrm>
            <a:off x="565574" y="820634"/>
            <a:ext cx="11050693" cy="328295"/>
          </a:xfrm>
        </p:spPr>
        <p:txBody>
          <a:bodyPr/>
          <a:lstStyle>
            <a:lvl1pPr marL="0" indent="0">
              <a:buNone/>
              <a:defRPr sz="2133" b="0">
                <a:solidFill>
                  <a:schemeClr val="accent3"/>
                </a:solidFill>
              </a:defRPr>
            </a:lvl1pPr>
          </a:lstStyle>
          <a:p>
            <a:r>
              <a:rPr lang="en-NZ" dirty="0"/>
              <a:t>Subtitle</a:t>
            </a:r>
            <a:endParaRPr lang="en-GB" dirty="0"/>
          </a:p>
        </p:txBody>
      </p:sp>
      <p:sp>
        <p:nvSpPr>
          <p:cNvPr id="4" name="Text Placeholder 6">
            <a:extLst>
              <a:ext uri="{FF2B5EF4-FFF2-40B4-BE49-F238E27FC236}">
                <a16:creationId xmlns:a16="http://schemas.microsoft.com/office/drawing/2014/main" id="{8993672C-269C-4EDB-88B3-5E27E744F013}"/>
              </a:ext>
            </a:extLst>
          </p:cNvPr>
          <p:cNvSpPr>
            <a:spLocks noGrp="1"/>
          </p:cNvSpPr>
          <p:nvPr>
            <p:ph type="body" sz="quarter" idx="15" hasCustomPrompt="1"/>
          </p:nvPr>
        </p:nvSpPr>
        <p:spPr>
          <a:xfrm>
            <a:off x="575734" y="1920000"/>
            <a:ext cx="11040535" cy="2236509"/>
          </a:xfrm>
        </p:spPr>
        <p:txBody>
          <a:bodyPr/>
          <a:lstStyle>
            <a:lvl1pPr>
              <a:defRPr>
                <a:solidFill>
                  <a:schemeClr val="accent3"/>
                </a:solidFill>
              </a:defRPr>
            </a:lvl1pPr>
            <a:lvl2pPr>
              <a:defRPr>
                <a:solidFill>
                  <a:schemeClr val="accent3"/>
                </a:solidFill>
              </a:defRPr>
            </a:lvl2pPr>
            <a:lvl3pPr>
              <a:defRPr>
                <a:solidFill>
                  <a:schemeClr val="accent3"/>
                </a:solidFill>
              </a:defRPr>
            </a:lvl3pPr>
            <a:lvl4pPr>
              <a:defRPr>
                <a:solidFill>
                  <a:schemeClr val="accent3"/>
                </a:solidFill>
              </a:defRPr>
            </a:lvl4pPr>
            <a:lvl5pPr>
              <a:defRPr>
                <a:solidFill>
                  <a:schemeClr val="accent3"/>
                </a:solidFill>
              </a:defRPr>
            </a:lvl5pPr>
          </a:lstStyle>
          <a:p>
            <a:pPr lvl="0"/>
            <a:r>
              <a:rPr lang="en-US" dirty="0"/>
              <a:t>Click to add text</a:t>
            </a:r>
          </a:p>
          <a:p>
            <a:pPr lvl="1"/>
            <a:r>
              <a:rPr lang="en-US" dirty="0"/>
              <a:t>Click to add indented text</a:t>
            </a:r>
          </a:p>
          <a:p>
            <a:pPr lvl="2"/>
            <a:r>
              <a:rPr lang="en-US" dirty="0"/>
              <a:t>Third level</a:t>
            </a:r>
          </a:p>
          <a:p>
            <a:pPr lvl="3"/>
            <a:r>
              <a:rPr lang="en-US" dirty="0"/>
              <a:t>Fourth level</a:t>
            </a:r>
          </a:p>
          <a:p>
            <a:pPr lvl="4"/>
            <a:r>
              <a:rPr lang="en-US" dirty="0"/>
              <a:t>Fifth level</a:t>
            </a:r>
            <a:endParaRPr lang="en-GB" dirty="0"/>
          </a:p>
          <a:p>
            <a:endParaRPr lang="en-GB" dirty="0"/>
          </a:p>
        </p:txBody>
      </p:sp>
      <p:cxnSp>
        <p:nvCxnSpPr>
          <p:cNvPr id="10" name="Straight Connector 9">
            <a:extLst>
              <a:ext uri="{FF2B5EF4-FFF2-40B4-BE49-F238E27FC236}">
                <a16:creationId xmlns:a16="http://schemas.microsoft.com/office/drawing/2014/main" id="{CCAEC779-1D8F-DA44-B798-D934F02251D4}"/>
              </a:ext>
            </a:extLst>
          </p:cNvPr>
          <p:cNvCxnSpPr>
            <a:cxnSpLocks/>
          </p:cNvCxnSpPr>
          <p:nvPr userDrawn="1"/>
        </p:nvCxnSpPr>
        <p:spPr>
          <a:xfrm>
            <a:off x="565574" y="1194203"/>
            <a:ext cx="11041501" cy="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sp>
        <p:nvSpPr>
          <p:cNvPr id="11" name="Text Placeholder 6">
            <a:extLst>
              <a:ext uri="{FF2B5EF4-FFF2-40B4-BE49-F238E27FC236}">
                <a16:creationId xmlns:a16="http://schemas.microsoft.com/office/drawing/2014/main" id="{D70E65FF-BB5B-E84E-BC12-275FA7C9165E}"/>
              </a:ext>
            </a:extLst>
          </p:cNvPr>
          <p:cNvSpPr>
            <a:spLocks noGrp="1"/>
          </p:cNvSpPr>
          <p:nvPr>
            <p:ph type="body" sz="quarter" idx="16" hasCustomPrompt="1"/>
          </p:nvPr>
        </p:nvSpPr>
        <p:spPr>
          <a:xfrm>
            <a:off x="575733" y="1536001"/>
            <a:ext cx="11050693" cy="285255"/>
          </a:xfrm>
        </p:spPr>
        <p:txBody>
          <a:bodyPr anchor="b"/>
          <a:lstStyle>
            <a:lvl1pPr marL="0" indent="0">
              <a:buNone/>
              <a:defRPr sz="1467" b="1">
                <a:solidFill>
                  <a:schemeClr val="accent1"/>
                </a:solidFill>
                <a:latin typeface="+mj-lt"/>
              </a:defRPr>
            </a:lvl1pPr>
            <a:lvl2pPr>
              <a:defRPr/>
            </a:lvl2pPr>
            <a:lvl3pPr>
              <a:defRPr/>
            </a:lvl3pPr>
            <a:lvl4pPr>
              <a:defRPr/>
            </a:lvl4pPr>
            <a:lvl5pPr>
              <a:defRPr/>
            </a:lvl5pPr>
          </a:lstStyle>
          <a:p>
            <a:pPr lvl="0"/>
            <a:r>
              <a:rPr lang="en-US" dirty="0"/>
              <a:t>Click to add heading text</a:t>
            </a:r>
            <a:endParaRPr lang="en-GB" dirty="0"/>
          </a:p>
        </p:txBody>
      </p:sp>
    </p:spTree>
    <p:extLst>
      <p:ext uri="{BB962C8B-B14F-4D97-AF65-F5344CB8AC3E}">
        <p14:creationId xmlns:p14="http://schemas.microsoft.com/office/powerpoint/2010/main" val="3660740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F51350-2A15-440E-8758-9014D43DC8E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4F4E69C-6913-4BD7-A75D-99860690CFC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27FA7E0-0719-43F9-B719-BA30E70999CD}"/>
              </a:ext>
            </a:extLst>
          </p:cNvPr>
          <p:cNvSpPr>
            <a:spLocks noGrp="1"/>
          </p:cNvSpPr>
          <p:nvPr>
            <p:ph type="dt" sz="half" idx="10"/>
          </p:nvPr>
        </p:nvSpPr>
        <p:spPr/>
        <p:txBody>
          <a:bodyPr/>
          <a:lstStyle/>
          <a:p>
            <a:fld id="{6D8E67F6-22BE-4FA0-8403-CDA14006433B}" type="datetimeFigureOut">
              <a:rPr lang="en-US" smtClean="0"/>
              <a:t>10/17/2021</a:t>
            </a:fld>
            <a:endParaRPr lang="en-US"/>
          </a:p>
        </p:txBody>
      </p:sp>
      <p:sp>
        <p:nvSpPr>
          <p:cNvPr id="5" name="Footer Placeholder 4">
            <a:extLst>
              <a:ext uri="{FF2B5EF4-FFF2-40B4-BE49-F238E27FC236}">
                <a16:creationId xmlns:a16="http://schemas.microsoft.com/office/drawing/2014/main" id="{725DD1D4-530C-4D71-8157-0036CC83312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EF757B2-06BB-434F-BD7B-AA894883BB5A}"/>
              </a:ext>
            </a:extLst>
          </p:cNvPr>
          <p:cNvSpPr>
            <a:spLocks noGrp="1"/>
          </p:cNvSpPr>
          <p:nvPr>
            <p:ph type="sldNum" sz="quarter" idx="12"/>
          </p:nvPr>
        </p:nvSpPr>
        <p:spPr/>
        <p:txBody>
          <a:bodyPr/>
          <a:lstStyle/>
          <a:p>
            <a:fld id="{252F9753-9956-4FBA-843C-B77A85B76D67}" type="slidenum">
              <a:rPr lang="en-US" smtClean="0"/>
              <a:t>‹#›</a:t>
            </a:fld>
            <a:endParaRPr lang="en-US"/>
          </a:p>
        </p:txBody>
      </p:sp>
    </p:spTree>
    <p:extLst>
      <p:ext uri="{BB962C8B-B14F-4D97-AF65-F5344CB8AC3E}">
        <p14:creationId xmlns:p14="http://schemas.microsoft.com/office/powerpoint/2010/main" val="2973995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A56C4F-25F8-4F52-B53F-05941901F26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92D835B-14A3-4E2A-A24E-906CBFF0E22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09B4F74-9855-4DC4-8809-424A8DA93B0D}"/>
              </a:ext>
            </a:extLst>
          </p:cNvPr>
          <p:cNvSpPr>
            <a:spLocks noGrp="1"/>
          </p:cNvSpPr>
          <p:nvPr>
            <p:ph type="dt" sz="half" idx="10"/>
          </p:nvPr>
        </p:nvSpPr>
        <p:spPr/>
        <p:txBody>
          <a:bodyPr/>
          <a:lstStyle/>
          <a:p>
            <a:fld id="{6D8E67F6-22BE-4FA0-8403-CDA14006433B}" type="datetimeFigureOut">
              <a:rPr lang="en-US" smtClean="0"/>
              <a:t>10/17/2021</a:t>
            </a:fld>
            <a:endParaRPr lang="en-US"/>
          </a:p>
        </p:txBody>
      </p:sp>
      <p:sp>
        <p:nvSpPr>
          <p:cNvPr id="5" name="Footer Placeholder 4">
            <a:extLst>
              <a:ext uri="{FF2B5EF4-FFF2-40B4-BE49-F238E27FC236}">
                <a16:creationId xmlns:a16="http://schemas.microsoft.com/office/drawing/2014/main" id="{0E393E4F-F447-49DB-B8B0-098F4DC4F6A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16D2CBE-7F1A-48F2-BB70-9F8ECC06E61D}"/>
              </a:ext>
            </a:extLst>
          </p:cNvPr>
          <p:cNvSpPr>
            <a:spLocks noGrp="1"/>
          </p:cNvSpPr>
          <p:nvPr>
            <p:ph type="sldNum" sz="quarter" idx="12"/>
          </p:nvPr>
        </p:nvSpPr>
        <p:spPr/>
        <p:txBody>
          <a:bodyPr/>
          <a:lstStyle/>
          <a:p>
            <a:fld id="{252F9753-9956-4FBA-843C-B77A85B76D67}" type="slidenum">
              <a:rPr lang="en-US" smtClean="0"/>
              <a:t>‹#›</a:t>
            </a:fld>
            <a:endParaRPr lang="en-US"/>
          </a:p>
        </p:txBody>
      </p:sp>
    </p:spTree>
    <p:extLst>
      <p:ext uri="{BB962C8B-B14F-4D97-AF65-F5344CB8AC3E}">
        <p14:creationId xmlns:p14="http://schemas.microsoft.com/office/powerpoint/2010/main" val="9498715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4EF035-2FCF-4E4F-BA75-68EF578D884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B931FEC-8691-4FAA-8318-96100E9F4AD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7F0B75C-D883-4298-9B73-19A497177AF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BA6CAA4-8BA3-4446-A95C-88D0CAE00281}"/>
              </a:ext>
            </a:extLst>
          </p:cNvPr>
          <p:cNvSpPr>
            <a:spLocks noGrp="1"/>
          </p:cNvSpPr>
          <p:nvPr>
            <p:ph type="dt" sz="half" idx="10"/>
          </p:nvPr>
        </p:nvSpPr>
        <p:spPr/>
        <p:txBody>
          <a:bodyPr/>
          <a:lstStyle/>
          <a:p>
            <a:fld id="{6D8E67F6-22BE-4FA0-8403-CDA14006433B}" type="datetimeFigureOut">
              <a:rPr lang="en-US" smtClean="0"/>
              <a:t>10/17/2021</a:t>
            </a:fld>
            <a:endParaRPr lang="en-US"/>
          </a:p>
        </p:txBody>
      </p:sp>
      <p:sp>
        <p:nvSpPr>
          <p:cNvPr id="6" name="Footer Placeholder 5">
            <a:extLst>
              <a:ext uri="{FF2B5EF4-FFF2-40B4-BE49-F238E27FC236}">
                <a16:creationId xmlns:a16="http://schemas.microsoft.com/office/drawing/2014/main" id="{066273A6-CD8F-4A11-9737-1DA06EBEBE1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E95A1FB-F8BE-4EC0-84A9-00BA17050E72}"/>
              </a:ext>
            </a:extLst>
          </p:cNvPr>
          <p:cNvSpPr>
            <a:spLocks noGrp="1"/>
          </p:cNvSpPr>
          <p:nvPr>
            <p:ph type="sldNum" sz="quarter" idx="12"/>
          </p:nvPr>
        </p:nvSpPr>
        <p:spPr/>
        <p:txBody>
          <a:bodyPr/>
          <a:lstStyle/>
          <a:p>
            <a:fld id="{252F9753-9956-4FBA-843C-B77A85B76D67}" type="slidenum">
              <a:rPr lang="en-US" smtClean="0"/>
              <a:t>‹#›</a:t>
            </a:fld>
            <a:endParaRPr lang="en-US"/>
          </a:p>
        </p:txBody>
      </p:sp>
    </p:spTree>
    <p:extLst>
      <p:ext uri="{BB962C8B-B14F-4D97-AF65-F5344CB8AC3E}">
        <p14:creationId xmlns:p14="http://schemas.microsoft.com/office/powerpoint/2010/main" val="41310859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021843-9864-4215-804A-928F5D96F62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DEE7575-51BB-444F-95CB-E982E2CBCA1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258E454-EFD4-4BBD-990F-B5D31AF2EDD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7C9A944-1F6C-4D75-BCCD-320E7E60E86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CF5132A-42F9-4772-9D73-B045FC73C46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2D5167F-EDE3-4ECE-AE96-3A0357B9B922}"/>
              </a:ext>
            </a:extLst>
          </p:cNvPr>
          <p:cNvSpPr>
            <a:spLocks noGrp="1"/>
          </p:cNvSpPr>
          <p:nvPr>
            <p:ph type="dt" sz="half" idx="10"/>
          </p:nvPr>
        </p:nvSpPr>
        <p:spPr/>
        <p:txBody>
          <a:bodyPr/>
          <a:lstStyle/>
          <a:p>
            <a:fld id="{6D8E67F6-22BE-4FA0-8403-CDA14006433B}" type="datetimeFigureOut">
              <a:rPr lang="en-US" smtClean="0"/>
              <a:t>10/17/2021</a:t>
            </a:fld>
            <a:endParaRPr lang="en-US"/>
          </a:p>
        </p:txBody>
      </p:sp>
      <p:sp>
        <p:nvSpPr>
          <p:cNvPr id="8" name="Footer Placeholder 7">
            <a:extLst>
              <a:ext uri="{FF2B5EF4-FFF2-40B4-BE49-F238E27FC236}">
                <a16:creationId xmlns:a16="http://schemas.microsoft.com/office/drawing/2014/main" id="{44D719FD-1724-4D7A-BB4D-5E5B0478C26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A625918-54AC-41C7-8F63-BC5710F9F9C1}"/>
              </a:ext>
            </a:extLst>
          </p:cNvPr>
          <p:cNvSpPr>
            <a:spLocks noGrp="1"/>
          </p:cNvSpPr>
          <p:nvPr>
            <p:ph type="sldNum" sz="quarter" idx="12"/>
          </p:nvPr>
        </p:nvSpPr>
        <p:spPr/>
        <p:txBody>
          <a:bodyPr/>
          <a:lstStyle/>
          <a:p>
            <a:fld id="{252F9753-9956-4FBA-843C-B77A85B76D67}" type="slidenum">
              <a:rPr lang="en-US" smtClean="0"/>
              <a:t>‹#›</a:t>
            </a:fld>
            <a:endParaRPr lang="en-US"/>
          </a:p>
        </p:txBody>
      </p:sp>
    </p:spTree>
    <p:extLst>
      <p:ext uri="{BB962C8B-B14F-4D97-AF65-F5344CB8AC3E}">
        <p14:creationId xmlns:p14="http://schemas.microsoft.com/office/powerpoint/2010/main" val="32630637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EDDB09-104A-43FE-AA38-7FE5145A294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4DAE0C6-449C-4F32-B0C7-E8DCB35CB69E}"/>
              </a:ext>
            </a:extLst>
          </p:cNvPr>
          <p:cNvSpPr>
            <a:spLocks noGrp="1"/>
          </p:cNvSpPr>
          <p:nvPr>
            <p:ph type="dt" sz="half" idx="10"/>
          </p:nvPr>
        </p:nvSpPr>
        <p:spPr/>
        <p:txBody>
          <a:bodyPr/>
          <a:lstStyle/>
          <a:p>
            <a:fld id="{6D8E67F6-22BE-4FA0-8403-CDA14006433B}" type="datetimeFigureOut">
              <a:rPr lang="en-US" smtClean="0"/>
              <a:t>10/17/2021</a:t>
            </a:fld>
            <a:endParaRPr lang="en-US"/>
          </a:p>
        </p:txBody>
      </p:sp>
      <p:sp>
        <p:nvSpPr>
          <p:cNvPr id="4" name="Footer Placeholder 3">
            <a:extLst>
              <a:ext uri="{FF2B5EF4-FFF2-40B4-BE49-F238E27FC236}">
                <a16:creationId xmlns:a16="http://schemas.microsoft.com/office/drawing/2014/main" id="{CA26A3C3-316C-414B-A2AD-AA6A9D8190E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D68F8FD-D55A-4738-8B73-64BAFC69C7F3}"/>
              </a:ext>
            </a:extLst>
          </p:cNvPr>
          <p:cNvSpPr>
            <a:spLocks noGrp="1"/>
          </p:cNvSpPr>
          <p:nvPr>
            <p:ph type="sldNum" sz="quarter" idx="12"/>
          </p:nvPr>
        </p:nvSpPr>
        <p:spPr/>
        <p:txBody>
          <a:bodyPr/>
          <a:lstStyle/>
          <a:p>
            <a:fld id="{252F9753-9956-4FBA-843C-B77A85B76D67}" type="slidenum">
              <a:rPr lang="en-US" smtClean="0"/>
              <a:t>‹#›</a:t>
            </a:fld>
            <a:endParaRPr lang="en-US"/>
          </a:p>
        </p:txBody>
      </p:sp>
    </p:spTree>
    <p:extLst>
      <p:ext uri="{BB962C8B-B14F-4D97-AF65-F5344CB8AC3E}">
        <p14:creationId xmlns:p14="http://schemas.microsoft.com/office/powerpoint/2010/main" val="30009968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2392B7E-6587-4989-8167-61C6AC43DAC8}"/>
              </a:ext>
            </a:extLst>
          </p:cNvPr>
          <p:cNvSpPr>
            <a:spLocks noGrp="1"/>
          </p:cNvSpPr>
          <p:nvPr>
            <p:ph type="dt" sz="half" idx="10"/>
          </p:nvPr>
        </p:nvSpPr>
        <p:spPr/>
        <p:txBody>
          <a:bodyPr/>
          <a:lstStyle/>
          <a:p>
            <a:fld id="{6D8E67F6-22BE-4FA0-8403-CDA14006433B}" type="datetimeFigureOut">
              <a:rPr lang="en-US" smtClean="0"/>
              <a:t>10/17/2021</a:t>
            </a:fld>
            <a:endParaRPr lang="en-US"/>
          </a:p>
        </p:txBody>
      </p:sp>
      <p:sp>
        <p:nvSpPr>
          <p:cNvPr id="3" name="Footer Placeholder 2">
            <a:extLst>
              <a:ext uri="{FF2B5EF4-FFF2-40B4-BE49-F238E27FC236}">
                <a16:creationId xmlns:a16="http://schemas.microsoft.com/office/drawing/2014/main" id="{DAADB7CD-61D5-4876-9384-9CF91F2830C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DAAB85E-E70C-44FE-A21F-183DDDA1F6FF}"/>
              </a:ext>
            </a:extLst>
          </p:cNvPr>
          <p:cNvSpPr>
            <a:spLocks noGrp="1"/>
          </p:cNvSpPr>
          <p:nvPr>
            <p:ph type="sldNum" sz="quarter" idx="12"/>
          </p:nvPr>
        </p:nvSpPr>
        <p:spPr/>
        <p:txBody>
          <a:bodyPr/>
          <a:lstStyle/>
          <a:p>
            <a:fld id="{252F9753-9956-4FBA-843C-B77A85B76D67}" type="slidenum">
              <a:rPr lang="en-US" smtClean="0"/>
              <a:t>‹#›</a:t>
            </a:fld>
            <a:endParaRPr lang="en-US"/>
          </a:p>
        </p:txBody>
      </p:sp>
    </p:spTree>
    <p:extLst>
      <p:ext uri="{BB962C8B-B14F-4D97-AF65-F5344CB8AC3E}">
        <p14:creationId xmlns:p14="http://schemas.microsoft.com/office/powerpoint/2010/main" val="22523068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3B0FD3-F39E-474E-904F-622B69CD129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859F838-FE17-4DD0-8541-7C02D2BEA94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C4EA953-E2DF-44C3-A257-2279264FB1E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8C9D7D5-4C51-4248-9D3D-111399874384}"/>
              </a:ext>
            </a:extLst>
          </p:cNvPr>
          <p:cNvSpPr>
            <a:spLocks noGrp="1"/>
          </p:cNvSpPr>
          <p:nvPr>
            <p:ph type="dt" sz="half" idx="10"/>
          </p:nvPr>
        </p:nvSpPr>
        <p:spPr/>
        <p:txBody>
          <a:bodyPr/>
          <a:lstStyle/>
          <a:p>
            <a:fld id="{6D8E67F6-22BE-4FA0-8403-CDA14006433B}" type="datetimeFigureOut">
              <a:rPr lang="en-US" smtClean="0"/>
              <a:t>10/17/2021</a:t>
            </a:fld>
            <a:endParaRPr lang="en-US"/>
          </a:p>
        </p:txBody>
      </p:sp>
      <p:sp>
        <p:nvSpPr>
          <p:cNvPr id="6" name="Footer Placeholder 5">
            <a:extLst>
              <a:ext uri="{FF2B5EF4-FFF2-40B4-BE49-F238E27FC236}">
                <a16:creationId xmlns:a16="http://schemas.microsoft.com/office/drawing/2014/main" id="{C4CE8390-C973-401F-90A0-A886189E99E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BCE0321-31C3-448B-9063-60777290D6BB}"/>
              </a:ext>
            </a:extLst>
          </p:cNvPr>
          <p:cNvSpPr>
            <a:spLocks noGrp="1"/>
          </p:cNvSpPr>
          <p:nvPr>
            <p:ph type="sldNum" sz="quarter" idx="12"/>
          </p:nvPr>
        </p:nvSpPr>
        <p:spPr/>
        <p:txBody>
          <a:bodyPr/>
          <a:lstStyle/>
          <a:p>
            <a:fld id="{252F9753-9956-4FBA-843C-B77A85B76D67}" type="slidenum">
              <a:rPr lang="en-US" smtClean="0"/>
              <a:t>‹#›</a:t>
            </a:fld>
            <a:endParaRPr lang="en-US"/>
          </a:p>
        </p:txBody>
      </p:sp>
    </p:spTree>
    <p:extLst>
      <p:ext uri="{BB962C8B-B14F-4D97-AF65-F5344CB8AC3E}">
        <p14:creationId xmlns:p14="http://schemas.microsoft.com/office/powerpoint/2010/main" val="22463652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30E38B-29ED-460B-AAC1-D8393EEA34C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E343F87-AD7B-4A08-BEBB-CAF96E93C74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3DAAC4F-954D-4677-9A8F-164EA57E571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779DB5A-23B4-4C0E-872F-06F5B5E7308A}"/>
              </a:ext>
            </a:extLst>
          </p:cNvPr>
          <p:cNvSpPr>
            <a:spLocks noGrp="1"/>
          </p:cNvSpPr>
          <p:nvPr>
            <p:ph type="dt" sz="half" idx="10"/>
          </p:nvPr>
        </p:nvSpPr>
        <p:spPr/>
        <p:txBody>
          <a:bodyPr/>
          <a:lstStyle/>
          <a:p>
            <a:fld id="{6D8E67F6-22BE-4FA0-8403-CDA14006433B}" type="datetimeFigureOut">
              <a:rPr lang="en-US" smtClean="0"/>
              <a:t>10/17/2021</a:t>
            </a:fld>
            <a:endParaRPr lang="en-US"/>
          </a:p>
        </p:txBody>
      </p:sp>
      <p:sp>
        <p:nvSpPr>
          <p:cNvPr id="6" name="Footer Placeholder 5">
            <a:extLst>
              <a:ext uri="{FF2B5EF4-FFF2-40B4-BE49-F238E27FC236}">
                <a16:creationId xmlns:a16="http://schemas.microsoft.com/office/drawing/2014/main" id="{7F50E3AF-91CA-455E-B6EB-D74449EC083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24364C6-6A67-4760-ACC0-B6AD03D63A4E}"/>
              </a:ext>
            </a:extLst>
          </p:cNvPr>
          <p:cNvSpPr>
            <a:spLocks noGrp="1"/>
          </p:cNvSpPr>
          <p:nvPr>
            <p:ph type="sldNum" sz="quarter" idx="12"/>
          </p:nvPr>
        </p:nvSpPr>
        <p:spPr/>
        <p:txBody>
          <a:bodyPr/>
          <a:lstStyle/>
          <a:p>
            <a:fld id="{252F9753-9956-4FBA-843C-B77A85B76D67}" type="slidenum">
              <a:rPr lang="en-US" smtClean="0"/>
              <a:t>‹#›</a:t>
            </a:fld>
            <a:endParaRPr lang="en-US"/>
          </a:p>
        </p:txBody>
      </p:sp>
    </p:spTree>
    <p:extLst>
      <p:ext uri="{BB962C8B-B14F-4D97-AF65-F5344CB8AC3E}">
        <p14:creationId xmlns:p14="http://schemas.microsoft.com/office/powerpoint/2010/main" val="6129787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1196C85-A6ED-40D3-9F60-FA7B55A38B2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EABC19B-CAE4-441E-B08A-F96D53EE5C0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CAB65B9-D578-4D90-A1A0-49E16F41DDC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D8E67F6-22BE-4FA0-8403-CDA14006433B}" type="datetimeFigureOut">
              <a:rPr lang="en-US" smtClean="0"/>
              <a:t>10/17/2021</a:t>
            </a:fld>
            <a:endParaRPr lang="en-US"/>
          </a:p>
        </p:txBody>
      </p:sp>
      <p:sp>
        <p:nvSpPr>
          <p:cNvPr id="5" name="Footer Placeholder 4">
            <a:extLst>
              <a:ext uri="{FF2B5EF4-FFF2-40B4-BE49-F238E27FC236}">
                <a16:creationId xmlns:a16="http://schemas.microsoft.com/office/drawing/2014/main" id="{F64B31B8-5E37-4B5E-BB95-D010BA265AF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97216AC-CDCD-47E7-BACB-9339692C1CA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52F9753-9956-4FBA-843C-B77A85B76D67}" type="slidenum">
              <a:rPr lang="en-US" smtClean="0"/>
              <a:t>‹#›</a:t>
            </a:fld>
            <a:endParaRPr lang="en-US"/>
          </a:p>
        </p:txBody>
      </p:sp>
    </p:spTree>
    <p:extLst>
      <p:ext uri="{BB962C8B-B14F-4D97-AF65-F5344CB8AC3E}">
        <p14:creationId xmlns:p14="http://schemas.microsoft.com/office/powerpoint/2010/main" val="19002245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chart" Target="../charts/char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image" Target="../media/image5.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61F0FE-B387-4D5C-8A5D-48A3F91B2193}"/>
              </a:ext>
            </a:extLst>
          </p:cNvPr>
          <p:cNvSpPr>
            <a:spLocks noGrp="1"/>
          </p:cNvSpPr>
          <p:nvPr>
            <p:ph type="title"/>
          </p:nvPr>
        </p:nvSpPr>
        <p:spPr/>
        <p:txBody>
          <a:bodyPr/>
          <a:lstStyle/>
          <a:p>
            <a:r>
              <a:rPr lang="en-US" dirty="0"/>
              <a:t>Rossi et al. Supplemental figures</a:t>
            </a:r>
          </a:p>
        </p:txBody>
      </p:sp>
      <p:sp>
        <p:nvSpPr>
          <p:cNvPr id="3" name="Content Placeholder 2">
            <a:extLst>
              <a:ext uri="{FF2B5EF4-FFF2-40B4-BE49-F238E27FC236}">
                <a16:creationId xmlns:a16="http://schemas.microsoft.com/office/drawing/2014/main" id="{60090915-19E8-4A3F-8A2A-9D14368DD051}"/>
              </a:ext>
            </a:extLst>
          </p:cNvPr>
          <p:cNvSpPr>
            <a:spLocks noGrp="1"/>
          </p:cNvSpPr>
          <p:nvPr>
            <p:ph idx="1"/>
          </p:nvPr>
        </p:nvSpPr>
        <p:spPr/>
        <p:txBody>
          <a:bodyPr/>
          <a:lstStyle/>
          <a:p>
            <a:r>
              <a:rPr lang="en-US" sz="1400" b="1" dirty="0"/>
              <a:t>Figure S1. Long read DNA contig in </a:t>
            </a:r>
            <a:r>
              <a:rPr lang="en-US" sz="1400" b="1" dirty="0" err="1"/>
              <a:t>SiHa</a:t>
            </a:r>
            <a:r>
              <a:rPr lang="en-US" sz="1400" b="1" dirty="0"/>
              <a:t> cervical cancer cells. </a:t>
            </a:r>
            <a:r>
              <a:rPr lang="en-US" sz="1400" dirty="0"/>
              <a:t>A 54 kb contig is shown containing the integrated HPV16 sequence and flanking human DNA. The Human DNA are rearranged with the sequences at the HPV junctions being 300kb apart on the human genome as described (Akagi et al. 2014). Human DNA is shown in Blue and light blue, and HPV sequences in red. </a:t>
            </a:r>
          </a:p>
          <a:p>
            <a:r>
              <a:rPr lang="en-US" sz="1400" b="1" dirty="0"/>
              <a:t>Figure S2. Ultra-HMW </a:t>
            </a:r>
            <a:r>
              <a:rPr lang="en-US" sz="1400" b="1" dirty="0" err="1"/>
              <a:t>CaSki</a:t>
            </a:r>
            <a:r>
              <a:rPr lang="en-US" sz="1400" b="1" dirty="0"/>
              <a:t> reads containing multiple human HPV junctions. </a:t>
            </a:r>
            <a:r>
              <a:rPr lang="en-US" sz="1400" dirty="0"/>
              <a:t>Representative sequence reads are shown containing HPV16 DNA blocs flanked on with side by human DNA or vice-versa. Human sequences are in light blue. Locations of HPV and human sequences are shown below the bars.</a:t>
            </a:r>
          </a:p>
          <a:p>
            <a:r>
              <a:rPr lang="en-US" sz="1400" b="1" dirty="0"/>
              <a:t>Figure S3. Read count data for SNU-1000 cells. </a:t>
            </a:r>
            <a:r>
              <a:rPr lang="en-US" sz="1400" dirty="0"/>
              <a:t>The read counts normalized and converted to a Z score was plotted for 10 MB intervals on all chromosomes. The arrow indicates the position of the </a:t>
            </a:r>
            <a:r>
              <a:rPr lang="en-US" sz="1400" i="1" dirty="0"/>
              <a:t>YAP1</a:t>
            </a:r>
            <a:r>
              <a:rPr lang="en-US" sz="1400" dirty="0"/>
              <a:t> oncogene.</a:t>
            </a:r>
          </a:p>
          <a:p>
            <a:r>
              <a:rPr lang="en-US" sz="1400" b="1" dirty="0"/>
              <a:t>Figure S4. Example of an HPV rearrangement in a cervical tumor. </a:t>
            </a:r>
            <a:r>
              <a:rPr lang="en-US" sz="1400" dirty="0"/>
              <a:t>The sequence at the junction of an HPV-HPV rearrangement in the tumor T04 is shown. The reads in IGV are shown as well as the sequence of the 7635 region.</a:t>
            </a:r>
          </a:p>
          <a:p>
            <a:r>
              <a:rPr lang="en-US" sz="1400" b="1" dirty="0"/>
              <a:t>Figure S5. RNA sequence reads of episomal only, HPV-16 positive tumors. </a:t>
            </a:r>
            <a:r>
              <a:rPr lang="en-US" sz="1400" dirty="0"/>
              <a:t>RNA sequence reads aligned to the HPV16 genome are shown for 3 EP-only tumors with either monomer, rearranged or multimer episomes.</a:t>
            </a:r>
          </a:p>
          <a:p>
            <a:r>
              <a:rPr lang="en-US" sz="2800" b="1" dirty="0"/>
              <a:t>Figure S2. Ultra-HMW</a:t>
            </a:r>
            <a:endParaRPr lang="en-US" dirty="0"/>
          </a:p>
        </p:txBody>
      </p:sp>
    </p:spTree>
    <p:extLst>
      <p:ext uri="{BB962C8B-B14F-4D97-AF65-F5344CB8AC3E}">
        <p14:creationId xmlns:p14="http://schemas.microsoft.com/office/powerpoint/2010/main" val="7697933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itle 1">
            <a:extLst>
              <a:ext uri="{FF2B5EF4-FFF2-40B4-BE49-F238E27FC236}">
                <a16:creationId xmlns:a16="http://schemas.microsoft.com/office/drawing/2014/main" id="{5F24C44F-4DF8-4216-8F4F-88B937101D2D}"/>
              </a:ext>
            </a:extLst>
          </p:cNvPr>
          <p:cNvSpPr txBox="1">
            <a:spLocks/>
          </p:cNvSpPr>
          <p:nvPr/>
        </p:nvSpPr>
        <p:spPr>
          <a:xfrm>
            <a:off x="519738" y="108504"/>
            <a:ext cx="10255057" cy="738664"/>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cap="none">
                <a:solidFill>
                  <a:schemeClr val="tx1"/>
                </a:solidFill>
                <a:latin typeface="+mj-lt"/>
                <a:ea typeface="+mj-ea"/>
                <a:cs typeface="+mj-cs"/>
              </a:defRPr>
            </a:lvl1pPr>
          </a:lstStyle>
          <a:p>
            <a:r>
              <a:rPr lang="en-US" i="1" dirty="0"/>
              <a:t>S1</a:t>
            </a:r>
          </a:p>
        </p:txBody>
      </p:sp>
      <p:sp>
        <p:nvSpPr>
          <p:cNvPr id="16" name="Text Placeholder 3">
            <a:extLst>
              <a:ext uri="{FF2B5EF4-FFF2-40B4-BE49-F238E27FC236}">
                <a16:creationId xmlns:a16="http://schemas.microsoft.com/office/drawing/2014/main" id="{2DC7B3C8-356E-4C57-BDF3-A2D6ADD08088}"/>
              </a:ext>
            </a:extLst>
          </p:cNvPr>
          <p:cNvSpPr txBox="1">
            <a:spLocks/>
          </p:cNvSpPr>
          <p:nvPr/>
        </p:nvSpPr>
        <p:spPr>
          <a:xfrm>
            <a:off x="1676084" y="4194948"/>
            <a:ext cx="9994613" cy="72750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accent3"/>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accent3"/>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accent3"/>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accent3"/>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accent3"/>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2133" b="1" dirty="0"/>
              <a:t>Human   13-73.5 MB                   HPV                     Human 73.2 MB</a:t>
            </a:r>
          </a:p>
        </p:txBody>
      </p:sp>
      <p:sp>
        <p:nvSpPr>
          <p:cNvPr id="17" name="Rectangle 16">
            <a:extLst>
              <a:ext uri="{FF2B5EF4-FFF2-40B4-BE49-F238E27FC236}">
                <a16:creationId xmlns:a16="http://schemas.microsoft.com/office/drawing/2014/main" id="{91B01D74-1277-429A-9ABC-27AEAD357EDC}"/>
              </a:ext>
            </a:extLst>
          </p:cNvPr>
          <p:cNvSpPr/>
          <p:nvPr/>
        </p:nvSpPr>
        <p:spPr>
          <a:xfrm>
            <a:off x="1763417" y="3851092"/>
            <a:ext cx="3013753" cy="123289"/>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a:p>
        </p:txBody>
      </p:sp>
      <p:sp>
        <p:nvSpPr>
          <p:cNvPr id="18" name="Rectangle 17">
            <a:extLst>
              <a:ext uri="{FF2B5EF4-FFF2-40B4-BE49-F238E27FC236}">
                <a16:creationId xmlns:a16="http://schemas.microsoft.com/office/drawing/2014/main" id="{34C84CC1-DAC4-4A89-AB30-FECE940212CE}"/>
              </a:ext>
            </a:extLst>
          </p:cNvPr>
          <p:cNvSpPr/>
          <p:nvPr/>
        </p:nvSpPr>
        <p:spPr>
          <a:xfrm>
            <a:off x="4722517" y="3850230"/>
            <a:ext cx="3013753" cy="123289"/>
          </a:xfrm>
          <a:prstGeom prst="rect">
            <a:avLst/>
          </a:prstGeom>
          <a:solidFill>
            <a:schemeClr val="accent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a:solidFill>
                <a:schemeClr val="accent1"/>
              </a:solidFill>
            </a:endParaRPr>
          </a:p>
        </p:txBody>
      </p:sp>
      <p:sp>
        <p:nvSpPr>
          <p:cNvPr id="19" name="Rectangle 18">
            <a:extLst>
              <a:ext uri="{FF2B5EF4-FFF2-40B4-BE49-F238E27FC236}">
                <a16:creationId xmlns:a16="http://schemas.microsoft.com/office/drawing/2014/main" id="{3E1F5393-D198-409F-BE0D-6C234B3EC153}"/>
              </a:ext>
            </a:extLst>
          </p:cNvPr>
          <p:cNvSpPr/>
          <p:nvPr/>
        </p:nvSpPr>
        <p:spPr>
          <a:xfrm>
            <a:off x="7719717" y="3838392"/>
            <a:ext cx="965343" cy="135989"/>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400">
              <a:solidFill>
                <a:srgbClr val="00B0F0"/>
              </a:solidFill>
            </a:endParaRPr>
          </a:p>
        </p:txBody>
      </p:sp>
      <p:sp>
        <p:nvSpPr>
          <p:cNvPr id="20" name="Arrow: Left 19">
            <a:extLst>
              <a:ext uri="{FF2B5EF4-FFF2-40B4-BE49-F238E27FC236}">
                <a16:creationId xmlns:a16="http://schemas.microsoft.com/office/drawing/2014/main" id="{A116A79C-3A53-4DC6-8B65-42FC5E9BAC82}"/>
              </a:ext>
            </a:extLst>
          </p:cNvPr>
          <p:cNvSpPr/>
          <p:nvPr/>
        </p:nvSpPr>
        <p:spPr>
          <a:xfrm>
            <a:off x="5190489" y="4558702"/>
            <a:ext cx="1396753" cy="285255"/>
          </a:xfrm>
          <a:prstGeom prst="leftArrow">
            <a:avLst/>
          </a:prstGeom>
          <a:solidFill>
            <a:schemeClr val="accent2">
              <a:lumMod val="75000"/>
            </a:scheme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p>
        </p:txBody>
      </p:sp>
      <p:cxnSp>
        <p:nvCxnSpPr>
          <p:cNvPr id="21" name="Straight Connector 20">
            <a:extLst>
              <a:ext uri="{FF2B5EF4-FFF2-40B4-BE49-F238E27FC236}">
                <a16:creationId xmlns:a16="http://schemas.microsoft.com/office/drawing/2014/main" id="{852E1CEA-20CC-4D70-97A7-FD71B1B8C66F}"/>
              </a:ext>
            </a:extLst>
          </p:cNvPr>
          <p:cNvCxnSpPr>
            <a:cxnSpLocks/>
            <a:stCxn id="18" idx="1"/>
          </p:cNvCxnSpPr>
          <p:nvPr/>
        </p:nvCxnSpPr>
        <p:spPr>
          <a:xfrm flipV="1">
            <a:off x="4722517" y="2333579"/>
            <a:ext cx="4388825" cy="1578296"/>
          </a:xfrm>
          <a:prstGeom prst="line">
            <a:avLst/>
          </a:prstGeom>
          <a:ln w="57150" cmpd="sng">
            <a:solidFill>
              <a:schemeClr val="accent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22" name="Straight Connector 21">
            <a:extLst>
              <a:ext uri="{FF2B5EF4-FFF2-40B4-BE49-F238E27FC236}">
                <a16:creationId xmlns:a16="http://schemas.microsoft.com/office/drawing/2014/main" id="{253B0731-1593-44F5-AD24-F4380644A3B8}"/>
              </a:ext>
            </a:extLst>
          </p:cNvPr>
          <p:cNvCxnSpPr>
            <a:cxnSpLocks/>
            <a:stCxn id="19" idx="1"/>
          </p:cNvCxnSpPr>
          <p:nvPr/>
        </p:nvCxnSpPr>
        <p:spPr>
          <a:xfrm flipH="1" flipV="1">
            <a:off x="4957567" y="2321741"/>
            <a:ext cx="2762150" cy="1584646"/>
          </a:xfrm>
          <a:prstGeom prst="line">
            <a:avLst/>
          </a:prstGeom>
          <a:ln w="57150" cmpd="sng">
            <a:solidFill>
              <a:schemeClr val="accent1"/>
            </a:solidFill>
            <a:tailEnd type="triangle"/>
          </a:ln>
          <a:effectLst/>
        </p:spPr>
        <p:style>
          <a:lnRef idx="2">
            <a:schemeClr val="accent1"/>
          </a:lnRef>
          <a:fillRef idx="0">
            <a:schemeClr val="accent1"/>
          </a:fillRef>
          <a:effectRef idx="1">
            <a:schemeClr val="accent1"/>
          </a:effectRef>
          <a:fontRef idx="minor">
            <a:schemeClr val="tx1"/>
          </a:fontRef>
        </p:style>
      </p:cxnSp>
      <p:sp>
        <p:nvSpPr>
          <p:cNvPr id="23" name="Rectangle 22">
            <a:extLst>
              <a:ext uri="{FF2B5EF4-FFF2-40B4-BE49-F238E27FC236}">
                <a16:creationId xmlns:a16="http://schemas.microsoft.com/office/drawing/2014/main" id="{247AA364-35D9-4A1D-B73C-1F84C4E6BDB7}"/>
              </a:ext>
            </a:extLst>
          </p:cNvPr>
          <p:cNvSpPr/>
          <p:nvPr/>
        </p:nvSpPr>
        <p:spPr>
          <a:xfrm>
            <a:off x="2880147" y="2012675"/>
            <a:ext cx="2077420" cy="309066"/>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chemeClr val="tx1"/>
                </a:solidFill>
              </a:rPr>
              <a:t>A</a:t>
            </a:r>
          </a:p>
        </p:txBody>
      </p:sp>
      <p:sp>
        <p:nvSpPr>
          <p:cNvPr id="24" name="Rectangle 23">
            <a:extLst>
              <a:ext uri="{FF2B5EF4-FFF2-40B4-BE49-F238E27FC236}">
                <a16:creationId xmlns:a16="http://schemas.microsoft.com/office/drawing/2014/main" id="{6125EB7F-BB7A-42C9-9A67-53910B5C4F54}"/>
              </a:ext>
            </a:extLst>
          </p:cNvPr>
          <p:cNvSpPr/>
          <p:nvPr/>
        </p:nvSpPr>
        <p:spPr>
          <a:xfrm>
            <a:off x="4981089" y="2007187"/>
            <a:ext cx="4130253" cy="309066"/>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b="1" dirty="0">
                <a:solidFill>
                  <a:schemeClr val="tx1"/>
                </a:solidFill>
              </a:rPr>
              <a:t>B</a:t>
            </a:r>
          </a:p>
        </p:txBody>
      </p:sp>
    </p:spTree>
    <p:extLst>
      <p:ext uri="{BB962C8B-B14F-4D97-AF65-F5344CB8AC3E}">
        <p14:creationId xmlns:p14="http://schemas.microsoft.com/office/powerpoint/2010/main" val="94597547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2"/>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89B21F16-9308-4571-8693-2E57F92F0CF9}"/>
              </a:ext>
            </a:extLst>
          </p:cNvPr>
          <p:cNvSpPr>
            <a:spLocks noGrp="1"/>
          </p:cNvSpPr>
          <p:nvPr>
            <p:ph type="title"/>
          </p:nvPr>
        </p:nvSpPr>
        <p:spPr>
          <a:xfrm>
            <a:off x="64185" y="-48377"/>
            <a:ext cx="10515600" cy="1325563"/>
          </a:xfrm>
        </p:spPr>
        <p:txBody>
          <a:bodyPr/>
          <a:lstStyle/>
          <a:p>
            <a:r>
              <a:rPr lang="en-US" b="1" i="1" dirty="0"/>
              <a:t>S2</a:t>
            </a:r>
            <a:br>
              <a:rPr lang="en-US" b="1" i="1" dirty="0"/>
            </a:br>
            <a:endParaRPr lang="en-US" i="1" dirty="0"/>
          </a:p>
        </p:txBody>
      </p:sp>
      <p:sp>
        <p:nvSpPr>
          <p:cNvPr id="5" name="Content Placeholder 2">
            <a:extLst>
              <a:ext uri="{FF2B5EF4-FFF2-40B4-BE49-F238E27FC236}">
                <a16:creationId xmlns:a16="http://schemas.microsoft.com/office/drawing/2014/main" id="{C730A80A-DC23-4C0F-A2FD-23A04E46F5B9}"/>
              </a:ext>
            </a:extLst>
          </p:cNvPr>
          <p:cNvSpPr txBox="1">
            <a:spLocks/>
          </p:cNvSpPr>
          <p:nvPr/>
        </p:nvSpPr>
        <p:spPr>
          <a:xfrm>
            <a:off x="243943" y="1997357"/>
            <a:ext cx="1943100" cy="675361"/>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dirty="0"/>
              <a:t> chr10</a:t>
            </a:r>
          </a:p>
        </p:txBody>
      </p:sp>
      <p:sp>
        <p:nvSpPr>
          <p:cNvPr id="6" name="Rectangle 5">
            <a:extLst>
              <a:ext uri="{FF2B5EF4-FFF2-40B4-BE49-F238E27FC236}">
                <a16:creationId xmlns:a16="http://schemas.microsoft.com/office/drawing/2014/main" id="{1FFA21B6-1312-4CB4-A627-C0FB8C4A8C71}"/>
              </a:ext>
            </a:extLst>
          </p:cNvPr>
          <p:cNvSpPr/>
          <p:nvPr/>
        </p:nvSpPr>
        <p:spPr>
          <a:xfrm>
            <a:off x="2306110" y="2030093"/>
            <a:ext cx="1581150" cy="381000"/>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1DE5C418-29CA-4B5A-A41F-4D7364F01A03}"/>
              </a:ext>
            </a:extLst>
          </p:cNvPr>
          <p:cNvSpPr txBox="1"/>
          <p:nvPr/>
        </p:nvSpPr>
        <p:spPr>
          <a:xfrm>
            <a:off x="2696635" y="2425937"/>
            <a:ext cx="8705850" cy="369332"/>
          </a:xfrm>
          <a:prstGeom prst="rect">
            <a:avLst/>
          </a:prstGeom>
          <a:noFill/>
        </p:spPr>
        <p:txBody>
          <a:bodyPr wrap="square">
            <a:spAutoFit/>
          </a:bodyPr>
          <a:lstStyle/>
          <a:p>
            <a:r>
              <a:rPr lang="en-US" dirty="0"/>
              <a:t>11,700,488  5664                                              470 1972   11,700,451</a:t>
            </a:r>
          </a:p>
        </p:txBody>
      </p:sp>
      <p:sp>
        <p:nvSpPr>
          <p:cNvPr id="8" name="Rectangle 7">
            <a:extLst>
              <a:ext uri="{FF2B5EF4-FFF2-40B4-BE49-F238E27FC236}">
                <a16:creationId xmlns:a16="http://schemas.microsoft.com/office/drawing/2014/main" id="{364B4429-8ABF-403F-AA07-98088E990883}"/>
              </a:ext>
            </a:extLst>
          </p:cNvPr>
          <p:cNvSpPr/>
          <p:nvPr/>
        </p:nvSpPr>
        <p:spPr>
          <a:xfrm>
            <a:off x="3906310" y="2030092"/>
            <a:ext cx="1641505" cy="380999"/>
          </a:xfrm>
          <a:prstGeom prst="rec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a:t>
            </a:r>
          </a:p>
        </p:txBody>
      </p:sp>
      <p:sp>
        <p:nvSpPr>
          <p:cNvPr id="9" name="Rectangle 8">
            <a:extLst>
              <a:ext uri="{FF2B5EF4-FFF2-40B4-BE49-F238E27FC236}">
                <a16:creationId xmlns:a16="http://schemas.microsoft.com/office/drawing/2014/main" id="{C3C78E4C-6B61-40B2-B70D-0F36DD46B98C}"/>
              </a:ext>
            </a:extLst>
          </p:cNvPr>
          <p:cNvSpPr/>
          <p:nvPr/>
        </p:nvSpPr>
        <p:spPr>
          <a:xfrm>
            <a:off x="7603855" y="2027950"/>
            <a:ext cx="2636582" cy="392668"/>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0A8AA1B2-A293-4F4F-B522-02087BD1D783}"/>
              </a:ext>
            </a:extLst>
          </p:cNvPr>
          <p:cNvSpPr txBox="1"/>
          <p:nvPr/>
        </p:nvSpPr>
        <p:spPr>
          <a:xfrm>
            <a:off x="2696635" y="1689376"/>
            <a:ext cx="6398355" cy="369332"/>
          </a:xfrm>
          <a:prstGeom prst="rect">
            <a:avLst/>
          </a:prstGeom>
          <a:noFill/>
        </p:spPr>
        <p:txBody>
          <a:bodyPr wrap="none" rtlCol="0">
            <a:spAutoFit/>
          </a:bodyPr>
          <a:lstStyle/>
          <a:p>
            <a:r>
              <a:rPr lang="en-US" b="1" dirty="0"/>
              <a:t>Human                                    HPV (18kb)                                   Human</a:t>
            </a:r>
          </a:p>
        </p:txBody>
      </p:sp>
      <p:sp>
        <p:nvSpPr>
          <p:cNvPr id="11" name="Rectangle 10">
            <a:extLst>
              <a:ext uri="{FF2B5EF4-FFF2-40B4-BE49-F238E27FC236}">
                <a16:creationId xmlns:a16="http://schemas.microsoft.com/office/drawing/2014/main" id="{C735ED5D-ABF1-4A41-A832-62F05D90810B}"/>
              </a:ext>
            </a:extLst>
          </p:cNvPr>
          <p:cNvSpPr/>
          <p:nvPr/>
        </p:nvSpPr>
        <p:spPr>
          <a:xfrm>
            <a:off x="6832331" y="2030093"/>
            <a:ext cx="771524" cy="380997"/>
          </a:xfrm>
          <a:prstGeom prst="rect">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X</a:t>
            </a:r>
          </a:p>
        </p:txBody>
      </p:sp>
      <p:sp>
        <p:nvSpPr>
          <p:cNvPr id="12" name="Rectangle 11">
            <a:extLst>
              <a:ext uri="{FF2B5EF4-FFF2-40B4-BE49-F238E27FC236}">
                <a16:creationId xmlns:a16="http://schemas.microsoft.com/office/drawing/2014/main" id="{064154FA-EA6D-4207-A7D1-58165352CD61}"/>
              </a:ext>
            </a:extLst>
          </p:cNvPr>
          <p:cNvSpPr/>
          <p:nvPr/>
        </p:nvSpPr>
        <p:spPr>
          <a:xfrm>
            <a:off x="5547815" y="2030093"/>
            <a:ext cx="1295399" cy="380997"/>
          </a:xfrm>
          <a:prstGeom prst="rec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rgbClr val="002060"/>
                </a:solidFill>
              </a:rPr>
              <a:t>B</a:t>
            </a:r>
          </a:p>
        </p:txBody>
      </p:sp>
      <p:sp>
        <p:nvSpPr>
          <p:cNvPr id="13" name="Content Placeholder 2">
            <a:extLst>
              <a:ext uri="{FF2B5EF4-FFF2-40B4-BE49-F238E27FC236}">
                <a16:creationId xmlns:a16="http://schemas.microsoft.com/office/drawing/2014/main" id="{2E0B3FD9-4F50-4350-AD28-671F8F9F5747}"/>
              </a:ext>
            </a:extLst>
          </p:cNvPr>
          <p:cNvSpPr txBox="1">
            <a:spLocks/>
          </p:cNvSpPr>
          <p:nvPr/>
        </p:nvSpPr>
        <p:spPr>
          <a:xfrm>
            <a:off x="202239" y="4559290"/>
            <a:ext cx="10067927" cy="186771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dirty="0"/>
              <a:t> </a:t>
            </a:r>
            <a:r>
              <a:rPr lang="en-US" dirty="0" err="1"/>
              <a:t>chrX</a:t>
            </a:r>
            <a:endParaRPr lang="en-US" dirty="0"/>
          </a:p>
        </p:txBody>
      </p:sp>
      <p:sp>
        <p:nvSpPr>
          <p:cNvPr id="14" name="Rectangle 13">
            <a:extLst>
              <a:ext uri="{FF2B5EF4-FFF2-40B4-BE49-F238E27FC236}">
                <a16:creationId xmlns:a16="http://schemas.microsoft.com/office/drawing/2014/main" id="{D49F91E3-B3F5-48E4-915A-3C5D90AB58A0}"/>
              </a:ext>
            </a:extLst>
          </p:cNvPr>
          <p:cNvSpPr/>
          <p:nvPr/>
        </p:nvSpPr>
        <p:spPr>
          <a:xfrm>
            <a:off x="4812581" y="4637693"/>
            <a:ext cx="1882796" cy="380999"/>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8A82AF99-8F4F-4417-B03E-6B4074E23F4F}"/>
              </a:ext>
            </a:extLst>
          </p:cNvPr>
          <p:cNvSpPr txBox="1"/>
          <p:nvPr/>
        </p:nvSpPr>
        <p:spPr>
          <a:xfrm>
            <a:off x="4130200" y="5042795"/>
            <a:ext cx="8705850" cy="369332"/>
          </a:xfrm>
          <a:prstGeom prst="rect">
            <a:avLst/>
          </a:prstGeom>
          <a:noFill/>
        </p:spPr>
        <p:txBody>
          <a:bodyPr wrap="square">
            <a:spAutoFit/>
          </a:bodyPr>
          <a:lstStyle/>
          <a:p>
            <a:r>
              <a:rPr lang="en-US" dirty="0"/>
              <a:t>2986   145,708,231      145,716,514   3153</a:t>
            </a:r>
          </a:p>
        </p:txBody>
      </p:sp>
      <p:sp>
        <p:nvSpPr>
          <p:cNvPr id="16" name="TextBox 15">
            <a:extLst>
              <a:ext uri="{FF2B5EF4-FFF2-40B4-BE49-F238E27FC236}">
                <a16:creationId xmlns:a16="http://schemas.microsoft.com/office/drawing/2014/main" id="{91DAD75E-D74E-47DA-821F-0C83378CD923}"/>
              </a:ext>
            </a:extLst>
          </p:cNvPr>
          <p:cNvSpPr txBox="1"/>
          <p:nvPr/>
        </p:nvSpPr>
        <p:spPr>
          <a:xfrm>
            <a:off x="2869626" y="4268361"/>
            <a:ext cx="6740243" cy="369332"/>
          </a:xfrm>
          <a:prstGeom prst="rect">
            <a:avLst/>
          </a:prstGeom>
          <a:noFill/>
        </p:spPr>
        <p:txBody>
          <a:bodyPr wrap="none" rtlCol="0">
            <a:spAutoFit/>
          </a:bodyPr>
          <a:lstStyle/>
          <a:p>
            <a:r>
              <a:rPr lang="en-US" b="1" dirty="0"/>
              <a:t>HPV (17 kb)                     Human (8 kb)                                    HPV (49 kb)</a:t>
            </a:r>
          </a:p>
        </p:txBody>
      </p:sp>
      <p:sp>
        <p:nvSpPr>
          <p:cNvPr id="17" name="Content Placeholder 2">
            <a:extLst>
              <a:ext uri="{FF2B5EF4-FFF2-40B4-BE49-F238E27FC236}">
                <a16:creationId xmlns:a16="http://schemas.microsoft.com/office/drawing/2014/main" id="{AF94AC00-E9CD-4139-A116-9786A44B1D5E}"/>
              </a:ext>
            </a:extLst>
          </p:cNvPr>
          <p:cNvSpPr txBox="1">
            <a:spLocks/>
          </p:cNvSpPr>
          <p:nvPr/>
        </p:nvSpPr>
        <p:spPr>
          <a:xfrm>
            <a:off x="202239" y="3086179"/>
            <a:ext cx="10515600" cy="4351338"/>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dirty="0"/>
              <a:t> chr19</a:t>
            </a:r>
          </a:p>
        </p:txBody>
      </p:sp>
      <p:sp>
        <p:nvSpPr>
          <p:cNvPr id="18" name="Rectangle 17">
            <a:extLst>
              <a:ext uri="{FF2B5EF4-FFF2-40B4-BE49-F238E27FC236}">
                <a16:creationId xmlns:a16="http://schemas.microsoft.com/office/drawing/2014/main" id="{7786E2FA-A769-41AD-B1D9-A8FA9F1B118D}"/>
              </a:ext>
            </a:extLst>
          </p:cNvPr>
          <p:cNvSpPr/>
          <p:nvPr/>
        </p:nvSpPr>
        <p:spPr>
          <a:xfrm>
            <a:off x="2991907" y="3133575"/>
            <a:ext cx="2286000" cy="381686"/>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16DF27A3-602C-4004-B5B2-02B71B6B0813}"/>
              </a:ext>
            </a:extLst>
          </p:cNvPr>
          <p:cNvSpPr/>
          <p:nvPr/>
        </p:nvSpPr>
        <p:spPr>
          <a:xfrm>
            <a:off x="2274355" y="3145930"/>
            <a:ext cx="819150" cy="369331"/>
          </a:xfrm>
          <a:prstGeom prst="rect">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a:extLst>
              <a:ext uri="{FF2B5EF4-FFF2-40B4-BE49-F238E27FC236}">
                <a16:creationId xmlns:a16="http://schemas.microsoft.com/office/drawing/2014/main" id="{7DB1B46D-B12F-4C57-AB19-28756BC9C9CE}"/>
              </a:ext>
            </a:extLst>
          </p:cNvPr>
          <p:cNvSpPr txBox="1"/>
          <p:nvPr/>
        </p:nvSpPr>
        <p:spPr>
          <a:xfrm>
            <a:off x="2172757" y="2740140"/>
            <a:ext cx="11130355" cy="369332"/>
          </a:xfrm>
          <a:prstGeom prst="rect">
            <a:avLst/>
          </a:prstGeom>
          <a:noFill/>
        </p:spPr>
        <p:txBody>
          <a:bodyPr wrap="none" rtlCol="0">
            <a:spAutoFit/>
          </a:bodyPr>
          <a:lstStyle/>
          <a:p>
            <a:r>
              <a:rPr lang="en-US" b="1" dirty="0"/>
              <a:t>HPV (37 kb)         Human                      HPV (55 kb)                              Human segments                                                           </a:t>
            </a:r>
          </a:p>
        </p:txBody>
      </p:sp>
      <p:sp>
        <p:nvSpPr>
          <p:cNvPr id="21" name="Rectangle 20">
            <a:extLst>
              <a:ext uri="{FF2B5EF4-FFF2-40B4-BE49-F238E27FC236}">
                <a16:creationId xmlns:a16="http://schemas.microsoft.com/office/drawing/2014/main" id="{B7EC1FC4-B733-4F07-92BB-28A7451007FC}"/>
              </a:ext>
            </a:extLst>
          </p:cNvPr>
          <p:cNvSpPr/>
          <p:nvPr/>
        </p:nvSpPr>
        <p:spPr>
          <a:xfrm>
            <a:off x="5287813" y="3136405"/>
            <a:ext cx="1762126" cy="374891"/>
          </a:xfrm>
          <a:prstGeom prst="rect">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2AC4EF92-3052-4CBF-BDF0-449EADB6E469}"/>
              </a:ext>
            </a:extLst>
          </p:cNvPr>
          <p:cNvSpPr txBox="1"/>
          <p:nvPr/>
        </p:nvSpPr>
        <p:spPr>
          <a:xfrm>
            <a:off x="2325159" y="3514574"/>
            <a:ext cx="6096000" cy="369332"/>
          </a:xfrm>
          <a:prstGeom prst="rect">
            <a:avLst/>
          </a:prstGeom>
          <a:noFill/>
        </p:spPr>
        <p:txBody>
          <a:bodyPr wrap="square">
            <a:spAutoFit/>
          </a:bodyPr>
          <a:lstStyle/>
          <a:p>
            <a:r>
              <a:rPr lang="en-US" dirty="0"/>
              <a:t>6901   55,307,401   55,310,208   582</a:t>
            </a:r>
          </a:p>
        </p:txBody>
      </p:sp>
      <p:sp>
        <p:nvSpPr>
          <p:cNvPr id="23" name="Rectangle 22">
            <a:extLst>
              <a:ext uri="{FF2B5EF4-FFF2-40B4-BE49-F238E27FC236}">
                <a16:creationId xmlns:a16="http://schemas.microsoft.com/office/drawing/2014/main" id="{21BD2B33-3DF3-498E-B88E-00433145F71F}"/>
              </a:ext>
            </a:extLst>
          </p:cNvPr>
          <p:cNvSpPr/>
          <p:nvPr/>
        </p:nvSpPr>
        <p:spPr>
          <a:xfrm>
            <a:off x="7401982" y="3127261"/>
            <a:ext cx="1038225" cy="369332"/>
          </a:xfrm>
          <a:prstGeom prst="rect">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a16="http://schemas.microsoft.com/office/drawing/2014/main" id="{52147CA0-7FBF-44B5-AB14-D2000EE3BFC3}"/>
              </a:ext>
            </a:extLst>
          </p:cNvPr>
          <p:cNvSpPr/>
          <p:nvPr/>
        </p:nvSpPr>
        <p:spPr>
          <a:xfrm>
            <a:off x="8440207" y="3124737"/>
            <a:ext cx="742952" cy="380605"/>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9964C6A9-19E2-478D-A657-D1AD12D98A12}"/>
              </a:ext>
            </a:extLst>
          </p:cNvPr>
          <p:cNvSpPr/>
          <p:nvPr/>
        </p:nvSpPr>
        <p:spPr>
          <a:xfrm>
            <a:off x="9202207" y="3134262"/>
            <a:ext cx="742952" cy="376464"/>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B4F16331-E581-4F84-8442-76F27BC38BB8}"/>
              </a:ext>
            </a:extLst>
          </p:cNvPr>
          <p:cNvSpPr/>
          <p:nvPr/>
        </p:nvSpPr>
        <p:spPr>
          <a:xfrm>
            <a:off x="9955063" y="3134643"/>
            <a:ext cx="742952" cy="368840"/>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CB4A43E6-4C42-4F5C-B1E9-C252D2098B14}"/>
              </a:ext>
            </a:extLst>
          </p:cNvPr>
          <p:cNvSpPr/>
          <p:nvPr/>
        </p:nvSpPr>
        <p:spPr>
          <a:xfrm>
            <a:off x="10707159" y="3134262"/>
            <a:ext cx="742952" cy="368840"/>
          </a:xfrm>
          <a:prstGeom prst="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E092D217-2F4C-4CF1-B83F-34D2BE54B01B}"/>
              </a:ext>
            </a:extLst>
          </p:cNvPr>
          <p:cNvSpPr/>
          <p:nvPr/>
        </p:nvSpPr>
        <p:spPr>
          <a:xfrm>
            <a:off x="2303991" y="757977"/>
            <a:ext cx="1581150" cy="367189"/>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TextBox 28">
            <a:extLst>
              <a:ext uri="{FF2B5EF4-FFF2-40B4-BE49-F238E27FC236}">
                <a16:creationId xmlns:a16="http://schemas.microsoft.com/office/drawing/2014/main" id="{E2D6FF18-37B8-46E7-AA00-B30667A48885}"/>
              </a:ext>
            </a:extLst>
          </p:cNvPr>
          <p:cNvSpPr txBox="1"/>
          <p:nvPr/>
        </p:nvSpPr>
        <p:spPr>
          <a:xfrm>
            <a:off x="2694516" y="1153820"/>
            <a:ext cx="6096000" cy="369332"/>
          </a:xfrm>
          <a:prstGeom prst="rect">
            <a:avLst/>
          </a:prstGeom>
          <a:noFill/>
        </p:spPr>
        <p:txBody>
          <a:bodyPr wrap="square">
            <a:spAutoFit/>
          </a:bodyPr>
          <a:lstStyle/>
          <a:p>
            <a:r>
              <a:rPr lang="en-US" dirty="0"/>
              <a:t>45,691,388  3728      1/7906       2246     45,691,417</a:t>
            </a:r>
          </a:p>
        </p:txBody>
      </p:sp>
      <p:sp>
        <p:nvSpPr>
          <p:cNvPr id="30" name="Rectangle 29">
            <a:extLst>
              <a:ext uri="{FF2B5EF4-FFF2-40B4-BE49-F238E27FC236}">
                <a16:creationId xmlns:a16="http://schemas.microsoft.com/office/drawing/2014/main" id="{90F994F6-B0E2-4BAA-8FFB-233208E24261}"/>
              </a:ext>
            </a:extLst>
          </p:cNvPr>
          <p:cNvSpPr/>
          <p:nvPr/>
        </p:nvSpPr>
        <p:spPr>
          <a:xfrm>
            <a:off x="3904191" y="757977"/>
            <a:ext cx="2438400" cy="369332"/>
          </a:xfrm>
          <a:prstGeom prst="rect">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D4914BC4-8A0C-49BF-854C-FF7562C09CF5}"/>
              </a:ext>
            </a:extLst>
          </p:cNvPr>
          <p:cNvSpPr/>
          <p:nvPr/>
        </p:nvSpPr>
        <p:spPr>
          <a:xfrm>
            <a:off x="6352116" y="746309"/>
            <a:ext cx="2324102" cy="378857"/>
          </a:xfrm>
          <a:prstGeom prst="rect">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Arrow: Left 31">
            <a:extLst>
              <a:ext uri="{FF2B5EF4-FFF2-40B4-BE49-F238E27FC236}">
                <a16:creationId xmlns:a16="http://schemas.microsoft.com/office/drawing/2014/main" id="{27ECC9A3-49CF-42A2-8BAF-5D6CEA7B58D8}"/>
              </a:ext>
            </a:extLst>
          </p:cNvPr>
          <p:cNvSpPr/>
          <p:nvPr/>
        </p:nvSpPr>
        <p:spPr>
          <a:xfrm>
            <a:off x="4770966" y="888152"/>
            <a:ext cx="657225" cy="161925"/>
          </a:xfrm>
          <a:prstGeom prst="lef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TextBox 32">
            <a:extLst>
              <a:ext uri="{FF2B5EF4-FFF2-40B4-BE49-F238E27FC236}">
                <a16:creationId xmlns:a16="http://schemas.microsoft.com/office/drawing/2014/main" id="{0325E46F-86F0-413A-BF52-2CDD667C3B54}"/>
              </a:ext>
            </a:extLst>
          </p:cNvPr>
          <p:cNvSpPr txBox="1"/>
          <p:nvPr/>
        </p:nvSpPr>
        <p:spPr>
          <a:xfrm>
            <a:off x="2694516" y="417260"/>
            <a:ext cx="5276253" cy="369332"/>
          </a:xfrm>
          <a:prstGeom prst="rect">
            <a:avLst/>
          </a:prstGeom>
          <a:noFill/>
        </p:spPr>
        <p:txBody>
          <a:bodyPr wrap="none" rtlCol="0">
            <a:spAutoFit/>
          </a:bodyPr>
          <a:lstStyle/>
          <a:p>
            <a:r>
              <a:rPr lang="en-US" b="1" dirty="0"/>
              <a:t>Human                          HPV (9 kb)                         Human</a:t>
            </a:r>
          </a:p>
        </p:txBody>
      </p:sp>
      <p:sp>
        <p:nvSpPr>
          <p:cNvPr id="34" name="TextBox 33">
            <a:extLst>
              <a:ext uri="{FF2B5EF4-FFF2-40B4-BE49-F238E27FC236}">
                <a16:creationId xmlns:a16="http://schemas.microsoft.com/office/drawing/2014/main" id="{B5DDA2DC-5BD4-4F62-8555-D278B427C546}"/>
              </a:ext>
            </a:extLst>
          </p:cNvPr>
          <p:cNvSpPr txBox="1"/>
          <p:nvPr/>
        </p:nvSpPr>
        <p:spPr>
          <a:xfrm>
            <a:off x="243943" y="707504"/>
            <a:ext cx="1023666" cy="523220"/>
          </a:xfrm>
          <a:prstGeom prst="rect">
            <a:avLst/>
          </a:prstGeom>
          <a:noFill/>
        </p:spPr>
        <p:txBody>
          <a:bodyPr wrap="square">
            <a:spAutoFit/>
          </a:bodyPr>
          <a:lstStyle/>
          <a:p>
            <a:pPr marL="0" indent="0">
              <a:buNone/>
            </a:pPr>
            <a:r>
              <a:rPr lang="en-US" sz="2800" dirty="0"/>
              <a:t> chr6</a:t>
            </a:r>
            <a:endParaRPr lang="en-US" dirty="0"/>
          </a:p>
        </p:txBody>
      </p:sp>
      <p:sp>
        <p:nvSpPr>
          <p:cNvPr id="35" name="Rectangle 34">
            <a:extLst>
              <a:ext uri="{FF2B5EF4-FFF2-40B4-BE49-F238E27FC236}">
                <a16:creationId xmlns:a16="http://schemas.microsoft.com/office/drawing/2014/main" id="{A24FBFF6-D144-4A2C-A8B0-2A3DFACA900C}"/>
              </a:ext>
            </a:extLst>
          </p:cNvPr>
          <p:cNvSpPr/>
          <p:nvPr/>
        </p:nvSpPr>
        <p:spPr>
          <a:xfrm>
            <a:off x="1520047" y="4642747"/>
            <a:ext cx="1641505" cy="380999"/>
          </a:xfrm>
          <a:prstGeom prst="rect">
            <a:avLst/>
          </a:prstGeom>
          <a:solidFill>
            <a:srgbClr val="0070C0"/>
          </a:solidFill>
          <a:ln>
            <a:solidFill>
              <a:schemeClr val="tx1">
                <a:lumMod val="85000"/>
                <a:lumOff val="1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a:t>
            </a:r>
          </a:p>
        </p:txBody>
      </p:sp>
      <p:sp>
        <p:nvSpPr>
          <p:cNvPr id="36" name="Rectangle 35">
            <a:extLst>
              <a:ext uri="{FF2B5EF4-FFF2-40B4-BE49-F238E27FC236}">
                <a16:creationId xmlns:a16="http://schemas.microsoft.com/office/drawing/2014/main" id="{719EE9CB-29FF-408B-8C96-2FE4245F2E01}"/>
              </a:ext>
            </a:extLst>
          </p:cNvPr>
          <p:cNvSpPr/>
          <p:nvPr/>
        </p:nvSpPr>
        <p:spPr>
          <a:xfrm>
            <a:off x="3171076" y="4642746"/>
            <a:ext cx="1641505" cy="380999"/>
          </a:xfrm>
          <a:prstGeom prst="rect">
            <a:avLst/>
          </a:prstGeom>
          <a:solidFill>
            <a:srgbClr val="0070C0"/>
          </a:solidFill>
          <a:ln>
            <a:solidFill>
              <a:schemeClr val="tx1">
                <a:lumMod val="85000"/>
                <a:lumOff val="1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a:t>
            </a:r>
          </a:p>
        </p:txBody>
      </p:sp>
      <p:sp>
        <p:nvSpPr>
          <p:cNvPr id="37" name="Rectangle 36">
            <a:extLst>
              <a:ext uri="{FF2B5EF4-FFF2-40B4-BE49-F238E27FC236}">
                <a16:creationId xmlns:a16="http://schemas.microsoft.com/office/drawing/2014/main" id="{0F08C4E0-7E64-4EBC-99E2-2E0B23EABB34}"/>
              </a:ext>
            </a:extLst>
          </p:cNvPr>
          <p:cNvSpPr/>
          <p:nvPr/>
        </p:nvSpPr>
        <p:spPr>
          <a:xfrm>
            <a:off x="6669522" y="4637693"/>
            <a:ext cx="1641505" cy="380999"/>
          </a:xfrm>
          <a:prstGeom prst="rec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a:t>
            </a:r>
          </a:p>
        </p:txBody>
      </p:sp>
      <p:sp>
        <p:nvSpPr>
          <p:cNvPr id="38" name="Rectangle 37">
            <a:extLst>
              <a:ext uri="{FF2B5EF4-FFF2-40B4-BE49-F238E27FC236}">
                <a16:creationId xmlns:a16="http://schemas.microsoft.com/office/drawing/2014/main" id="{D34D2CC3-2280-4439-BDFD-30B6119D1794}"/>
              </a:ext>
            </a:extLst>
          </p:cNvPr>
          <p:cNvSpPr/>
          <p:nvPr/>
        </p:nvSpPr>
        <p:spPr>
          <a:xfrm>
            <a:off x="8315116" y="4639555"/>
            <a:ext cx="1295399" cy="380997"/>
          </a:xfrm>
          <a:prstGeom prst="rec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rgbClr val="002060"/>
                </a:solidFill>
              </a:rPr>
              <a:t>B</a:t>
            </a:r>
          </a:p>
        </p:txBody>
      </p:sp>
      <p:sp>
        <p:nvSpPr>
          <p:cNvPr id="39" name="Rectangle 38">
            <a:extLst>
              <a:ext uri="{FF2B5EF4-FFF2-40B4-BE49-F238E27FC236}">
                <a16:creationId xmlns:a16="http://schemas.microsoft.com/office/drawing/2014/main" id="{F92FD265-D6CC-4F0A-B90E-9555B99939E9}"/>
              </a:ext>
            </a:extLst>
          </p:cNvPr>
          <p:cNvSpPr/>
          <p:nvPr/>
        </p:nvSpPr>
        <p:spPr>
          <a:xfrm>
            <a:off x="9610515" y="4637695"/>
            <a:ext cx="1295399" cy="380997"/>
          </a:xfrm>
          <a:prstGeom prst="rec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rgbClr val="002060"/>
                </a:solidFill>
              </a:rPr>
              <a:t>B</a:t>
            </a:r>
          </a:p>
        </p:txBody>
      </p:sp>
      <p:sp>
        <p:nvSpPr>
          <p:cNvPr id="40" name="Rectangle 39">
            <a:extLst>
              <a:ext uri="{FF2B5EF4-FFF2-40B4-BE49-F238E27FC236}">
                <a16:creationId xmlns:a16="http://schemas.microsoft.com/office/drawing/2014/main" id="{48483A69-5C4B-469F-B9C1-B186C314C112}"/>
              </a:ext>
            </a:extLst>
          </p:cNvPr>
          <p:cNvSpPr/>
          <p:nvPr/>
        </p:nvSpPr>
        <p:spPr>
          <a:xfrm>
            <a:off x="4384091" y="5917631"/>
            <a:ext cx="1641505" cy="380999"/>
          </a:xfrm>
          <a:prstGeom prst="rec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a:t>
            </a:r>
          </a:p>
        </p:txBody>
      </p:sp>
      <p:sp>
        <p:nvSpPr>
          <p:cNvPr id="41" name="Rectangle 40">
            <a:extLst>
              <a:ext uri="{FF2B5EF4-FFF2-40B4-BE49-F238E27FC236}">
                <a16:creationId xmlns:a16="http://schemas.microsoft.com/office/drawing/2014/main" id="{D930EC9B-0F29-4918-BA6E-D169F369CB7A}"/>
              </a:ext>
            </a:extLst>
          </p:cNvPr>
          <p:cNvSpPr/>
          <p:nvPr/>
        </p:nvSpPr>
        <p:spPr>
          <a:xfrm>
            <a:off x="6029685" y="5919493"/>
            <a:ext cx="1295399" cy="380997"/>
          </a:xfrm>
          <a:prstGeom prst="rec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rgbClr val="002060"/>
                </a:solidFill>
              </a:rPr>
              <a:t>B</a:t>
            </a:r>
          </a:p>
        </p:txBody>
      </p:sp>
      <p:sp>
        <p:nvSpPr>
          <p:cNvPr id="42" name="Rectangle 41">
            <a:extLst>
              <a:ext uri="{FF2B5EF4-FFF2-40B4-BE49-F238E27FC236}">
                <a16:creationId xmlns:a16="http://schemas.microsoft.com/office/drawing/2014/main" id="{776CBC50-3BC1-496C-82CA-4DDE829C7176}"/>
              </a:ext>
            </a:extLst>
          </p:cNvPr>
          <p:cNvSpPr/>
          <p:nvPr/>
        </p:nvSpPr>
        <p:spPr>
          <a:xfrm>
            <a:off x="6669522" y="4637693"/>
            <a:ext cx="1641505" cy="380999"/>
          </a:xfrm>
          <a:prstGeom prst="rec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a:t>
            </a:r>
          </a:p>
        </p:txBody>
      </p:sp>
      <p:sp>
        <p:nvSpPr>
          <p:cNvPr id="43" name="Rectangle 42">
            <a:extLst>
              <a:ext uri="{FF2B5EF4-FFF2-40B4-BE49-F238E27FC236}">
                <a16:creationId xmlns:a16="http://schemas.microsoft.com/office/drawing/2014/main" id="{A4B8B8EF-5831-4239-8376-2D4F9F2CB4B3}"/>
              </a:ext>
            </a:extLst>
          </p:cNvPr>
          <p:cNvSpPr/>
          <p:nvPr/>
        </p:nvSpPr>
        <p:spPr>
          <a:xfrm>
            <a:off x="8315116" y="4641297"/>
            <a:ext cx="1295399" cy="380997"/>
          </a:xfrm>
          <a:prstGeom prst="rec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rgbClr val="002060"/>
                </a:solidFill>
              </a:rPr>
              <a:t>B</a:t>
            </a:r>
          </a:p>
        </p:txBody>
      </p:sp>
      <p:sp>
        <p:nvSpPr>
          <p:cNvPr id="44" name="Rectangle 43">
            <a:extLst>
              <a:ext uri="{FF2B5EF4-FFF2-40B4-BE49-F238E27FC236}">
                <a16:creationId xmlns:a16="http://schemas.microsoft.com/office/drawing/2014/main" id="{BD0C3CFE-552D-455F-B627-6A4C95E27246}"/>
              </a:ext>
            </a:extLst>
          </p:cNvPr>
          <p:cNvSpPr/>
          <p:nvPr/>
        </p:nvSpPr>
        <p:spPr>
          <a:xfrm>
            <a:off x="7325769" y="5919493"/>
            <a:ext cx="771524" cy="380997"/>
          </a:xfrm>
          <a:prstGeom prst="rect">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rgbClr val="002060"/>
                </a:solidFill>
              </a:rPr>
              <a:t>X</a:t>
            </a:r>
          </a:p>
        </p:txBody>
      </p:sp>
      <p:sp>
        <p:nvSpPr>
          <p:cNvPr id="45" name="Rectangle 44">
            <a:extLst>
              <a:ext uri="{FF2B5EF4-FFF2-40B4-BE49-F238E27FC236}">
                <a16:creationId xmlns:a16="http://schemas.microsoft.com/office/drawing/2014/main" id="{7D9EAF58-65D7-467D-96A8-52102914540B}"/>
              </a:ext>
            </a:extLst>
          </p:cNvPr>
          <p:cNvSpPr/>
          <p:nvPr/>
        </p:nvSpPr>
        <p:spPr>
          <a:xfrm>
            <a:off x="8108856" y="5921059"/>
            <a:ext cx="1295399" cy="380997"/>
          </a:xfrm>
          <a:prstGeom prst="rec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rgbClr val="002060"/>
                </a:solidFill>
              </a:rPr>
              <a:t>B</a:t>
            </a:r>
          </a:p>
        </p:txBody>
      </p:sp>
      <p:sp>
        <p:nvSpPr>
          <p:cNvPr id="46" name="Rectangle 45">
            <a:extLst>
              <a:ext uri="{FF2B5EF4-FFF2-40B4-BE49-F238E27FC236}">
                <a16:creationId xmlns:a16="http://schemas.microsoft.com/office/drawing/2014/main" id="{5CE730E6-BC28-422D-A9FF-33A2B79F6737}"/>
              </a:ext>
            </a:extLst>
          </p:cNvPr>
          <p:cNvSpPr/>
          <p:nvPr/>
        </p:nvSpPr>
        <p:spPr>
          <a:xfrm>
            <a:off x="9404940" y="5917632"/>
            <a:ext cx="771524" cy="382860"/>
          </a:xfrm>
          <a:prstGeom prst="rect">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rgbClr val="002060"/>
                </a:solidFill>
              </a:rPr>
              <a:t>X</a:t>
            </a:r>
          </a:p>
        </p:txBody>
      </p:sp>
      <p:sp>
        <p:nvSpPr>
          <p:cNvPr id="47" name="Rectangle 46">
            <a:extLst>
              <a:ext uri="{FF2B5EF4-FFF2-40B4-BE49-F238E27FC236}">
                <a16:creationId xmlns:a16="http://schemas.microsoft.com/office/drawing/2014/main" id="{9AD4DF95-5052-4AC0-8A09-ADAF5E44AEEF}"/>
              </a:ext>
            </a:extLst>
          </p:cNvPr>
          <p:cNvSpPr/>
          <p:nvPr/>
        </p:nvSpPr>
        <p:spPr>
          <a:xfrm>
            <a:off x="10188027" y="5921060"/>
            <a:ext cx="1295399" cy="380997"/>
          </a:xfrm>
          <a:prstGeom prst="rec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rgbClr val="002060"/>
                </a:solidFill>
              </a:rPr>
              <a:t>B</a:t>
            </a:r>
          </a:p>
        </p:txBody>
      </p:sp>
      <p:cxnSp>
        <p:nvCxnSpPr>
          <p:cNvPr id="49" name="Connector: Elbow 48">
            <a:extLst>
              <a:ext uri="{FF2B5EF4-FFF2-40B4-BE49-F238E27FC236}">
                <a16:creationId xmlns:a16="http://schemas.microsoft.com/office/drawing/2014/main" id="{45BAF305-D01C-4EBA-9839-245E28E69634}"/>
              </a:ext>
            </a:extLst>
          </p:cNvPr>
          <p:cNvCxnSpPr>
            <a:cxnSpLocks/>
            <a:stCxn id="39" idx="3"/>
          </p:cNvCxnSpPr>
          <p:nvPr/>
        </p:nvCxnSpPr>
        <p:spPr>
          <a:xfrm flipH="1">
            <a:off x="4130200" y="4828194"/>
            <a:ext cx="6775714" cy="876754"/>
          </a:xfrm>
          <a:prstGeom prst="bentConnector3">
            <a:avLst>
              <a:gd name="adj1" fmla="val -3374"/>
            </a:avLst>
          </a:prstGeom>
        </p:spPr>
        <p:style>
          <a:lnRef idx="1">
            <a:schemeClr val="accent1"/>
          </a:lnRef>
          <a:fillRef idx="0">
            <a:schemeClr val="accent1"/>
          </a:fillRef>
          <a:effectRef idx="0">
            <a:schemeClr val="accent1"/>
          </a:effectRef>
          <a:fontRef idx="minor">
            <a:schemeClr val="tx1"/>
          </a:fontRef>
        </p:style>
      </p:cxnSp>
      <p:cxnSp>
        <p:nvCxnSpPr>
          <p:cNvPr id="51" name="Connector: Elbow 50">
            <a:extLst>
              <a:ext uri="{FF2B5EF4-FFF2-40B4-BE49-F238E27FC236}">
                <a16:creationId xmlns:a16="http://schemas.microsoft.com/office/drawing/2014/main" id="{442342B6-B498-43B1-913F-5150DA5260DE}"/>
              </a:ext>
            </a:extLst>
          </p:cNvPr>
          <p:cNvCxnSpPr>
            <a:stCxn id="40" idx="1"/>
          </p:cNvCxnSpPr>
          <p:nvPr/>
        </p:nvCxnSpPr>
        <p:spPr>
          <a:xfrm rot="10800000">
            <a:off x="4130201" y="5704181"/>
            <a:ext cx="253891" cy="403951"/>
          </a:xfrm>
          <a:prstGeom prst="bentConnector2">
            <a:avLst/>
          </a:prstGeom>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457052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C53264-4BAA-4565-A494-6321EDA063EB}"/>
              </a:ext>
            </a:extLst>
          </p:cNvPr>
          <p:cNvSpPr>
            <a:spLocks noGrp="1"/>
          </p:cNvSpPr>
          <p:nvPr>
            <p:ph type="title"/>
          </p:nvPr>
        </p:nvSpPr>
        <p:spPr>
          <a:xfrm>
            <a:off x="1357146" y="937693"/>
            <a:ext cx="10515599" cy="932688"/>
          </a:xfrm>
        </p:spPr>
        <p:txBody>
          <a:bodyPr vert="horz" lIns="91440" tIns="45720" rIns="91440" bIns="45720" rtlCol="0" anchor="b">
            <a:normAutofit/>
          </a:bodyPr>
          <a:lstStyle/>
          <a:p>
            <a:r>
              <a:rPr lang="en-US" sz="4000" dirty="0"/>
              <a:t> 1            2         3         4          5      6       7        8</a:t>
            </a:r>
            <a:endParaRPr lang="en-US" sz="4000" kern="1200" dirty="0">
              <a:solidFill>
                <a:schemeClr val="tx1"/>
              </a:solidFill>
              <a:latin typeface="+mj-lt"/>
              <a:ea typeface="+mj-ea"/>
              <a:cs typeface="+mj-cs"/>
            </a:endParaRPr>
          </a:p>
        </p:txBody>
      </p:sp>
      <p:graphicFrame>
        <p:nvGraphicFramePr>
          <p:cNvPr id="4" name="Chart 3">
            <a:extLst>
              <a:ext uri="{FF2B5EF4-FFF2-40B4-BE49-F238E27FC236}">
                <a16:creationId xmlns:a16="http://schemas.microsoft.com/office/drawing/2014/main" id="{8865E34B-596C-4FF9-8951-45AEE743D325}"/>
              </a:ext>
            </a:extLst>
          </p:cNvPr>
          <p:cNvGraphicFramePr>
            <a:graphicFrameLocks/>
          </p:cNvGraphicFramePr>
          <p:nvPr>
            <p:extLst>
              <p:ext uri="{D42A27DB-BD31-4B8C-83A1-F6EECF244321}">
                <p14:modId xmlns:p14="http://schemas.microsoft.com/office/powerpoint/2010/main" val="2959767588"/>
              </p:ext>
            </p:extLst>
          </p:nvPr>
        </p:nvGraphicFramePr>
        <p:xfrm>
          <a:off x="720335" y="473652"/>
          <a:ext cx="10515598" cy="311097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a:extLst>
              <a:ext uri="{FF2B5EF4-FFF2-40B4-BE49-F238E27FC236}">
                <a16:creationId xmlns:a16="http://schemas.microsoft.com/office/drawing/2014/main" id="{3A37C677-09AC-4053-A1E1-46C3EE046DA7}"/>
              </a:ext>
            </a:extLst>
          </p:cNvPr>
          <p:cNvGraphicFramePr>
            <a:graphicFrameLocks/>
          </p:cNvGraphicFramePr>
          <p:nvPr>
            <p:extLst>
              <p:ext uri="{D42A27DB-BD31-4B8C-83A1-F6EECF244321}">
                <p14:modId xmlns:p14="http://schemas.microsoft.com/office/powerpoint/2010/main" val="3649646143"/>
              </p:ext>
            </p:extLst>
          </p:nvPr>
        </p:nvGraphicFramePr>
        <p:xfrm>
          <a:off x="1003361" y="3386580"/>
          <a:ext cx="10232572"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6" name="Title 1">
            <a:extLst>
              <a:ext uri="{FF2B5EF4-FFF2-40B4-BE49-F238E27FC236}">
                <a16:creationId xmlns:a16="http://schemas.microsoft.com/office/drawing/2014/main" id="{1B648563-DCD2-4425-B9ED-5D6A15A58B1B}"/>
              </a:ext>
            </a:extLst>
          </p:cNvPr>
          <p:cNvSpPr txBox="1">
            <a:spLocks/>
          </p:cNvSpPr>
          <p:nvPr/>
        </p:nvSpPr>
        <p:spPr>
          <a:xfrm>
            <a:off x="1325617" y="5462540"/>
            <a:ext cx="10515599" cy="932688"/>
          </a:xfrm>
          <a:prstGeom prst="rect">
            <a:avLst/>
          </a:prstGeom>
        </p:spPr>
        <p:txBody>
          <a:bodyPr vert="horz" lIns="91440" tIns="45720" rIns="91440" bIns="45720" rtlCol="0" anchor="b">
            <a:normAutofit fontScale="925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4000" dirty="0"/>
              <a:t> 9  10    11    12  13     14   15 16  1718 19 20 21 22 X</a:t>
            </a:r>
          </a:p>
        </p:txBody>
      </p:sp>
      <p:sp>
        <p:nvSpPr>
          <p:cNvPr id="7" name="Arrow: Up 6">
            <a:extLst>
              <a:ext uri="{FF2B5EF4-FFF2-40B4-BE49-F238E27FC236}">
                <a16:creationId xmlns:a16="http://schemas.microsoft.com/office/drawing/2014/main" id="{6225B4EF-8E5D-469A-AC29-313B1398B9A9}"/>
              </a:ext>
            </a:extLst>
          </p:cNvPr>
          <p:cNvSpPr/>
          <p:nvPr/>
        </p:nvSpPr>
        <p:spPr>
          <a:xfrm>
            <a:off x="3657600" y="5854262"/>
            <a:ext cx="157655" cy="451945"/>
          </a:xfrm>
          <a:prstGeom prst="upArrow">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F2C9D73E-D523-44BA-84F9-BEFE4A985F23}"/>
              </a:ext>
            </a:extLst>
          </p:cNvPr>
          <p:cNvSpPr txBox="1"/>
          <p:nvPr/>
        </p:nvSpPr>
        <p:spPr>
          <a:xfrm>
            <a:off x="409903" y="182461"/>
            <a:ext cx="6096000" cy="369332"/>
          </a:xfrm>
          <a:prstGeom prst="rect">
            <a:avLst/>
          </a:prstGeom>
          <a:noFill/>
        </p:spPr>
        <p:txBody>
          <a:bodyPr wrap="square">
            <a:spAutoFit/>
          </a:bodyPr>
          <a:lstStyle/>
          <a:p>
            <a:r>
              <a:rPr lang="en-US" dirty="0"/>
              <a:t>S3.</a:t>
            </a:r>
          </a:p>
        </p:txBody>
      </p:sp>
    </p:spTree>
    <p:extLst>
      <p:ext uri="{BB962C8B-B14F-4D97-AF65-F5344CB8AC3E}">
        <p14:creationId xmlns:p14="http://schemas.microsoft.com/office/powerpoint/2010/main" val="28304862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937F55-07E9-4EC0-BA3F-654912C39300}"/>
              </a:ext>
            </a:extLst>
          </p:cNvPr>
          <p:cNvSpPr>
            <a:spLocks noGrp="1"/>
          </p:cNvSpPr>
          <p:nvPr>
            <p:ph type="title"/>
          </p:nvPr>
        </p:nvSpPr>
        <p:spPr>
          <a:xfrm>
            <a:off x="575733" y="-467"/>
            <a:ext cx="10515600" cy="1325563"/>
          </a:xfrm>
        </p:spPr>
        <p:txBody>
          <a:bodyPr/>
          <a:lstStyle/>
          <a:p>
            <a:r>
              <a:rPr lang="en-US" dirty="0"/>
              <a:t>S4</a:t>
            </a:r>
          </a:p>
        </p:txBody>
      </p:sp>
      <p:pic>
        <p:nvPicPr>
          <p:cNvPr id="6" name="Content Placeholder 3">
            <a:extLst>
              <a:ext uri="{FF2B5EF4-FFF2-40B4-BE49-F238E27FC236}">
                <a16:creationId xmlns:a16="http://schemas.microsoft.com/office/drawing/2014/main" id="{A134EDA6-975A-43B3-894E-FA36B7BF0C67}"/>
              </a:ext>
            </a:extLst>
          </p:cNvPr>
          <p:cNvPicPr>
            <a:picLocks noChangeAspect="1"/>
          </p:cNvPicPr>
          <p:nvPr/>
        </p:nvPicPr>
        <p:blipFill rotWithShape="1">
          <a:blip r:embed="rId2"/>
          <a:srcRect l="5125" t="13732"/>
          <a:stretch/>
        </p:blipFill>
        <p:spPr>
          <a:xfrm>
            <a:off x="489855" y="5120405"/>
            <a:ext cx="9976691" cy="1364694"/>
          </a:xfrm>
          <a:prstGeom prst="rect">
            <a:avLst/>
          </a:prstGeom>
        </p:spPr>
      </p:pic>
      <p:pic>
        <p:nvPicPr>
          <p:cNvPr id="7" name="Picture 6">
            <a:extLst>
              <a:ext uri="{FF2B5EF4-FFF2-40B4-BE49-F238E27FC236}">
                <a16:creationId xmlns:a16="http://schemas.microsoft.com/office/drawing/2014/main" id="{A79F3DFA-1A99-4C34-9BE5-8E652B0678FF}"/>
              </a:ext>
            </a:extLst>
          </p:cNvPr>
          <p:cNvPicPr>
            <a:picLocks noChangeAspect="1"/>
          </p:cNvPicPr>
          <p:nvPr/>
        </p:nvPicPr>
        <p:blipFill rotWithShape="1">
          <a:blip r:embed="rId3"/>
          <a:srcRect l="1774" t="19058"/>
          <a:stretch/>
        </p:blipFill>
        <p:spPr>
          <a:xfrm>
            <a:off x="1653419" y="1289112"/>
            <a:ext cx="8369484" cy="3747125"/>
          </a:xfrm>
          <a:prstGeom prst="rect">
            <a:avLst/>
          </a:prstGeom>
        </p:spPr>
      </p:pic>
      <p:sp>
        <p:nvSpPr>
          <p:cNvPr id="8" name="Title 1">
            <a:extLst>
              <a:ext uri="{FF2B5EF4-FFF2-40B4-BE49-F238E27FC236}">
                <a16:creationId xmlns:a16="http://schemas.microsoft.com/office/drawing/2014/main" id="{0E6FFD0A-2305-490C-8F5E-F19168502077}"/>
              </a:ext>
            </a:extLst>
          </p:cNvPr>
          <p:cNvSpPr txBox="1">
            <a:spLocks/>
          </p:cNvSpPr>
          <p:nvPr/>
        </p:nvSpPr>
        <p:spPr>
          <a:xfrm>
            <a:off x="9121140" y="3108960"/>
            <a:ext cx="3070860" cy="1146293"/>
          </a:xfrm>
          <a:prstGeom prst="rect">
            <a:avLst/>
          </a:prstGeom>
          <a:solidFill>
            <a:schemeClr val="bg1"/>
          </a:solidFill>
        </p:spPr>
        <p:txBody>
          <a:bodyPr vert="horz" lIns="91440" tIns="45720" rIns="91440" bIns="45720" rtlCol="0" anchor="ctr">
            <a:normAutofit fontScale="92500" lnSpcReduction="20000"/>
          </a:bodyPr>
          <a:lstStyle>
            <a:lvl1pPr algn="l" defTabSz="914400" rtl="0" eaLnBrk="1" latinLnBrk="0" hangingPunct="1">
              <a:lnSpc>
                <a:spcPct val="90000"/>
              </a:lnSpc>
              <a:spcBef>
                <a:spcPct val="0"/>
              </a:spcBef>
              <a:buNone/>
              <a:defRPr sz="4400" kern="1200" cap="none">
                <a:solidFill>
                  <a:schemeClr val="tx1"/>
                </a:solidFill>
                <a:latin typeface="+mj-lt"/>
                <a:ea typeface="+mj-ea"/>
                <a:cs typeface="+mj-cs"/>
              </a:defRPr>
            </a:lvl1pPr>
          </a:lstStyle>
          <a:p>
            <a:r>
              <a:rPr lang="en-US" sz="3200" dirty="0"/>
              <a:t>Rearrangement 7635-1266 bp</a:t>
            </a:r>
          </a:p>
          <a:p>
            <a:r>
              <a:rPr lang="en-US" sz="3200" dirty="0"/>
              <a:t>T014</a:t>
            </a:r>
          </a:p>
        </p:txBody>
      </p:sp>
    </p:spTree>
    <p:extLst>
      <p:ext uri="{BB962C8B-B14F-4D97-AF65-F5344CB8AC3E}">
        <p14:creationId xmlns:p14="http://schemas.microsoft.com/office/powerpoint/2010/main" val="27367881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7B0958-445B-48F3-B2DF-861A920EB9CC}"/>
              </a:ext>
            </a:extLst>
          </p:cNvPr>
          <p:cNvSpPr>
            <a:spLocks noGrp="1"/>
          </p:cNvSpPr>
          <p:nvPr>
            <p:ph type="title"/>
          </p:nvPr>
        </p:nvSpPr>
        <p:spPr>
          <a:xfrm>
            <a:off x="329568" y="318499"/>
            <a:ext cx="10515600" cy="674403"/>
          </a:xfrm>
        </p:spPr>
        <p:txBody>
          <a:bodyPr>
            <a:normAutofit fontScale="90000"/>
          </a:bodyPr>
          <a:lstStyle/>
          <a:p>
            <a:r>
              <a:rPr lang="en-US" dirty="0"/>
              <a:t>S5. </a:t>
            </a:r>
          </a:p>
        </p:txBody>
      </p:sp>
      <p:sp>
        <p:nvSpPr>
          <p:cNvPr id="3" name="TextBox 2">
            <a:extLst>
              <a:ext uri="{FF2B5EF4-FFF2-40B4-BE49-F238E27FC236}">
                <a16:creationId xmlns:a16="http://schemas.microsoft.com/office/drawing/2014/main" id="{955ED027-A9EC-4599-B78D-EE12845E8720}"/>
              </a:ext>
            </a:extLst>
          </p:cNvPr>
          <p:cNvSpPr txBox="1"/>
          <p:nvPr/>
        </p:nvSpPr>
        <p:spPr>
          <a:xfrm>
            <a:off x="596561" y="5495766"/>
            <a:ext cx="3389518" cy="369332"/>
          </a:xfrm>
          <a:prstGeom prst="rect">
            <a:avLst/>
          </a:prstGeom>
          <a:solidFill>
            <a:schemeClr val="bg1"/>
          </a:solidFill>
        </p:spPr>
        <p:txBody>
          <a:bodyPr wrap="none" rtlCol="0">
            <a:spAutoFit/>
          </a:bodyPr>
          <a:lstStyle/>
          <a:p>
            <a:r>
              <a:rPr lang="en-US" b="1" dirty="0"/>
              <a:t>T550   EP-only, Multimer </a:t>
            </a:r>
            <a:r>
              <a:rPr lang="en-US" b="1" dirty="0" err="1"/>
              <a:t>Episome</a:t>
            </a:r>
            <a:endParaRPr lang="en-US" b="1" dirty="0"/>
          </a:p>
        </p:txBody>
      </p:sp>
      <p:sp>
        <p:nvSpPr>
          <p:cNvPr id="8" name="TextBox 7">
            <a:extLst>
              <a:ext uri="{FF2B5EF4-FFF2-40B4-BE49-F238E27FC236}">
                <a16:creationId xmlns:a16="http://schemas.microsoft.com/office/drawing/2014/main" id="{BB90D79E-88C1-4677-8FF8-487D1C27B6FD}"/>
              </a:ext>
            </a:extLst>
          </p:cNvPr>
          <p:cNvSpPr txBox="1"/>
          <p:nvPr/>
        </p:nvSpPr>
        <p:spPr>
          <a:xfrm>
            <a:off x="534300" y="3679573"/>
            <a:ext cx="3534044" cy="369332"/>
          </a:xfrm>
          <a:prstGeom prst="rect">
            <a:avLst/>
          </a:prstGeom>
          <a:solidFill>
            <a:schemeClr val="bg1"/>
          </a:solidFill>
        </p:spPr>
        <p:txBody>
          <a:bodyPr wrap="none" rtlCol="0">
            <a:spAutoFit/>
          </a:bodyPr>
          <a:lstStyle/>
          <a:p>
            <a:r>
              <a:rPr lang="en-US" b="1" dirty="0"/>
              <a:t>T014  EP-only, Rearranged </a:t>
            </a:r>
            <a:r>
              <a:rPr lang="en-US" b="1" dirty="0" err="1"/>
              <a:t>episome</a:t>
            </a:r>
            <a:endParaRPr lang="en-US" b="1" dirty="0"/>
          </a:p>
        </p:txBody>
      </p:sp>
      <p:sp>
        <p:nvSpPr>
          <p:cNvPr id="9" name="TextBox 8">
            <a:extLst>
              <a:ext uri="{FF2B5EF4-FFF2-40B4-BE49-F238E27FC236}">
                <a16:creationId xmlns:a16="http://schemas.microsoft.com/office/drawing/2014/main" id="{66A39529-83A0-4D9B-A6D6-8B247BA16DF2}"/>
              </a:ext>
            </a:extLst>
          </p:cNvPr>
          <p:cNvSpPr txBox="1"/>
          <p:nvPr/>
        </p:nvSpPr>
        <p:spPr>
          <a:xfrm>
            <a:off x="534300" y="1678714"/>
            <a:ext cx="2528706" cy="369332"/>
          </a:xfrm>
          <a:prstGeom prst="rect">
            <a:avLst/>
          </a:prstGeom>
          <a:solidFill>
            <a:schemeClr val="bg1"/>
          </a:solidFill>
        </p:spPr>
        <p:txBody>
          <a:bodyPr wrap="none" rtlCol="0">
            <a:spAutoFit/>
          </a:bodyPr>
          <a:lstStyle/>
          <a:p>
            <a:r>
              <a:rPr lang="en-US" b="1" dirty="0"/>
              <a:t>T368  EP-only, Monomer</a:t>
            </a:r>
          </a:p>
        </p:txBody>
      </p:sp>
      <p:pic>
        <p:nvPicPr>
          <p:cNvPr id="11" name="Content Placeholder 4">
            <a:extLst>
              <a:ext uri="{FF2B5EF4-FFF2-40B4-BE49-F238E27FC236}">
                <a16:creationId xmlns:a16="http://schemas.microsoft.com/office/drawing/2014/main" id="{C5D2D85F-6DA3-4353-964B-3E9610E4E614}"/>
              </a:ext>
            </a:extLst>
          </p:cNvPr>
          <p:cNvPicPr>
            <a:picLocks noChangeAspect="1"/>
          </p:cNvPicPr>
          <p:nvPr/>
        </p:nvPicPr>
        <p:blipFill>
          <a:blip r:embed="rId3"/>
          <a:stretch>
            <a:fillRect/>
          </a:stretch>
        </p:blipFill>
        <p:spPr>
          <a:xfrm>
            <a:off x="5532167" y="2814243"/>
            <a:ext cx="6291569" cy="2014746"/>
          </a:xfrm>
          <a:prstGeom prst="rect">
            <a:avLst/>
          </a:prstGeom>
        </p:spPr>
      </p:pic>
      <p:pic>
        <p:nvPicPr>
          <p:cNvPr id="12" name="Content Placeholder 4">
            <a:extLst>
              <a:ext uri="{FF2B5EF4-FFF2-40B4-BE49-F238E27FC236}">
                <a16:creationId xmlns:a16="http://schemas.microsoft.com/office/drawing/2014/main" id="{CB8FBAC9-C1EC-4E81-9A5B-5F72AF3CBC17}"/>
              </a:ext>
            </a:extLst>
          </p:cNvPr>
          <p:cNvPicPr>
            <a:picLocks noGrp="1" noChangeAspect="1"/>
          </p:cNvPicPr>
          <p:nvPr>
            <p:ph idx="1"/>
          </p:nvPr>
        </p:nvPicPr>
        <p:blipFill>
          <a:blip r:embed="rId4"/>
          <a:stretch>
            <a:fillRect/>
          </a:stretch>
        </p:blipFill>
        <p:spPr>
          <a:xfrm>
            <a:off x="5587368" y="836115"/>
            <a:ext cx="6236368" cy="2087358"/>
          </a:xfrm>
        </p:spPr>
      </p:pic>
      <p:pic>
        <p:nvPicPr>
          <p:cNvPr id="13" name="Content Placeholder 4">
            <a:extLst>
              <a:ext uri="{FF2B5EF4-FFF2-40B4-BE49-F238E27FC236}">
                <a16:creationId xmlns:a16="http://schemas.microsoft.com/office/drawing/2014/main" id="{C5FF8B6E-EC05-40CC-A94C-CA2B2422E589}"/>
              </a:ext>
            </a:extLst>
          </p:cNvPr>
          <p:cNvPicPr>
            <a:picLocks noChangeAspect="1"/>
          </p:cNvPicPr>
          <p:nvPr/>
        </p:nvPicPr>
        <p:blipFill>
          <a:blip r:embed="rId5"/>
          <a:stretch>
            <a:fillRect/>
          </a:stretch>
        </p:blipFill>
        <p:spPr>
          <a:xfrm>
            <a:off x="5516104" y="4709820"/>
            <a:ext cx="6236368" cy="1876342"/>
          </a:xfrm>
          <a:prstGeom prst="rect">
            <a:avLst/>
          </a:prstGeom>
        </p:spPr>
      </p:pic>
    </p:spTree>
    <p:extLst>
      <p:ext uri="{BB962C8B-B14F-4D97-AF65-F5344CB8AC3E}">
        <p14:creationId xmlns:p14="http://schemas.microsoft.com/office/powerpoint/2010/main" val="6461890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372</TotalTime>
  <Words>477</Words>
  <Application>Microsoft Office PowerPoint</Application>
  <PresentationFormat>Widescreen</PresentationFormat>
  <Paragraphs>55</Paragraphs>
  <Slides>6</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Rossi et al. Supplemental figures</vt:lpstr>
      <vt:lpstr>PowerPoint Presentation</vt:lpstr>
      <vt:lpstr>S2 </vt:lpstr>
      <vt:lpstr> 1            2         3         4          5      6       7        8</vt:lpstr>
      <vt:lpstr>S4</vt:lpstr>
      <vt:lpstr>S5.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an, Michael (NIH/NCI) [E]</dc:creator>
  <cp:lastModifiedBy>Dean, Michael (NIH/NCI) [E]</cp:lastModifiedBy>
  <cp:revision>20</cp:revision>
  <dcterms:created xsi:type="dcterms:W3CDTF">2021-08-14T18:38:56Z</dcterms:created>
  <dcterms:modified xsi:type="dcterms:W3CDTF">2021-10-17T23:40:56Z</dcterms:modified>
</cp:coreProperties>
</file>